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2FC2030-53C9-DA4C-90B7-101DEDB891D0}" v="61" dt="2023-09-28T12:01:01.249"/>
    <p1510:client id="{9A25FDF3-48D6-B8AD-6E63-84E9F4CB4DFE}" v="4" dt="2023-09-28T11:59:48.409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slideViewPr>
    <p:cSldViewPr snapToGrid="0">
      <p:cViewPr>
        <p:scale>
          <a:sx n="1" d="2"/>
          <a:sy n="1" d="2"/>
        </p:scale>
        <p:origin x="0" y="0"/>
      </p:cViewPr>
      <p:guideLst/>
    </p:cSldViewPr>
  </p:slide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ake Kendrick" userId="S::21308325@student.uwa.edu.au::ab142299-a4dd-4def-8b03-8ee3e1d9a7dd" providerId="AD" clId="Web-{6EB5C446-C2D2-4F79-881F-212B0D1CE35F}"/>
    <pc:docChg chg="modSld">
      <pc:chgData name="Jake Kendrick" userId="S::21308325@student.uwa.edu.au::ab142299-a4dd-4def-8b03-8ee3e1d9a7dd" providerId="AD" clId="Web-{6EB5C446-C2D2-4F79-881F-212B0D1CE35F}" dt="2022-07-04T08:41:55.910" v="7" actId="20577"/>
      <pc:docMkLst>
        <pc:docMk/>
      </pc:docMkLst>
      <pc:sldChg chg="modSp">
        <pc:chgData name="Jake Kendrick" userId="S::21308325@student.uwa.edu.au::ab142299-a4dd-4def-8b03-8ee3e1d9a7dd" providerId="AD" clId="Web-{6EB5C446-C2D2-4F79-881F-212B0D1CE35F}" dt="2022-07-04T08:41:55.910" v="7" actId="20577"/>
        <pc:sldMkLst>
          <pc:docMk/>
          <pc:sldMk cId="109857222" sldId="256"/>
        </pc:sldMkLst>
        <pc:spChg chg="mod">
          <ac:chgData name="Jake Kendrick" userId="S::21308325@student.uwa.edu.au::ab142299-a4dd-4def-8b03-8ee3e1d9a7dd" providerId="AD" clId="Web-{6EB5C446-C2D2-4F79-881F-212B0D1CE35F}" dt="2022-07-04T08:41:55.910" v="7" actId="20577"/>
          <ac:spMkLst>
            <pc:docMk/>
            <pc:sldMk cId="109857222" sldId="256"/>
            <ac:spMk id="13" creationId="{A9A32FB2-2064-654E-9855-BDC1D5C342CA}"/>
          </ac:spMkLst>
        </pc:spChg>
      </pc:sldChg>
    </pc:docChg>
  </pc:docChgLst>
  <pc:docChgLst>
    <pc:chgData name="Jake Kendrick" userId="S::21308325@student.uwa.edu.au::ab142299-a4dd-4def-8b03-8ee3e1d9a7dd" providerId="AD" clId="Web-{78C78655-E099-370A-12ED-AEFDE86367F6}"/>
    <pc:docChg chg="modSld">
      <pc:chgData name="Jake Kendrick" userId="S::21308325@student.uwa.edu.au::ab142299-a4dd-4def-8b03-8ee3e1d9a7dd" providerId="AD" clId="Web-{78C78655-E099-370A-12ED-AEFDE86367F6}" dt="2023-04-18T00:08:01.337" v="38" actId="1076"/>
      <pc:docMkLst>
        <pc:docMk/>
      </pc:docMkLst>
      <pc:sldChg chg="addSp delSp modSp">
        <pc:chgData name="Jake Kendrick" userId="S::21308325@student.uwa.edu.au::ab142299-a4dd-4def-8b03-8ee3e1d9a7dd" providerId="AD" clId="Web-{78C78655-E099-370A-12ED-AEFDE86367F6}" dt="2023-04-18T00:08:01.337" v="38" actId="1076"/>
        <pc:sldMkLst>
          <pc:docMk/>
          <pc:sldMk cId="109857222" sldId="256"/>
        </pc:sldMkLst>
        <pc:spChg chg="del">
          <ac:chgData name="Jake Kendrick" userId="S::21308325@student.uwa.edu.au::ab142299-a4dd-4def-8b03-8ee3e1d9a7dd" providerId="AD" clId="Web-{78C78655-E099-370A-12ED-AEFDE86367F6}" dt="2023-04-17T06:14:07.248" v="3"/>
          <ac:spMkLst>
            <pc:docMk/>
            <pc:sldMk cId="109857222" sldId="256"/>
            <ac:spMk id="6" creationId="{23160FD5-8722-3429-CB9A-189EF509C80F}"/>
          </ac:spMkLst>
        </pc:spChg>
        <pc:spChg chg="del">
          <ac:chgData name="Jake Kendrick" userId="S::21308325@student.uwa.edu.au::ab142299-a4dd-4def-8b03-8ee3e1d9a7dd" providerId="AD" clId="Web-{78C78655-E099-370A-12ED-AEFDE86367F6}" dt="2023-04-17T06:14:07.248" v="2"/>
          <ac:spMkLst>
            <pc:docMk/>
            <pc:sldMk cId="109857222" sldId="256"/>
            <ac:spMk id="7" creationId="{43B4FB55-2C13-F8CC-3E5F-F9B56E8E5139}"/>
          </ac:spMkLst>
        </pc:spChg>
        <pc:spChg chg="del">
          <ac:chgData name="Jake Kendrick" userId="S::21308325@student.uwa.edu.au::ab142299-a4dd-4def-8b03-8ee3e1d9a7dd" providerId="AD" clId="Web-{78C78655-E099-370A-12ED-AEFDE86367F6}" dt="2023-04-17T06:14:07.248" v="1"/>
          <ac:spMkLst>
            <pc:docMk/>
            <pc:sldMk cId="109857222" sldId="256"/>
            <ac:spMk id="8" creationId="{9CF02C2F-EEE6-2390-57E4-77D6A739D78E}"/>
          </ac:spMkLst>
        </pc:spChg>
        <pc:spChg chg="del">
          <ac:chgData name="Jake Kendrick" userId="S::21308325@student.uwa.edu.au::ab142299-a4dd-4def-8b03-8ee3e1d9a7dd" providerId="AD" clId="Web-{78C78655-E099-370A-12ED-AEFDE86367F6}" dt="2023-04-17T06:14:07.233" v="0"/>
          <ac:spMkLst>
            <pc:docMk/>
            <pc:sldMk cId="109857222" sldId="256"/>
            <ac:spMk id="9" creationId="{B9E6849A-2317-E80F-4C77-DEA66A8FCE49}"/>
          </ac:spMkLst>
        </pc:spChg>
        <pc:picChg chg="add del mod">
          <ac:chgData name="Jake Kendrick" userId="S::21308325@student.uwa.edu.au::ab142299-a4dd-4def-8b03-8ee3e1d9a7dd" providerId="AD" clId="Web-{78C78655-E099-370A-12ED-AEFDE86367F6}" dt="2023-04-18T00:07:45.150" v="36"/>
          <ac:picMkLst>
            <pc:docMk/>
            <pc:sldMk cId="109857222" sldId="256"/>
            <ac:picMk id="3" creationId="{673069EA-BD06-036F-7FEC-B7124B15F515}"/>
          </ac:picMkLst>
        </pc:picChg>
        <pc:picChg chg="del">
          <ac:chgData name="Jake Kendrick" userId="S::21308325@student.uwa.edu.au::ab142299-a4dd-4def-8b03-8ee3e1d9a7dd" providerId="AD" clId="Web-{78C78655-E099-370A-12ED-AEFDE86367F6}" dt="2023-04-17T06:14:07.248" v="6"/>
          <ac:picMkLst>
            <pc:docMk/>
            <pc:sldMk cId="109857222" sldId="256"/>
            <ac:picMk id="3" creationId="{D4FCBEE6-8C41-CF50-C664-5CE7048A8A46}"/>
          </ac:picMkLst>
        </pc:picChg>
        <pc:picChg chg="del">
          <ac:chgData name="Jake Kendrick" userId="S::21308325@student.uwa.edu.au::ab142299-a4dd-4def-8b03-8ee3e1d9a7dd" providerId="AD" clId="Web-{78C78655-E099-370A-12ED-AEFDE86367F6}" dt="2023-04-17T06:14:07.248" v="5"/>
          <ac:picMkLst>
            <pc:docMk/>
            <pc:sldMk cId="109857222" sldId="256"/>
            <ac:picMk id="4" creationId="{3778CDEF-44B7-F2C1-0189-6FCA3A94E4CF}"/>
          </ac:picMkLst>
        </pc:picChg>
        <pc:picChg chg="add mod">
          <ac:chgData name="Jake Kendrick" userId="S::21308325@student.uwa.edu.au::ab142299-a4dd-4def-8b03-8ee3e1d9a7dd" providerId="AD" clId="Web-{78C78655-E099-370A-12ED-AEFDE86367F6}" dt="2023-04-17T06:59:15.218" v="33" actId="1076"/>
          <ac:picMkLst>
            <pc:docMk/>
            <pc:sldMk cId="109857222" sldId="256"/>
            <ac:picMk id="4" creationId="{42A5408E-8D63-B43B-E4A4-8E3F4E4FB538}"/>
          </ac:picMkLst>
        </pc:picChg>
        <pc:picChg chg="add mod">
          <ac:chgData name="Jake Kendrick" userId="S::21308325@student.uwa.edu.au::ab142299-a4dd-4def-8b03-8ee3e1d9a7dd" providerId="AD" clId="Web-{78C78655-E099-370A-12ED-AEFDE86367F6}" dt="2023-04-18T00:07:42.743" v="35" actId="1076"/>
          <ac:picMkLst>
            <pc:docMk/>
            <pc:sldMk cId="109857222" sldId="256"/>
            <ac:picMk id="5" creationId="{13FEBA5D-98B5-BD5E-A1E3-17D7DBF59A5C}"/>
          </ac:picMkLst>
        </pc:picChg>
        <pc:picChg chg="del">
          <ac:chgData name="Jake Kendrick" userId="S::21308325@student.uwa.edu.au::ab142299-a4dd-4def-8b03-8ee3e1d9a7dd" providerId="AD" clId="Web-{78C78655-E099-370A-12ED-AEFDE86367F6}" dt="2023-04-17T06:14:07.248" v="4"/>
          <ac:picMkLst>
            <pc:docMk/>
            <pc:sldMk cId="109857222" sldId="256"/>
            <ac:picMk id="5" creationId="{BBED81FA-1167-3EB8-F332-059E25B64E73}"/>
          </ac:picMkLst>
        </pc:picChg>
        <pc:picChg chg="add mod">
          <ac:chgData name="Jake Kendrick" userId="S::21308325@student.uwa.edu.au::ab142299-a4dd-4def-8b03-8ee3e1d9a7dd" providerId="AD" clId="Web-{78C78655-E099-370A-12ED-AEFDE86367F6}" dt="2023-04-18T00:08:01.337" v="38" actId="1076"/>
          <ac:picMkLst>
            <pc:docMk/>
            <pc:sldMk cId="109857222" sldId="256"/>
            <ac:picMk id="6" creationId="{B919A257-4724-3984-FC02-16DECF9DA3E1}"/>
          </ac:picMkLst>
        </pc:picChg>
        <pc:picChg chg="add del mod">
          <ac:chgData name="Jake Kendrick" userId="S::21308325@student.uwa.edu.au::ab142299-a4dd-4def-8b03-8ee3e1d9a7dd" providerId="AD" clId="Web-{78C78655-E099-370A-12ED-AEFDE86367F6}" dt="2023-04-17T06:14:42.499" v="9"/>
          <ac:picMkLst>
            <pc:docMk/>
            <pc:sldMk cId="109857222" sldId="256"/>
            <ac:picMk id="10" creationId="{5A0F98C8-90D3-E7E0-14D7-E9BD73C863D4}"/>
          </ac:picMkLst>
        </pc:picChg>
        <pc:picChg chg="add del mod">
          <ac:chgData name="Jake Kendrick" userId="S::21308325@student.uwa.edu.au::ab142299-a4dd-4def-8b03-8ee3e1d9a7dd" providerId="AD" clId="Web-{78C78655-E099-370A-12ED-AEFDE86367F6}" dt="2023-04-17T06:21:04.428" v="13"/>
          <ac:picMkLst>
            <pc:docMk/>
            <pc:sldMk cId="109857222" sldId="256"/>
            <ac:picMk id="11" creationId="{7BDAB1AE-6F0E-3476-0305-CE7F8997DD7F}"/>
          </ac:picMkLst>
        </pc:picChg>
        <pc:picChg chg="add del mod">
          <ac:chgData name="Jake Kendrick" userId="S::21308325@student.uwa.edu.au::ab142299-a4dd-4def-8b03-8ee3e1d9a7dd" providerId="AD" clId="Web-{78C78655-E099-370A-12ED-AEFDE86367F6}" dt="2023-04-17T06:21:35.460" v="16"/>
          <ac:picMkLst>
            <pc:docMk/>
            <pc:sldMk cId="109857222" sldId="256"/>
            <ac:picMk id="13" creationId="{9604EF52-34D3-0736-AD86-9BDA6396E115}"/>
          </ac:picMkLst>
        </pc:picChg>
        <pc:picChg chg="add del mod">
          <ac:chgData name="Jake Kendrick" userId="S::21308325@student.uwa.edu.au::ab142299-a4dd-4def-8b03-8ee3e1d9a7dd" providerId="AD" clId="Web-{78C78655-E099-370A-12ED-AEFDE86367F6}" dt="2023-04-17T06:55:50.900" v="25"/>
          <ac:picMkLst>
            <pc:docMk/>
            <pc:sldMk cId="109857222" sldId="256"/>
            <ac:picMk id="14" creationId="{1ABC57BB-7811-14DC-67C6-0012269BFF74}"/>
          </ac:picMkLst>
        </pc:picChg>
        <pc:picChg chg="add del mod">
          <ac:chgData name="Jake Kendrick" userId="S::21308325@student.uwa.edu.au::ab142299-a4dd-4def-8b03-8ee3e1d9a7dd" providerId="AD" clId="Web-{78C78655-E099-370A-12ED-AEFDE86367F6}" dt="2023-04-17T06:28:05.437" v="22"/>
          <ac:picMkLst>
            <pc:docMk/>
            <pc:sldMk cId="109857222" sldId="256"/>
            <ac:picMk id="16" creationId="{E2189F4C-E2DE-004C-01FA-63098653B0AF}"/>
          </ac:picMkLst>
        </pc:picChg>
        <pc:picChg chg="add mod">
          <ac:chgData name="Jake Kendrick" userId="S::21308325@student.uwa.edu.au::ab142299-a4dd-4def-8b03-8ee3e1d9a7dd" providerId="AD" clId="Web-{78C78655-E099-370A-12ED-AEFDE86367F6}" dt="2023-04-17T06:56:14.275" v="31" actId="1076"/>
          <ac:picMkLst>
            <pc:docMk/>
            <pc:sldMk cId="109857222" sldId="256"/>
            <ac:picMk id="17" creationId="{48672E4C-F164-1CC7-B618-3D75C583825D}"/>
          </ac:picMkLst>
        </pc:picChg>
      </pc:sldChg>
    </pc:docChg>
  </pc:docChgLst>
  <pc:docChgLst>
    <pc:chgData name="Jake Kendrick" userId="S::21308325@student.uwa.edu.au::ab142299-a4dd-4def-8b03-8ee3e1d9a7dd" providerId="AD" clId="Web-{943EFF99-AE15-4774-B59F-CE02862FF064}"/>
    <pc:docChg chg="modSld">
      <pc:chgData name="Jake Kendrick" userId="S::21308325@student.uwa.edu.au::ab142299-a4dd-4def-8b03-8ee3e1d9a7dd" providerId="AD" clId="Web-{943EFF99-AE15-4774-B59F-CE02862FF064}" dt="2023-03-26T23:50:44.641" v="1" actId="1076"/>
      <pc:docMkLst>
        <pc:docMk/>
      </pc:docMkLst>
      <pc:sldChg chg="modSp">
        <pc:chgData name="Jake Kendrick" userId="S::21308325@student.uwa.edu.au::ab142299-a4dd-4def-8b03-8ee3e1d9a7dd" providerId="AD" clId="Web-{943EFF99-AE15-4774-B59F-CE02862FF064}" dt="2023-03-26T23:50:44.641" v="1" actId="1076"/>
        <pc:sldMkLst>
          <pc:docMk/>
          <pc:sldMk cId="109857222" sldId="256"/>
        </pc:sldMkLst>
        <pc:picChg chg="mod">
          <ac:chgData name="Jake Kendrick" userId="S::21308325@student.uwa.edu.au::ab142299-a4dd-4def-8b03-8ee3e1d9a7dd" providerId="AD" clId="Web-{943EFF99-AE15-4774-B59F-CE02862FF064}" dt="2023-03-26T23:50:44.641" v="1" actId="1076"/>
          <ac:picMkLst>
            <pc:docMk/>
            <pc:sldMk cId="109857222" sldId="256"/>
            <ac:picMk id="4" creationId="{C019A8C6-A179-6266-AC40-CF809E053682}"/>
          </ac:picMkLst>
        </pc:picChg>
      </pc:sldChg>
    </pc:docChg>
  </pc:docChgLst>
  <pc:docChgLst>
    <pc:chgData name="Jake Kendrick" userId="S::21308325@student.uwa.edu.au::ab142299-a4dd-4def-8b03-8ee3e1d9a7dd" providerId="AD" clId="Web-{2C709363-D186-02F0-4E66-C5887FC046D8}"/>
    <pc:docChg chg="modSld">
      <pc:chgData name="Jake Kendrick" userId="S::21308325@student.uwa.edu.au::ab142299-a4dd-4def-8b03-8ee3e1d9a7dd" providerId="AD" clId="Web-{2C709363-D186-02F0-4E66-C5887FC046D8}" dt="2023-05-02T02:06:34.638" v="197"/>
      <pc:docMkLst>
        <pc:docMk/>
      </pc:docMkLst>
      <pc:sldChg chg="addSp modSp">
        <pc:chgData name="Jake Kendrick" userId="S::21308325@student.uwa.edu.au::ab142299-a4dd-4def-8b03-8ee3e1d9a7dd" providerId="AD" clId="Web-{2C709363-D186-02F0-4E66-C5887FC046D8}" dt="2023-05-02T02:06:34.638" v="197"/>
        <pc:sldMkLst>
          <pc:docMk/>
          <pc:sldMk cId="109857222" sldId="256"/>
        </pc:sldMkLst>
        <pc:graphicFrameChg chg="add mod modGraphic">
          <ac:chgData name="Jake Kendrick" userId="S::21308325@student.uwa.edu.au::ab142299-a4dd-4def-8b03-8ee3e1d9a7dd" providerId="AD" clId="Web-{2C709363-D186-02F0-4E66-C5887FC046D8}" dt="2023-05-02T02:06:34.638" v="197"/>
          <ac:graphicFrameMkLst>
            <pc:docMk/>
            <pc:sldMk cId="109857222" sldId="256"/>
            <ac:graphicFrameMk id="7" creationId="{277382E6-C6E4-6D8E-B6CB-723A91E54FAC}"/>
          </ac:graphicFrameMkLst>
        </pc:graphicFrameChg>
        <pc:picChg chg="mod">
          <ac:chgData name="Jake Kendrick" userId="S::21308325@student.uwa.edu.au::ab142299-a4dd-4def-8b03-8ee3e1d9a7dd" providerId="AD" clId="Web-{2C709363-D186-02F0-4E66-C5887FC046D8}" dt="2023-05-02T00:11:23.997" v="2" actId="1076"/>
          <ac:picMkLst>
            <pc:docMk/>
            <pc:sldMk cId="109857222" sldId="256"/>
            <ac:picMk id="3" creationId="{E8F764C4-D6FF-C1CE-BFD9-596111DAFC0C}"/>
          </ac:picMkLst>
        </pc:picChg>
        <pc:picChg chg="mod">
          <ac:chgData name="Jake Kendrick" userId="S::21308325@student.uwa.edu.au::ab142299-a4dd-4def-8b03-8ee3e1d9a7dd" providerId="AD" clId="Web-{2C709363-D186-02F0-4E66-C5887FC046D8}" dt="2023-05-02T00:11:23.919" v="0" actId="1076"/>
          <ac:picMkLst>
            <pc:docMk/>
            <pc:sldMk cId="109857222" sldId="256"/>
            <ac:picMk id="4" creationId="{42A5408E-8D63-B43B-E4A4-8E3F4E4FB538}"/>
          </ac:picMkLst>
        </pc:picChg>
        <pc:picChg chg="mod">
          <ac:chgData name="Jake Kendrick" userId="S::21308325@student.uwa.edu.au::ab142299-a4dd-4def-8b03-8ee3e1d9a7dd" providerId="AD" clId="Web-{2C709363-D186-02F0-4E66-C5887FC046D8}" dt="2023-05-02T00:11:23.950" v="1" actId="1076"/>
          <ac:picMkLst>
            <pc:docMk/>
            <pc:sldMk cId="109857222" sldId="256"/>
            <ac:picMk id="5" creationId="{13FEBA5D-98B5-BD5E-A1E3-17D7DBF59A5C}"/>
          </ac:picMkLst>
        </pc:picChg>
      </pc:sldChg>
    </pc:docChg>
  </pc:docChgLst>
  <pc:docChgLst>
    <pc:chgData name="Jake Kendrick" userId="S::21308325@student.uwa.edu.au::ab142299-a4dd-4def-8b03-8ee3e1d9a7dd" providerId="AD" clId="Web-{4F710391-FD24-B9C4-7744-BF5434DF269E}"/>
    <pc:docChg chg="modSld">
      <pc:chgData name="Jake Kendrick" userId="S::21308325@student.uwa.edu.au::ab142299-a4dd-4def-8b03-8ee3e1d9a7dd" providerId="AD" clId="Web-{4F710391-FD24-B9C4-7744-BF5434DF269E}" dt="2023-05-31T05:10:25.071" v="144" actId="20577"/>
      <pc:docMkLst>
        <pc:docMk/>
      </pc:docMkLst>
      <pc:sldChg chg="addSp delSp modSp">
        <pc:chgData name="Jake Kendrick" userId="S::21308325@student.uwa.edu.au::ab142299-a4dd-4def-8b03-8ee3e1d9a7dd" providerId="AD" clId="Web-{4F710391-FD24-B9C4-7744-BF5434DF269E}" dt="2023-05-31T05:10:25.071" v="144" actId="20577"/>
        <pc:sldMkLst>
          <pc:docMk/>
          <pc:sldMk cId="109857222" sldId="256"/>
        </pc:sldMkLst>
        <pc:spChg chg="mod">
          <ac:chgData name="Jake Kendrick" userId="S::21308325@student.uwa.edu.au::ab142299-a4dd-4def-8b03-8ee3e1d9a7dd" providerId="AD" clId="Web-{4F710391-FD24-B9C4-7744-BF5434DF269E}" dt="2023-05-31T05:10:25.071" v="144" actId="20577"/>
          <ac:spMkLst>
            <pc:docMk/>
            <pc:sldMk cId="109857222" sldId="256"/>
            <ac:spMk id="4" creationId="{B78966BB-B4FE-5DBC-C3FF-9E2ADA0C6ACF}"/>
          </ac:spMkLst>
        </pc:spChg>
        <pc:graphicFrameChg chg="mod modGraphic">
          <ac:chgData name="Jake Kendrick" userId="S::21308325@student.uwa.edu.au::ab142299-a4dd-4def-8b03-8ee3e1d9a7dd" providerId="AD" clId="Web-{4F710391-FD24-B9C4-7744-BF5434DF269E}" dt="2023-05-31T05:09:36.070" v="142"/>
          <ac:graphicFrameMkLst>
            <pc:docMk/>
            <pc:sldMk cId="109857222" sldId="256"/>
            <ac:graphicFrameMk id="7" creationId="{277382E6-C6E4-6D8E-B6CB-723A91E54FAC}"/>
          </ac:graphicFrameMkLst>
        </pc:graphicFrameChg>
        <pc:picChg chg="add mod">
          <ac:chgData name="Jake Kendrick" userId="S::21308325@student.uwa.edu.au::ab142299-a4dd-4def-8b03-8ee3e1d9a7dd" providerId="AD" clId="Web-{4F710391-FD24-B9C4-7744-BF5434DF269E}" dt="2023-05-31T04:46:56.212" v="46" actId="1076"/>
          <ac:picMkLst>
            <pc:docMk/>
            <pc:sldMk cId="109857222" sldId="256"/>
            <ac:picMk id="3" creationId="{CB735357-50D4-6C1E-45BF-2572C6DDDCBE}"/>
          </ac:picMkLst>
        </pc:picChg>
        <pc:picChg chg="add mod">
          <ac:chgData name="Jake Kendrick" userId="S::21308325@student.uwa.edu.au::ab142299-a4dd-4def-8b03-8ee3e1d9a7dd" providerId="AD" clId="Web-{4F710391-FD24-B9C4-7744-BF5434DF269E}" dt="2023-05-31T04:50:10.123" v="48" actId="1076"/>
          <ac:picMkLst>
            <pc:docMk/>
            <pc:sldMk cId="109857222" sldId="256"/>
            <ac:picMk id="5" creationId="{06E7921B-76CC-085A-3D78-778AC1E318B7}"/>
          </ac:picMkLst>
        </pc:picChg>
        <pc:picChg chg="add mod">
          <ac:chgData name="Jake Kendrick" userId="S::21308325@student.uwa.edu.au::ab142299-a4dd-4def-8b03-8ee3e1d9a7dd" providerId="AD" clId="Web-{4F710391-FD24-B9C4-7744-BF5434DF269E}" dt="2023-05-31T04:54:20.675" v="50" actId="1076"/>
          <ac:picMkLst>
            <pc:docMk/>
            <pc:sldMk cId="109857222" sldId="256"/>
            <ac:picMk id="6" creationId="{13B886A7-A12C-4FD2-154E-4B8C0F088E95}"/>
          </ac:picMkLst>
        </pc:picChg>
        <pc:picChg chg="add mod">
          <ac:chgData name="Jake Kendrick" userId="S::21308325@student.uwa.edu.au::ab142299-a4dd-4def-8b03-8ee3e1d9a7dd" providerId="AD" clId="Web-{4F710391-FD24-B9C4-7744-BF5434DF269E}" dt="2023-05-31T04:54:44.457" v="52" actId="1076"/>
          <ac:picMkLst>
            <pc:docMk/>
            <pc:sldMk cId="109857222" sldId="256"/>
            <ac:picMk id="13" creationId="{06B8B814-FB8B-694A-0C1F-832A68674305}"/>
          </ac:picMkLst>
        </pc:picChg>
        <pc:picChg chg="del">
          <ac:chgData name="Jake Kendrick" userId="S::21308325@student.uwa.edu.au::ab142299-a4dd-4def-8b03-8ee3e1d9a7dd" providerId="AD" clId="Web-{4F710391-FD24-B9C4-7744-BF5434DF269E}" dt="2023-05-31T04:46:39.354" v="41"/>
          <ac:picMkLst>
            <pc:docMk/>
            <pc:sldMk cId="109857222" sldId="256"/>
            <ac:picMk id="14" creationId="{4805575D-724B-0721-19D5-7969E57983AD}"/>
          </ac:picMkLst>
        </pc:picChg>
        <pc:picChg chg="del">
          <ac:chgData name="Jake Kendrick" userId="S::21308325@student.uwa.edu.au::ab142299-a4dd-4def-8b03-8ee3e1d9a7dd" providerId="AD" clId="Web-{4F710391-FD24-B9C4-7744-BF5434DF269E}" dt="2023-05-31T04:46:40.056" v="42"/>
          <ac:picMkLst>
            <pc:docMk/>
            <pc:sldMk cId="109857222" sldId="256"/>
            <ac:picMk id="16" creationId="{075F939F-35E1-9D5B-02A2-E44724D26402}"/>
          </ac:picMkLst>
        </pc:picChg>
        <pc:picChg chg="del">
          <ac:chgData name="Jake Kendrick" userId="S::21308325@student.uwa.edu.au::ab142299-a4dd-4def-8b03-8ee3e1d9a7dd" providerId="AD" clId="Web-{4F710391-FD24-B9C4-7744-BF5434DF269E}" dt="2023-05-31T04:46:40.618" v="43"/>
          <ac:picMkLst>
            <pc:docMk/>
            <pc:sldMk cId="109857222" sldId="256"/>
            <ac:picMk id="18" creationId="{9F50A6FB-A4FA-2BD4-D64C-BFB76E471CCC}"/>
          </ac:picMkLst>
        </pc:picChg>
        <pc:picChg chg="del">
          <ac:chgData name="Jake Kendrick" userId="S::21308325@student.uwa.edu.au::ab142299-a4dd-4def-8b03-8ee3e1d9a7dd" providerId="AD" clId="Web-{4F710391-FD24-B9C4-7744-BF5434DF269E}" dt="2023-05-31T04:46:41.134" v="44"/>
          <ac:picMkLst>
            <pc:docMk/>
            <pc:sldMk cId="109857222" sldId="256"/>
            <ac:picMk id="19" creationId="{E4887A76-AD79-132E-7654-130AC7EEFA43}"/>
          </ac:picMkLst>
        </pc:picChg>
      </pc:sldChg>
    </pc:docChg>
  </pc:docChgLst>
  <pc:docChgLst>
    <pc:chgData name="Jake Kendrick" userId="S::21308325@student.uwa.edu.au::ab142299-a4dd-4def-8b03-8ee3e1d9a7dd" providerId="AD" clId="Web-{86ED6F03-63E6-4AF4-80A9-1F5E5B0F3C85}"/>
    <pc:docChg chg="modSld">
      <pc:chgData name="Jake Kendrick" userId="S::21308325@student.uwa.edu.au::ab142299-a4dd-4def-8b03-8ee3e1d9a7dd" providerId="AD" clId="Web-{86ED6F03-63E6-4AF4-80A9-1F5E5B0F3C85}" dt="2023-03-23T05:38:47.317" v="40"/>
      <pc:docMkLst>
        <pc:docMk/>
      </pc:docMkLst>
      <pc:sldChg chg="addSp delSp modSp">
        <pc:chgData name="Jake Kendrick" userId="S::21308325@student.uwa.edu.au::ab142299-a4dd-4def-8b03-8ee3e1d9a7dd" providerId="AD" clId="Web-{86ED6F03-63E6-4AF4-80A9-1F5E5B0F3C85}" dt="2023-03-23T05:38:47.317" v="40"/>
        <pc:sldMkLst>
          <pc:docMk/>
          <pc:sldMk cId="109857222" sldId="256"/>
        </pc:sldMkLst>
        <pc:picChg chg="add del mod">
          <ac:chgData name="Jake Kendrick" userId="S::21308325@student.uwa.edu.au::ab142299-a4dd-4def-8b03-8ee3e1d9a7dd" providerId="AD" clId="Web-{86ED6F03-63E6-4AF4-80A9-1F5E5B0F3C85}" dt="2023-03-23T05:00:21.403" v="7"/>
          <ac:picMkLst>
            <pc:docMk/>
            <pc:sldMk cId="109857222" sldId="256"/>
            <ac:picMk id="3" creationId="{1FF100CB-3368-8727-7F0E-D85AD3973E8A}"/>
          </ac:picMkLst>
        </pc:picChg>
        <pc:picChg chg="add mod">
          <ac:chgData name="Jake Kendrick" userId="S::21308325@student.uwa.edu.au::ab142299-a4dd-4def-8b03-8ee3e1d9a7dd" providerId="AD" clId="Web-{86ED6F03-63E6-4AF4-80A9-1F5E5B0F3C85}" dt="2023-03-23T04:55:09.829" v="6" actId="1076"/>
          <ac:picMkLst>
            <pc:docMk/>
            <pc:sldMk cId="109857222" sldId="256"/>
            <ac:picMk id="4" creationId="{C019A8C6-A179-6266-AC40-CF809E053682}"/>
          </ac:picMkLst>
        </pc:picChg>
        <pc:picChg chg="add del mod">
          <ac:chgData name="Jake Kendrick" userId="S::21308325@student.uwa.edu.au::ab142299-a4dd-4def-8b03-8ee3e1d9a7dd" providerId="AD" clId="Web-{86ED6F03-63E6-4AF4-80A9-1F5E5B0F3C85}" dt="2023-03-23T05:01:41.531" v="12"/>
          <ac:picMkLst>
            <pc:docMk/>
            <pc:sldMk cId="109857222" sldId="256"/>
            <ac:picMk id="5" creationId="{2613D035-3FEF-3440-68FD-F94FEDCEE0B4}"/>
          </ac:picMkLst>
        </pc:picChg>
        <pc:picChg chg="add del mod">
          <ac:chgData name="Jake Kendrick" userId="S::21308325@student.uwa.edu.au::ab142299-a4dd-4def-8b03-8ee3e1d9a7dd" providerId="AD" clId="Web-{86ED6F03-63E6-4AF4-80A9-1F5E5B0F3C85}" dt="2023-03-23T05:02:23.299" v="16"/>
          <ac:picMkLst>
            <pc:docMk/>
            <pc:sldMk cId="109857222" sldId="256"/>
            <ac:picMk id="6" creationId="{F08E551F-46FB-D4DC-2702-68CF6CF3EDC7}"/>
          </ac:picMkLst>
        </pc:picChg>
        <pc:picChg chg="add del mod">
          <ac:chgData name="Jake Kendrick" userId="S::21308325@student.uwa.edu.au::ab142299-a4dd-4def-8b03-8ee3e1d9a7dd" providerId="AD" clId="Web-{86ED6F03-63E6-4AF4-80A9-1F5E5B0F3C85}" dt="2023-03-23T05:02:34.533" v="19"/>
          <ac:picMkLst>
            <pc:docMk/>
            <pc:sldMk cId="109857222" sldId="256"/>
            <ac:picMk id="7" creationId="{BCB2D142-9AC9-F67A-7885-AABC0EAD55F5}"/>
          </ac:picMkLst>
        </pc:picChg>
        <pc:picChg chg="add del mod">
          <ac:chgData name="Jake Kendrick" userId="S::21308325@student.uwa.edu.au::ab142299-a4dd-4def-8b03-8ee3e1d9a7dd" providerId="AD" clId="Web-{86ED6F03-63E6-4AF4-80A9-1F5E5B0F3C85}" dt="2023-03-23T05:04:13.584" v="22"/>
          <ac:picMkLst>
            <pc:docMk/>
            <pc:sldMk cId="109857222" sldId="256"/>
            <ac:picMk id="8" creationId="{855FC974-7938-7ABD-7B6C-52D99046CEF9}"/>
          </ac:picMkLst>
        </pc:picChg>
        <pc:picChg chg="add del mod">
          <ac:chgData name="Jake Kendrick" userId="S::21308325@student.uwa.edu.au::ab142299-a4dd-4def-8b03-8ee3e1d9a7dd" providerId="AD" clId="Web-{86ED6F03-63E6-4AF4-80A9-1F5E5B0F3C85}" dt="2023-03-23T05:10:32.504" v="24"/>
          <ac:picMkLst>
            <pc:docMk/>
            <pc:sldMk cId="109857222" sldId="256"/>
            <ac:picMk id="9" creationId="{52DEADF0-2CE0-D5EA-400D-71C8EDE8F4CB}"/>
          </ac:picMkLst>
        </pc:picChg>
        <pc:picChg chg="add del mod">
          <ac:chgData name="Jake Kendrick" userId="S::21308325@student.uwa.edu.au::ab142299-a4dd-4def-8b03-8ee3e1d9a7dd" providerId="AD" clId="Web-{86ED6F03-63E6-4AF4-80A9-1F5E5B0F3C85}" dt="2023-03-23T05:11:40.772" v="27"/>
          <ac:picMkLst>
            <pc:docMk/>
            <pc:sldMk cId="109857222" sldId="256"/>
            <ac:picMk id="11" creationId="{45371F3B-E3A2-09CC-E5AC-0B4D61455A63}"/>
          </ac:picMkLst>
        </pc:picChg>
        <pc:picChg chg="add mod">
          <ac:chgData name="Jake Kendrick" userId="S::21308325@student.uwa.edu.au::ab142299-a4dd-4def-8b03-8ee3e1d9a7dd" providerId="AD" clId="Web-{86ED6F03-63E6-4AF4-80A9-1F5E5B0F3C85}" dt="2023-03-23T05:14:50.107" v="32" actId="1076"/>
          <ac:picMkLst>
            <pc:docMk/>
            <pc:sldMk cId="109857222" sldId="256"/>
            <ac:picMk id="14" creationId="{BBCEA129-4F1A-83A4-6952-E8EA980D7838}"/>
          </ac:picMkLst>
        </pc:picChg>
        <pc:picChg chg="add del mod">
          <ac:chgData name="Jake Kendrick" userId="S::21308325@student.uwa.edu.au::ab142299-a4dd-4def-8b03-8ee3e1d9a7dd" providerId="AD" clId="Web-{86ED6F03-63E6-4AF4-80A9-1F5E5B0F3C85}" dt="2023-03-23T05:28:58.826" v="36"/>
          <ac:picMkLst>
            <pc:docMk/>
            <pc:sldMk cId="109857222" sldId="256"/>
            <ac:picMk id="16" creationId="{B25DB94C-A424-D27B-6F4D-E85BAC9D53C8}"/>
          </ac:picMkLst>
        </pc:picChg>
        <pc:picChg chg="add del mod">
          <ac:chgData name="Jake Kendrick" userId="S::21308325@student.uwa.edu.au::ab142299-a4dd-4def-8b03-8ee3e1d9a7dd" providerId="AD" clId="Web-{86ED6F03-63E6-4AF4-80A9-1F5E5B0F3C85}" dt="2023-03-23T05:38:47.317" v="40"/>
          <ac:picMkLst>
            <pc:docMk/>
            <pc:sldMk cId="109857222" sldId="256"/>
            <ac:picMk id="17" creationId="{9B2B96C3-B133-5171-E392-9FA31B5D9F68}"/>
          </ac:picMkLst>
        </pc:picChg>
      </pc:sldChg>
    </pc:docChg>
  </pc:docChgLst>
  <pc:docChgLst>
    <pc:chgData name="Jake Kendrick" userId="S::21308325@student.uwa.edu.au::ab142299-a4dd-4def-8b03-8ee3e1d9a7dd" providerId="AD" clId="Web-{20A4B039-7DBA-447A-9417-E4D1B9757562}"/>
    <pc:docChg chg="modSld">
      <pc:chgData name="Jake Kendrick" userId="S::21308325@student.uwa.edu.au::ab142299-a4dd-4def-8b03-8ee3e1d9a7dd" providerId="AD" clId="Web-{20A4B039-7DBA-447A-9417-E4D1B9757562}" dt="2023-04-03T00:06:20.743" v="32" actId="1076"/>
      <pc:docMkLst>
        <pc:docMk/>
      </pc:docMkLst>
      <pc:sldChg chg="addSp delSp modSp">
        <pc:chgData name="Jake Kendrick" userId="S::21308325@student.uwa.edu.au::ab142299-a4dd-4def-8b03-8ee3e1d9a7dd" providerId="AD" clId="Web-{20A4B039-7DBA-447A-9417-E4D1B9757562}" dt="2023-04-03T00:06:20.743" v="32" actId="1076"/>
        <pc:sldMkLst>
          <pc:docMk/>
          <pc:sldMk cId="109857222" sldId="256"/>
        </pc:sldMkLst>
        <pc:spChg chg="add mod">
          <ac:chgData name="Jake Kendrick" userId="S::21308325@student.uwa.edu.au::ab142299-a4dd-4def-8b03-8ee3e1d9a7dd" providerId="AD" clId="Web-{20A4B039-7DBA-447A-9417-E4D1B9757562}" dt="2023-04-03T00:06:02.492" v="27" actId="14100"/>
          <ac:spMkLst>
            <pc:docMk/>
            <pc:sldMk cId="109857222" sldId="256"/>
            <ac:spMk id="3" creationId="{752B7F05-BB20-FF7C-46AD-19DB3DCBC1C5}"/>
          </ac:spMkLst>
        </pc:spChg>
        <pc:spChg chg="add mod">
          <ac:chgData name="Jake Kendrick" userId="S::21308325@student.uwa.edu.au::ab142299-a4dd-4def-8b03-8ee3e1d9a7dd" providerId="AD" clId="Web-{20A4B039-7DBA-447A-9417-E4D1B9757562}" dt="2023-04-03T00:06:06.664" v="28" actId="1076"/>
          <ac:spMkLst>
            <pc:docMk/>
            <pc:sldMk cId="109857222" sldId="256"/>
            <ac:spMk id="5" creationId="{98293BB6-3D40-E604-EEC1-B02802083163}"/>
          </ac:spMkLst>
        </pc:spChg>
        <pc:spChg chg="add mod">
          <ac:chgData name="Jake Kendrick" userId="S::21308325@student.uwa.edu.au::ab142299-a4dd-4def-8b03-8ee3e1d9a7dd" providerId="AD" clId="Web-{20A4B039-7DBA-447A-9417-E4D1B9757562}" dt="2023-04-03T00:06:20.743" v="32" actId="1076"/>
          <ac:spMkLst>
            <pc:docMk/>
            <pc:sldMk cId="109857222" sldId="256"/>
            <ac:spMk id="6" creationId="{54EB5050-2446-CEE9-5B90-ABA19520141F}"/>
          </ac:spMkLst>
        </pc:spChg>
        <pc:picChg chg="del">
          <ac:chgData name="Jake Kendrick" userId="S::21308325@student.uwa.edu.au::ab142299-a4dd-4def-8b03-8ee3e1d9a7dd" providerId="AD" clId="Web-{20A4B039-7DBA-447A-9417-E4D1B9757562}" dt="2023-04-03T00:03:30.347" v="0"/>
          <ac:picMkLst>
            <pc:docMk/>
            <pc:sldMk cId="109857222" sldId="256"/>
            <ac:picMk id="4" creationId="{C019A8C6-A179-6266-AC40-CF809E053682}"/>
          </ac:picMkLst>
        </pc:picChg>
        <pc:picChg chg="del">
          <ac:chgData name="Jake Kendrick" userId="S::21308325@student.uwa.edu.au::ab142299-a4dd-4def-8b03-8ee3e1d9a7dd" providerId="AD" clId="Web-{20A4B039-7DBA-447A-9417-E4D1B9757562}" dt="2023-04-03T00:03:30.863" v="1"/>
          <ac:picMkLst>
            <pc:docMk/>
            <pc:sldMk cId="109857222" sldId="256"/>
            <ac:picMk id="14" creationId="{BBCEA129-4F1A-83A4-6952-E8EA980D7838}"/>
          </ac:picMkLst>
        </pc:picChg>
      </pc:sldChg>
    </pc:docChg>
  </pc:docChgLst>
  <pc:docChgLst>
    <pc:chgData name="Jake Kendrick" userId="S::21308325@student.uwa.edu.au::ab142299-a4dd-4def-8b03-8ee3e1d9a7dd" providerId="AD" clId="Web-{971CA831-DAEA-4931-A841-4AA89F631199}"/>
    <pc:docChg chg="modSld">
      <pc:chgData name="Jake Kendrick" userId="S::21308325@student.uwa.edu.au::ab142299-a4dd-4def-8b03-8ee3e1d9a7dd" providerId="AD" clId="Web-{971CA831-DAEA-4931-A841-4AA89F631199}" dt="2023-01-02T23:46:28.802" v="180" actId="20577"/>
      <pc:docMkLst>
        <pc:docMk/>
      </pc:docMkLst>
      <pc:sldChg chg="modSp">
        <pc:chgData name="Jake Kendrick" userId="S::21308325@student.uwa.edu.au::ab142299-a4dd-4def-8b03-8ee3e1d9a7dd" providerId="AD" clId="Web-{971CA831-DAEA-4931-A841-4AA89F631199}" dt="2023-01-02T23:46:28.802" v="180" actId="20577"/>
        <pc:sldMkLst>
          <pc:docMk/>
          <pc:sldMk cId="109857222" sldId="256"/>
        </pc:sldMkLst>
        <pc:spChg chg="mod">
          <ac:chgData name="Jake Kendrick" userId="S::21308325@student.uwa.edu.au::ab142299-a4dd-4def-8b03-8ee3e1d9a7dd" providerId="AD" clId="Web-{971CA831-DAEA-4931-A841-4AA89F631199}" dt="2023-01-02T23:46:28.802" v="180" actId="20577"/>
          <ac:spMkLst>
            <pc:docMk/>
            <pc:sldMk cId="109857222" sldId="256"/>
            <ac:spMk id="13" creationId="{A9A32FB2-2064-654E-9855-BDC1D5C342CA}"/>
          </ac:spMkLst>
        </pc:spChg>
      </pc:sldChg>
    </pc:docChg>
  </pc:docChgLst>
  <pc:docChgLst>
    <pc:chgData name="Jake Kendrick" userId="c9aa91da-2e15-46cf-a8c4-b4cee9b8e514" providerId="ADAL" clId="{8B45A429-B7B1-FD4F-BC49-09965DEFACEA}"/>
    <pc:docChg chg="modSld">
      <pc:chgData name="Jake Kendrick" userId="c9aa91da-2e15-46cf-a8c4-b4cee9b8e514" providerId="ADAL" clId="{8B45A429-B7B1-FD4F-BC49-09965DEFACEA}" dt="2023-01-09T23:40:28.912" v="0" actId="767"/>
      <pc:docMkLst>
        <pc:docMk/>
      </pc:docMkLst>
      <pc:sldChg chg="addSp modSp">
        <pc:chgData name="Jake Kendrick" userId="c9aa91da-2e15-46cf-a8c4-b4cee9b8e514" providerId="ADAL" clId="{8B45A429-B7B1-FD4F-BC49-09965DEFACEA}" dt="2023-01-09T23:40:28.912" v="0" actId="767"/>
        <pc:sldMkLst>
          <pc:docMk/>
          <pc:sldMk cId="109857222" sldId="256"/>
        </pc:sldMkLst>
        <pc:spChg chg="add mod">
          <ac:chgData name="Jake Kendrick" userId="c9aa91da-2e15-46cf-a8c4-b4cee9b8e514" providerId="ADAL" clId="{8B45A429-B7B1-FD4F-BC49-09965DEFACEA}" dt="2023-01-09T23:40:28.912" v="0" actId="767"/>
          <ac:spMkLst>
            <pc:docMk/>
            <pc:sldMk cId="109857222" sldId="256"/>
            <ac:spMk id="2" creationId="{2EF2A381-DB62-ADB9-8061-FEE116D46C4B}"/>
          </ac:spMkLst>
        </pc:spChg>
      </pc:sldChg>
    </pc:docChg>
  </pc:docChgLst>
  <pc:docChgLst>
    <pc:chgData name="Jake Kendrick" userId="S::21308325@student.uwa.edu.au::ab142299-a4dd-4def-8b03-8ee3e1d9a7dd" providerId="AD" clId="Web-{4E3A628E-BFF1-479D-AE1E-F018F1267E13}"/>
    <pc:docChg chg="modSld">
      <pc:chgData name="Jake Kendrick" userId="S::21308325@student.uwa.edu.au::ab142299-a4dd-4def-8b03-8ee3e1d9a7dd" providerId="AD" clId="Web-{4E3A628E-BFF1-479D-AE1E-F018F1267E13}" dt="2023-01-05T05:42:05.204" v="7" actId="20577"/>
      <pc:docMkLst>
        <pc:docMk/>
      </pc:docMkLst>
      <pc:sldChg chg="modSp">
        <pc:chgData name="Jake Kendrick" userId="S::21308325@student.uwa.edu.au::ab142299-a4dd-4def-8b03-8ee3e1d9a7dd" providerId="AD" clId="Web-{4E3A628E-BFF1-479D-AE1E-F018F1267E13}" dt="2023-01-05T05:42:05.204" v="7" actId="20577"/>
        <pc:sldMkLst>
          <pc:docMk/>
          <pc:sldMk cId="109857222" sldId="256"/>
        </pc:sldMkLst>
        <pc:spChg chg="mod">
          <ac:chgData name="Jake Kendrick" userId="S::21308325@student.uwa.edu.au::ab142299-a4dd-4def-8b03-8ee3e1d9a7dd" providerId="AD" clId="Web-{4E3A628E-BFF1-479D-AE1E-F018F1267E13}" dt="2023-01-05T05:42:05.204" v="7" actId="20577"/>
          <ac:spMkLst>
            <pc:docMk/>
            <pc:sldMk cId="109857222" sldId="256"/>
            <ac:spMk id="13" creationId="{A9A32FB2-2064-654E-9855-BDC1D5C342CA}"/>
          </ac:spMkLst>
        </pc:spChg>
      </pc:sldChg>
    </pc:docChg>
  </pc:docChgLst>
  <pc:docChgLst>
    <pc:chgData name="Jake Kendrick" userId="S::21308325@student.uwa.edu.au::ab142299-a4dd-4def-8b03-8ee3e1d9a7dd" providerId="AD" clId="Web-{DE7C6DF5-6E4C-F2E7-143C-B8CE36CA6F5E}"/>
    <pc:docChg chg="addSld modSld">
      <pc:chgData name="Jake Kendrick" userId="S::21308325@student.uwa.edu.au::ab142299-a4dd-4def-8b03-8ee3e1d9a7dd" providerId="AD" clId="Web-{DE7C6DF5-6E4C-F2E7-143C-B8CE36CA6F5E}" dt="2023-05-04T05:44:55.277" v="827" actId="20577"/>
      <pc:docMkLst>
        <pc:docMk/>
      </pc:docMkLst>
      <pc:sldChg chg="addSp delSp modSp">
        <pc:chgData name="Jake Kendrick" userId="S::21308325@student.uwa.edu.au::ab142299-a4dd-4def-8b03-8ee3e1d9a7dd" providerId="AD" clId="Web-{DE7C6DF5-6E4C-F2E7-143C-B8CE36CA6F5E}" dt="2023-05-04T05:35:13.790" v="256" actId="20577"/>
        <pc:sldMkLst>
          <pc:docMk/>
          <pc:sldMk cId="109857222" sldId="256"/>
        </pc:sldMkLst>
        <pc:spChg chg="mod">
          <ac:chgData name="Jake Kendrick" userId="S::21308325@student.uwa.edu.au::ab142299-a4dd-4def-8b03-8ee3e1d9a7dd" providerId="AD" clId="Web-{DE7C6DF5-6E4C-F2E7-143C-B8CE36CA6F5E}" dt="2023-05-04T05:34:47.821" v="234" actId="20577"/>
          <ac:spMkLst>
            <pc:docMk/>
            <pc:sldMk cId="109857222" sldId="256"/>
            <ac:spMk id="8" creationId="{041D0248-A10B-9F46-5A61-C090DA7913F3}"/>
          </ac:spMkLst>
        </pc:spChg>
        <pc:spChg chg="mod">
          <ac:chgData name="Jake Kendrick" userId="S::21308325@student.uwa.edu.au::ab142299-a4dd-4def-8b03-8ee3e1d9a7dd" providerId="AD" clId="Web-{DE7C6DF5-6E4C-F2E7-143C-B8CE36CA6F5E}" dt="2023-05-04T05:34:51.321" v="236" actId="20577"/>
          <ac:spMkLst>
            <pc:docMk/>
            <pc:sldMk cId="109857222" sldId="256"/>
            <ac:spMk id="9" creationId="{6C3B6FDF-F768-36A2-9015-C260E85FB4D9}"/>
          </ac:spMkLst>
        </pc:spChg>
        <pc:spChg chg="mod">
          <ac:chgData name="Jake Kendrick" userId="S::21308325@student.uwa.edu.au::ab142299-a4dd-4def-8b03-8ee3e1d9a7dd" providerId="AD" clId="Web-{DE7C6DF5-6E4C-F2E7-143C-B8CE36CA6F5E}" dt="2023-05-04T05:34:53.696" v="240" actId="20577"/>
          <ac:spMkLst>
            <pc:docMk/>
            <pc:sldMk cId="109857222" sldId="256"/>
            <ac:spMk id="10" creationId="{DF6790C0-0DCA-2251-715A-2652703863E9}"/>
          </ac:spMkLst>
        </pc:spChg>
        <pc:spChg chg="mod">
          <ac:chgData name="Jake Kendrick" userId="S::21308325@student.uwa.edu.au::ab142299-a4dd-4def-8b03-8ee3e1d9a7dd" providerId="AD" clId="Web-{DE7C6DF5-6E4C-F2E7-143C-B8CE36CA6F5E}" dt="2023-05-04T05:35:09.400" v="252" actId="20577"/>
          <ac:spMkLst>
            <pc:docMk/>
            <pc:sldMk cId="109857222" sldId="256"/>
            <ac:spMk id="11" creationId="{FBF1C41F-63C6-7F23-2E67-7A5EC0A32D6A}"/>
          </ac:spMkLst>
        </pc:spChg>
        <pc:spChg chg="add del mod">
          <ac:chgData name="Jake Kendrick" userId="S::21308325@student.uwa.edu.au::ab142299-a4dd-4def-8b03-8ee3e1d9a7dd" providerId="AD" clId="Web-{DE7C6DF5-6E4C-F2E7-143C-B8CE36CA6F5E}" dt="2023-05-04T05:35:13.790" v="256" actId="20577"/>
          <ac:spMkLst>
            <pc:docMk/>
            <pc:sldMk cId="109857222" sldId="256"/>
            <ac:spMk id="13" creationId="{DA3BCD9B-837D-5E60-A267-BFE9F61A15F4}"/>
          </ac:spMkLst>
        </pc:spChg>
      </pc:sldChg>
      <pc:sldChg chg="addSp delSp modSp new">
        <pc:chgData name="Jake Kendrick" userId="S::21308325@student.uwa.edu.au::ab142299-a4dd-4def-8b03-8ee3e1d9a7dd" providerId="AD" clId="Web-{DE7C6DF5-6E4C-F2E7-143C-B8CE36CA6F5E}" dt="2023-05-04T05:44:55.277" v="827" actId="20577"/>
        <pc:sldMkLst>
          <pc:docMk/>
          <pc:sldMk cId="169461359" sldId="257"/>
        </pc:sldMkLst>
        <pc:spChg chg="del">
          <ac:chgData name="Jake Kendrick" userId="S::21308325@student.uwa.edu.au::ab142299-a4dd-4def-8b03-8ee3e1d9a7dd" providerId="AD" clId="Web-{DE7C6DF5-6E4C-F2E7-143C-B8CE36CA6F5E}" dt="2023-05-04T05:30:21.391" v="7"/>
          <ac:spMkLst>
            <pc:docMk/>
            <pc:sldMk cId="169461359" sldId="257"/>
            <ac:spMk id="2" creationId="{F704C1AF-88B0-81E4-B629-E815D1F7DE77}"/>
          </ac:spMkLst>
        </pc:spChg>
        <pc:spChg chg="del">
          <ac:chgData name="Jake Kendrick" userId="S::21308325@student.uwa.edu.au::ab142299-a4dd-4def-8b03-8ee3e1d9a7dd" providerId="AD" clId="Web-{DE7C6DF5-6E4C-F2E7-143C-B8CE36CA6F5E}" dt="2023-05-04T05:30:23.907" v="8"/>
          <ac:spMkLst>
            <pc:docMk/>
            <pc:sldMk cId="169461359" sldId="257"/>
            <ac:spMk id="3" creationId="{0B25DDDC-AB36-8845-916C-686FC80CD4BD}"/>
          </ac:spMkLst>
        </pc:spChg>
        <pc:spChg chg="add mod">
          <ac:chgData name="Jake Kendrick" userId="S::21308325@student.uwa.edu.au::ab142299-a4dd-4def-8b03-8ee3e1d9a7dd" providerId="AD" clId="Web-{DE7C6DF5-6E4C-F2E7-143C-B8CE36CA6F5E}" dt="2023-05-04T05:44:55.277" v="827" actId="20577"/>
          <ac:spMkLst>
            <pc:docMk/>
            <pc:sldMk cId="169461359" sldId="257"/>
            <ac:spMk id="4" creationId="{DA2CAD60-077B-2071-8974-928108A43881}"/>
          </ac:spMkLst>
        </pc:spChg>
      </pc:sldChg>
    </pc:docChg>
  </pc:docChgLst>
  <pc:docChgLst>
    <pc:chgData name="Jake Kendrick" userId="S::21308325@student.uwa.edu.au::ab142299-a4dd-4def-8b03-8ee3e1d9a7dd" providerId="AD" clId="Web-{0344D514-DB4A-C863-FF28-3BBF1CA4CD24}"/>
    <pc:docChg chg="modSld">
      <pc:chgData name="Jake Kendrick" userId="S::21308325@student.uwa.edu.au::ab142299-a4dd-4def-8b03-8ee3e1d9a7dd" providerId="AD" clId="Web-{0344D514-DB4A-C863-FF28-3BBF1CA4CD24}" dt="2023-04-20T07:46:11.914" v="3" actId="1076"/>
      <pc:docMkLst>
        <pc:docMk/>
      </pc:docMkLst>
      <pc:sldChg chg="addSp modSp">
        <pc:chgData name="Jake Kendrick" userId="S::21308325@student.uwa.edu.au::ab142299-a4dd-4def-8b03-8ee3e1d9a7dd" providerId="AD" clId="Web-{0344D514-DB4A-C863-FF28-3BBF1CA4CD24}" dt="2023-04-20T07:46:11.914" v="3" actId="1076"/>
        <pc:sldMkLst>
          <pc:docMk/>
          <pc:sldMk cId="109857222" sldId="256"/>
        </pc:sldMkLst>
        <pc:picChg chg="add mod">
          <ac:chgData name="Jake Kendrick" userId="S::21308325@student.uwa.edu.au::ab142299-a4dd-4def-8b03-8ee3e1d9a7dd" providerId="AD" clId="Web-{0344D514-DB4A-C863-FF28-3BBF1CA4CD24}" dt="2023-04-20T07:46:11.914" v="3" actId="1076"/>
          <ac:picMkLst>
            <pc:docMk/>
            <pc:sldMk cId="109857222" sldId="256"/>
            <ac:picMk id="3" creationId="{E8F764C4-D6FF-C1CE-BFD9-596111DAFC0C}"/>
          </ac:picMkLst>
        </pc:picChg>
        <pc:picChg chg="mod">
          <ac:chgData name="Jake Kendrick" userId="S::21308325@student.uwa.edu.au::ab142299-a4dd-4def-8b03-8ee3e1d9a7dd" providerId="AD" clId="Web-{0344D514-DB4A-C863-FF28-3BBF1CA4CD24}" dt="2023-04-20T06:38:12.969" v="0" actId="1076"/>
          <ac:picMkLst>
            <pc:docMk/>
            <pc:sldMk cId="109857222" sldId="256"/>
            <ac:picMk id="6" creationId="{B919A257-4724-3984-FC02-16DECF9DA3E1}"/>
          </ac:picMkLst>
        </pc:picChg>
      </pc:sldChg>
    </pc:docChg>
  </pc:docChgLst>
  <pc:docChgLst>
    <pc:chgData name="Jake Kendrick" userId="S::21308325@student.uwa.edu.au::ab142299-a4dd-4def-8b03-8ee3e1d9a7dd" providerId="AD" clId="Web-{97CF255D-1AC1-AA4C-F5CF-DFD8AC230607}"/>
    <pc:docChg chg="modSld">
      <pc:chgData name="Jake Kendrick" userId="S::21308325@student.uwa.edu.au::ab142299-a4dd-4def-8b03-8ee3e1d9a7dd" providerId="AD" clId="Web-{97CF255D-1AC1-AA4C-F5CF-DFD8AC230607}" dt="2023-06-16T06:18:13.088" v="0" actId="20577"/>
      <pc:docMkLst>
        <pc:docMk/>
      </pc:docMkLst>
      <pc:sldChg chg="modSp">
        <pc:chgData name="Jake Kendrick" userId="S::21308325@student.uwa.edu.au::ab142299-a4dd-4def-8b03-8ee3e1d9a7dd" providerId="AD" clId="Web-{97CF255D-1AC1-AA4C-F5CF-DFD8AC230607}" dt="2023-06-16T06:18:13.088" v="0" actId="20577"/>
        <pc:sldMkLst>
          <pc:docMk/>
          <pc:sldMk cId="109857222" sldId="256"/>
        </pc:sldMkLst>
        <pc:spChg chg="mod">
          <ac:chgData name="Jake Kendrick" userId="S::21308325@student.uwa.edu.au::ab142299-a4dd-4def-8b03-8ee3e1d9a7dd" providerId="AD" clId="Web-{97CF255D-1AC1-AA4C-F5CF-DFD8AC230607}" dt="2023-06-16T06:18:13.088" v="0" actId="20577"/>
          <ac:spMkLst>
            <pc:docMk/>
            <pc:sldMk cId="109857222" sldId="256"/>
            <ac:spMk id="4" creationId="{B78966BB-B4FE-5DBC-C3FF-9E2ADA0C6ACF}"/>
          </ac:spMkLst>
        </pc:spChg>
      </pc:sldChg>
    </pc:docChg>
  </pc:docChgLst>
  <pc:docChgLst>
    <pc:chgData name="Jake Kendrick" userId="S::21308325@student.uwa.edu.au::ab142299-a4dd-4def-8b03-8ee3e1d9a7dd" providerId="AD" clId="Web-{798923EE-36AA-1FF6-7586-29FCD12DCB0B}"/>
    <pc:docChg chg="modSld">
      <pc:chgData name="Jake Kendrick" userId="S::21308325@student.uwa.edu.au::ab142299-a4dd-4def-8b03-8ee3e1d9a7dd" providerId="AD" clId="Web-{798923EE-36AA-1FF6-7586-29FCD12DCB0B}" dt="2023-01-18T01:14:23.985" v="11" actId="20577"/>
      <pc:docMkLst>
        <pc:docMk/>
      </pc:docMkLst>
      <pc:sldChg chg="modSp">
        <pc:chgData name="Jake Kendrick" userId="S::21308325@student.uwa.edu.au::ab142299-a4dd-4def-8b03-8ee3e1d9a7dd" providerId="AD" clId="Web-{798923EE-36AA-1FF6-7586-29FCD12DCB0B}" dt="2023-01-18T01:14:23.985" v="11" actId="20577"/>
        <pc:sldMkLst>
          <pc:docMk/>
          <pc:sldMk cId="109857222" sldId="256"/>
        </pc:sldMkLst>
        <pc:spChg chg="mod">
          <ac:chgData name="Jake Kendrick" userId="S::21308325@student.uwa.edu.au::ab142299-a4dd-4def-8b03-8ee3e1d9a7dd" providerId="AD" clId="Web-{798923EE-36AA-1FF6-7586-29FCD12DCB0B}" dt="2023-01-18T01:14:23.985" v="11" actId="20577"/>
          <ac:spMkLst>
            <pc:docMk/>
            <pc:sldMk cId="109857222" sldId="256"/>
            <ac:spMk id="13" creationId="{A9A32FB2-2064-654E-9855-BDC1D5C342CA}"/>
          </ac:spMkLst>
        </pc:spChg>
      </pc:sldChg>
    </pc:docChg>
  </pc:docChgLst>
  <pc:docChgLst>
    <pc:chgData name="Jake Kendrick" userId="S::21308325@student.uwa.edu.au::ab142299-a4dd-4def-8b03-8ee3e1d9a7dd" providerId="AD" clId="Web-{11E9321A-6FD3-4CBD-9F17-7B40575D75C8}"/>
    <pc:docChg chg="modSld">
      <pc:chgData name="Jake Kendrick" userId="S::21308325@student.uwa.edu.au::ab142299-a4dd-4def-8b03-8ee3e1d9a7dd" providerId="AD" clId="Web-{11E9321A-6FD3-4CBD-9F17-7B40575D75C8}" dt="2023-01-09T03:31:22.234" v="321" actId="20577"/>
      <pc:docMkLst>
        <pc:docMk/>
      </pc:docMkLst>
      <pc:sldChg chg="modSp">
        <pc:chgData name="Jake Kendrick" userId="S::21308325@student.uwa.edu.au::ab142299-a4dd-4def-8b03-8ee3e1d9a7dd" providerId="AD" clId="Web-{11E9321A-6FD3-4CBD-9F17-7B40575D75C8}" dt="2023-01-09T03:31:22.234" v="321" actId="20577"/>
        <pc:sldMkLst>
          <pc:docMk/>
          <pc:sldMk cId="109857222" sldId="256"/>
        </pc:sldMkLst>
        <pc:spChg chg="mod">
          <ac:chgData name="Jake Kendrick" userId="S::21308325@student.uwa.edu.au::ab142299-a4dd-4def-8b03-8ee3e1d9a7dd" providerId="AD" clId="Web-{11E9321A-6FD3-4CBD-9F17-7B40575D75C8}" dt="2023-01-09T03:31:22.234" v="321" actId="20577"/>
          <ac:spMkLst>
            <pc:docMk/>
            <pc:sldMk cId="109857222" sldId="256"/>
            <ac:spMk id="13" creationId="{A9A32FB2-2064-654E-9855-BDC1D5C342CA}"/>
          </ac:spMkLst>
        </pc:spChg>
      </pc:sldChg>
    </pc:docChg>
  </pc:docChgLst>
  <pc:docChgLst>
    <pc:chgData name="Jake Kendrick" userId="S::21308325@student.uwa.edu.au::ab142299-a4dd-4def-8b03-8ee3e1d9a7dd" providerId="AD" clId="Web-{BD978237-DCF2-278F-9551-890A85808CE6}"/>
    <pc:docChg chg="modSld">
      <pc:chgData name="Jake Kendrick" userId="S::21308325@student.uwa.edu.au::ab142299-a4dd-4def-8b03-8ee3e1d9a7dd" providerId="AD" clId="Web-{BD978237-DCF2-278F-9551-890A85808CE6}" dt="2023-04-13T01:52:01.679" v="2" actId="1076"/>
      <pc:docMkLst>
        <pc:docMk/>
      </pc:docMkLst>
      <pc:sldChg chg="addSp modSp">
        <pc:chgData name="Jake Kendrick" userId="S::21308325@student.uwa.edu.au::ab142299-a4dd-4def-8b03-8ee3e1d9a7dd" providerId="AD" clId="Web-{BD978237-DCF2-278F-9551-890A85808CE6}" dt="2023-04-13T01:52:01.679" v="2" actId="1076"/>
        <pc:sldMkLst>
          <pc:docMk/>
          <pc:sldMk cId="109857222" sldId="256"/>
        </pc:sldMkLst>
        <pc:picChg chg="mod">
          <ac:chgData name="Jake Kendrick" userId="S::21308325@student.uwa.edu.au::ab142299-a4dd-4def-8b03-8ee3e1d9a7dd" providerId="AD" clId="Web-{BD978237-DCF2-278F-9551-890A85808CE6}" dt="2023-04-13T01:50:00.677" v="0" actId="1076"/>
          <ac:picMkLst>
            <pc:docMk/>
            <pc:sldMk cId="109857222" sldId="256"/>
            <ac:picMk id="4" creationId="{3778CDEF-44B7-F2C1-0189-6FCA3A94E4CF}"/>
          </ac:picMkLst>
        </pc:picChg>
        <pc:picChg chg="add mod">
          <ac:chgData name="Jake Kendrick" userId="S::21308325@student.uwa.edu.au::ab142299-a4dd-4def-8b03-8ee3e1d9a7dd" providerId="AD" clId="Web-{BD978237-DCF2-278F-9551-890A85808CE6}" dt="2023-04-13T01:52:01.679" v="2" actId="1076"/>
          <ac:picMkLst>
            <pc:docMk/>
            <pc:sldMk cId="109857222" sldId="256"/>
            <ac:picMk id="5" creationId="{BBED81FA-1167-3EB8-F332-059E25B64E73}"/>
          </ac:picMkLst>
        </pc:picChg>
      </pc:sldChg>
    </pc:docChg>
  </pc:docChgLst>
  <pc:docChgLst>
    <pc:chgData name="Jake Kendrick" userId="S::21308325@student.uwa.edu.au::ab142299-a4dd-4def-8b03-8ee3e1d9a7dd" providerId="AD" clId="Web-{71067842-DC60-4BA4-A80B-E2F3844D8B62}"/>
    <pc:docChg chg="modSld">
      <pc:chgData name="Jake Kendrick" userId="S::21308325@student.uwa.edu.au::ab142299-a4dd-4def-8b03-8ee3e1d9a7dd" providerId="AD" clId="Web-{71067842-DC60-4BA4-A80B-E2F3844D8B62}" dt="2023-01-09T03:41:48.887" v="282" actId="20577"/>
      <pc:docMkLst>
        <pc:docMk/>
      </pc:docMkLst>
      <pc:sldChg chg="modSp">
        <pc:chgData name="Jake Kendrick" userId="S::21308325@student.uwa.edu.au::ab142299-a4dd-4def-8b03-8ee3e1d9a7dd" providerId="AD" clId="Web-{71067842-DC60-4BA4-A80B-E2F3844D8B62}" dt="2023-01-09T03:41:48.887" v="282" actId="20577"/>
        <pc:sldMkLst>
          <pc:docMk/>
          <pc:sldMk cId="109857222" sldId="256"/>
        </pc:sldMkLst>
        <pc:spChg chg="mod">
          <ac:chgData name="Jake Kendrick" userId="S::21308325@student.uwa.edu.au::ab142299-a4dd-4def-8b03-8ee3e1d9a7dd" providerId="AD" clId="Web-{71067842-DC60-4BA4-A80B-E2F3844D8B62}" dt="2023-01-09T03:41:48.887" v="282" actId="20577"/>
          <ac:spMkLst>
            <pc:docMk/>
            <pc:sldMk cId="109857222" sldId="256"/>
            <ac:spMk id="13" creationId="{A9A32FB2-2064-654E-9855-BDC1D5C342CA}"/>
          </ac:spMkLst>
        </pc:spChg>
      </pc:sldChg>
    </pc:docChg>
  </pc:docChgLst>
  <pc:docChgLst>
    <pc:chgData name="Jake Kendrick" userId="S::21308325@student.uwa.edu.au::ab142299-a4dd-4def-8b03-8ee3e1d9a7dd" providerId="AD" clId="Web-{6A8078A2-13CA-018C-6D6B-BA50CC66E3DB}"/>
    <pc:docChg chg="modSld">
      <pc:chgData name="Jake Kendrick" userId="S::21308325@student.uwa.edu.au::ab142299-a4dd-4def-8b03-8ee3e1d9a7dd" providerId="AD" clId="Web-{6A8078A2-13CA-018C-6D6B-BA50CC66E3DB}" dt="2023-04-13T02:02:57.902" v="495" actId="20577"/>
      <pc:docMkLst>
        <pc:docMk/>
      </pc:docMkLst>
      <pc:sldChg chg="addSp modSp">
        <pc:chgData name="Jake Kendrick" userId="S::21308325@student.uwa.edu.au::ab142299-a4dd-4def-8b03-8ee3e1d9a7dd" providerId="AD" clId="Web-{6A8078A2-13CA-018C-6D6B-BA50CC66E3DB}" dt="2023-04-13T02:02:57.902" v="495" actId="20577"/>
        <pc:sldMkLst>
          <pc:docMk/>
          <pc:sldMk cId="109857222" sldId="256"/>
        </pc:sldMkLst>
        <pc:spChg chg="add mod">
          <ac:chgData name="Jake Kendrick" userId="S::21308325@student.uwa.edu.au::ab142299-a4dd-4def-8b03-8ee3e1d9a7dd" providerId="AD" clId="Web-{6A8078A2-13CA-018C-6D6B-BA50CC66E3DB}" dt="2023-04-13T02:02:57.902" v="495" actId="20577"/>
          <ac:spMkLst>
            <pc:docMk/>
            <pc:sldMk cId="109857222" sldId="256"/>
            <ac:spMk id="6" creationId="{23160FD5-8722-3429-CB9A-189EF509C80F}"/>
          </ac:spMkLst>
        </pc:spChg>
        <pc:spChg chg="add mod">
          <ac:chgData name="Jake Kendrick" userId="S::21308325@student.uwa.edu.au::ab142299-a4dd-4def-8b03-8ee3e1d9a7dd" providerId="AD" clId="Web-{6A8078A2-13CA-018C-6D6B-BA50CC66E3DB}" dt="2023-04-13T01:55:51.393" v="16" actId="1076"/>
          <ac:spMkLst>
            <pc:docMk/>
            <pc:sldMk cId="109857222" sldId="256"/>
            <ac:spMk id="7" creationId="{43B4FB55-2C13-F8CC-3E5F-F9B56E8E5139}"/>
          </ac:spMkLst>
        </pc:spChg>
        <pc:spChg chg="add mod">
          <ac:chgData name="Jake Kendrick" userId="S::21308325@student.uwa.edu.au::ab142299-a4dd-4def-8b03-8ee3e1d9a7dd" providerId="AD" clId="Web-{6A8078A2-13CA-018C-6D6B-BA50CC66E3DB}" dt="2023-04-13T01:56:03.847" v="20" actId="20577"/>
          <ac:spMkLst>
            <pc:docMk/>
            <pc:sldMk cId="109857222" sldId="256"/>
            <ac:spMk id="8" creationId="{9CF02C2F-EEE6-2390-57E4-77D6A739D78E}"/>
          </ac:spMkLst>
        </pc:spChg>
        <pc:spChg chg="add mod">
          <ac:chgData name="Jake Kendrick" userId="S::21308325@student.uwa.edu.au::ab142299-a4dd-4def-8b03-8ee3e1d9a7dd" providerId="AD" clId="Web-{6A8078A2-13CA-018C-6D6B-BA50CC66E3DB}" dt="2023-04-13T01:56:15.925" v="24" actId="20577"/>
          <ac:spMkLst>
            <pc:docMk/>
            <pc:sldMk cId="109857222" sldId="256"/>
            <ac:spMk id="9" creationId="{B9E6849A-2317-E80F-4C77-DEA66A8FCE49}"/>
          </ac:spMkLst>
        </pc:spChg>
        <pc:picChg chg="mod">
          <ac:chgData name="Jake Kendrick" userId="S::21308325@student.uwa.edu.au::ab142299-a4dd-4def-8b03-8ee3e1d9a7dd" providerId="AD" clId="Web-{6A8078A2-13CA-018C-6D6B-BA50CC66E3DB}" dt="2023-04-13T01:55:23.658" v="3" actId="1076"/>
          <ac:picMkLst>
            <pc:docMk/>
            <pc:sldMk cId="109857222" sldId="256"/>
            <ac:picMk id="3" creationId="{D4FCBEE6-8C41-CF50-C664-5CE7048A8A46}"/>
          </ac:picMkLst>
        </pc:picChg>
        <pc:picChg chg="mod">
          <ac:chgData name="Jake Kendrick" userId="S::21308325@student.uwa.edu.au::ab142299-a4dd-4def-8b03-8ee3e1d9a7dd" providerId="AD" clId="Web-{6A8078A2-13CA-018C-6D6B-BA50CC66E3DB}" dt="2023-04-13T01:55:23.674" v="4" actId="1076"/>
          <ac:picMkLst>
            <pc:docMk/>
            <pc:sldMk cId="109857222" sldId="256"/>
            <ac:picMk id="4" creationId="{3778CDEF-44B7-F2C1-0189-6FCA3A94E4CF}"/>
          </ac:picMkLst>
        </pc:picChg>
        <pc:picChg chg="mod">
          <ac:chgData name="Jake Kendrick" userId="S::21308325@student.uwa.edu.au::ab142299-a4dd-4def-8b03-8ee3e1d9a7dd" providerId="AD" clId="Web-{6A8078A2-13CA-018C-6D6B-BA50CC66E3DB}" dt="2023-04-13T01:55:23.690" v="5" actId="1076"/>
          <ac:picMkLst>
            <pc:docMk/>
            <pc:sldMk cId="109857222" sldId="256"/>
            <ac:picMk id="5" creationId="{BBED81FA-1167-3EB8-F332-059E25B64E73}"/>
          </ac:picMkLst>
        </pc:picChg>
      </pc:sldChg>
    </pc:docChg>
  </pc:docChgLst>
  <pc:docChgLst>
    <pc:chgData name="Jake Kendrick" userId="ab142299-a4dd-4def-8b03-8ee3e1d9a7dd" providerId="ADAL" clId="{42FC2030-53C9-DA4C-90B7-101DEDB891D0}"/>
    <pc:docChg chg="custSel modSld">
      <pc:chgData name="Jake Kendrick" userId="ab142299-a4dd-4def-8b03-8ee3e1d9a7dd" providerId="ADAL" clId="{42FC2030-53C9-DA4C-90B7-101DEDB891D0}" dt="2023-09-28T12:01:01.250" v="60" actId="20577"/>
      <pc:docMkLst>
        <pc:docMk/>
      </pc:docMkLst>
      <pc:sldChg chg="delSp modSp mod">
        <pc:chgData name="Jake Kendrick" userId="ab142299-a4dd-4def-8b03-8ee3e1d9a7dd" providerId="ADAL" clId="{42FC2030-53C9-DA4C-90B7-101DEDB891D0}" dt="2023-09-28T12:01:01.250" v="60" actId="20577"/>
        <pc:sldMkLst>
          <pc:docMk/>
          <pc:sldMk cId="109857222" sldId="256"/>
        </pc:sldMkLst>
        <pc:spChg chg="mod">
          <ac:chgData name="Jake Kendrick" userId="ab142299-a4dd-4def-8b03-8ee3e1d9a7dd" providerId="ADAL" clId="{42FC2030-53C9-DA4C-90B7-101DEDB891D0}" dt="2023-09-28T12:01:01.250" v="60" actId="20577"/>
          <ac:spMkLst>
            <pc:docMk/>
            <pc:sldMk cId="109857222" sldId="256"/>
            <ac:spMk id="4" creationId="{B78966BB-B4FE-5DBC-C3FF-9E2ADA0C6ACF}"/>
          </ac:spMkLst>
        </pc:spChg>
        <pc:graphicFrameChg chg="modGraphic">
          <ac:chgData name="Jake Kendrick" userId="ab142299-a4dd-4def-8b03-8ee3e1d9a7dd" providerId="ADAL" clId="{42FC2030-53C9-DA4C-90B7-101DEDB891D0}" dt="2023-09-28T12:00:50.940" v="59" actId="20577"/>
          <ac:graphicFrameMkLst>
            <pc:docMk/>
            <pc:sldMk cId="109857222" sldId="256"/>
            <ac:graphicFrameMk id="7" creationId="{277382E6-C6E4-6D8E-B6CB-723A91E54FAC}"/>
          </ac:graphicFrameMkLst>
        </pc:graphicFrameChg>
        <pc:picChg chg="mod">
          <ac:chgData name="Jake Kendrick" userId="ab142299-a4dd-4def-8b03-8ee3e1d9a7dd" providerId="ADAL" clId="{42FC2030-53C9-DA4C-90B7-101DEDB891D0}" dt="2023-09-28T11:57:23.058" v="42" actId="1076"/>
          <ac:picMkLst>
            <pc:docMk/>
            <pc:sldMk cId="109857222" sldId="256"/>
            <ac:picMk id="3" creationId="{B7BCCCC1-74AC-0FF5-36CE-0181F35A3917}"/>
          </ac:picMkLst>
        </pc:picChg>
        <pc:picChg chg="del">
          <ac:chgData name="Jake Kendrick" userId="ab142299-a4dd-4def-8b03-8ee3e1d9a7dd" providerId="ADAL" clId="{42FC2030-53C9-DA4C-90B7-101DEDB891D0}" dt="2023-09-28T11:52:23.409" v="1" actId="478"/>
          <ac:picMkLst>
            <pc:docMk/>
            <pc:sldMk cId="109857222" sldId="256"/>
            <ac:picMk id="3" creationId="{CB735357-50D4-6C1E-45BF-2572C6DDDCBE}"/>
          </ac:picMkLst>
        </pc:picChg>
        <pc:picChg chg="del">
          <ac:chgData name="Jake Kendrick" userId="ab142299-a4dd-4def-8b03-8ee3e1d9a7dd" providerId="ADAL" clId="{42FC2030-53C9-DA4C-90B7-101DEDB891D0}" dt="2023-09-28T11:53:40.225" v="4" actId="478"/>
          <ac:picMkLst>
            <pc:docMk/>
            <pc:sldMk cId="109857222" sldId="256"/>
            <ac:picMk id="5" creationId="{06E7921B-76CC-085A-3D78-778AC1E318B7}"/>
          </ac:picMkLst>
        </pc:picChg>
        <pc:picChg chg="mod">
          <ac:chgData name="Jake Kendrick" userId="ab142299-a4dd-4def-8b03-8ee3e1d9a7dd" providerId="ADAL" clId="{42FC2030-53C9-DA4C-90B7-101DEDB891D0}" dt="2023-09-28T12:00:09.027" v="53" actId="1076"/>
          <ac:picMkLst>
            <pc:docMk/>
            <pc:sldMk cId="109857222" sldId="256"/>
            <ac:picMk id="5" creationId="{977180E6-C268-ABFB-2E4F-53D3AA20B421}"/>
          </ac:picMkLst>
        </pc:picChg>
        <pc:picChg chg="del">
          <ac:chgData name="Jake Kendrick" userId="ab142299-a4dd-4def-8b03-8ee3e1d9a7dd" providerId="ADAL" clId="{42FC2030-53C9-DA4C-90B7-101DEDB891D0}" dt="2023-09-28T11:57:15.607" v="41" actId="478"/>
          <ac:picMkLst>
            <pc:docMk/>
            <pc:sldMk cId="109857222" sldId="256"/>
            <ac:picMk id="6" creationId="{13B886A7-A12C-4FD2-154E-4B8C0F088E95}"/>
          </ac:picMkLst>
        </pc:picChg>
        <pc:picChg chg="del">
          <ac:chgData name="Jake Kendrick" userId="ab142299-a4dd-4def-8b03-8ee3e1d9a7dd" providerId="ADAL" clId="{42FC2030-53C9-DA4C-90B7-101DEDB891D0}" dt="2023-09-28T11:59:53.886" v="51" actId="478"/>
          <ac:picMkLst>
            <pc:docMk/>
            <pc:sldMk cId="109857222" sldId="256"/>
            <ac:picMk id="13" creationId="{06B8B814-FB8B-694A-0C1F-832A68674305}"/>
          </ac:picMkLst>
        </pc:picChg>
        <pc:picChg chg="mod">
          <ac:chgData name="Jake Kendrick" userId="ab142299-a4dd-4def-8b03-8ee3e1d9a7dd" providerId="ADAL" clId="{42FC2030-53C9-DA4C-90B7-101DEDB891D0}" dt="2023-09-28T11:52:37.660" v="3" actId="1076"/>
          <ac:picMkLst>
            <pc:docMk/>
            <pc:sldMk cId="109857222" sldId="256"/>
            <ac:picMk id="14" creationId="{BBE2731B-A5A1-7545-B9E3-B01B473E1634}"/>
          </ac:picMkLst>
        </pc:picChg>
        <pc:picChg chg="mod">
          <ac:chgData name="Jake Kendrick" userId="ab142299-a4dd-4def-8b03-8ee3e1d9a7dd" providerId="ADAL" clId="{42FC2030-53C9-DA4C-90B7-101DEDB891D0}" dt="2023-09-28T11:53:46.754" v="6" actId="1076"/>
          <ac:picMkLst>
            <pc:docMk/>
            <pc:sldMk cId="109857222" sldId="256"/>
            <ac:picMk id="16" creationId="{63EA3BCA-1D1C-EB6D-F52A-7EAC7F7D2AAC}"/>
          </ac:picMkLst>
        </pc:picChg>
      </pc:sldChg>
    </pc:docChg>
  </pc:docChgLst>
  <pc:docChgLst>
    <pc:chgData name="Jake Kendrick" userId="c9aa91da-2e15-46cf-a8c4-b4cee9b8e514" providerId="ADAL" clId="{4D39B9F2-2A26-5844-9159-FAC44B83CB06}"/>
    <pc:docChg chg="undo custSel modSld modMainMaster">
      <pc:chgData name="Jake Kendrick" userId="c9aa91da-2e15-46cf-a8c4-b4cee9b8e514" providerId="ADAL" clId="{4D39B9F2-2A26-5844-9159-FAC44B83CB06}" dt="2022-05-16T06:21:44.646" v="1059" actId="255"/>
      <pc:docMkLst>
        <pc:docMk/>
      </pc:docMkLst>
      <pc:sldChg chg="addSp delSp modSp mod">
        <pc:chgData name="Jake Kendrick" userId="c9aa91da-2e15-46cf-a8c4-b4cee9b8e514" providerId="ADAL" clId="{4D39B9F2-2A26-5844-9159-FAC44B83CB06}" dt="2022-05-16T06:21:44.646" v="1059" actId="255"/>
        <pc:sldMkLst>
          <pc:docMk/>
          <pc:sldMk cId="109857222" sldId="256"/>
        </pc:sldMkLst>
        <pc:spChg chg="del">
          <ac:chgData name="Jake Kendrick" userId="c9aa91da-2e15-46cf-a8c4-b4cee9b8e514" providerId="ADAL" clId="{4D39B9F2-2A26-5844-9159-FAC44B83CB06}" dt="2022-05-16T02:36:42.839" v="0" actId="478"/>
          <ac:spMkLst>
            <pc:docMk/>
            <pc:sldMk cId="109857222" sldId="256"/>
            <ac:spMk id="2" creationId="{00000000-0000-0000-0000-000000000000}"/>
          </ac:spMkLst>
        </pc:spChg>
        <pc:spChg chg="del">
          <ac:chgData name="Jake Kendrick" userId="c9aa91da-2e15-46cf-a8c4-b4cee9b8e514" providerId="ADAL" clId="{4D39B9F2-2A26-5844-9159-FAC44B83CB06}" dt="2022-05-16T02:36:44.015" v="1" actId="478"/>
          <ac:spMkLst>
            <pc:docMk/>
            <pc:sldMk cId="109857222" sldId="256"/>
            <ac:spMk id="3" creationId="{00000000-0000-0000-0000-000000000000}"/>
          </ac:spMkLst>
        </pc:spChg>
        <pc:spChg chg="add mod">
          <ac:chgData name="Jake Kendrick" userId="c9aa91da-2e15-46cf-a8c4-b4cee9b8e514" providerId="ADAL" clId="{4D39B9F2-2A26-5844-9159-FAC44B83CB06}" dt="2022-05-16T02:49:24.057" v="139" actId="1076"/>
          <ac:spMkLst>
            <pc:docMk/>
            <pc:sldMk cId="109857222" sldId="256"/>
            <ac:spMk id="10" creationId="{77A02ED0-8423-0C42-930A-6F5D1DA6A053}"/>
          </ac:spMkLst>
        </pc:spChg>
        <pc:spChg chg="add mod">
          <ac:chgData name="Jake Kendrick" userId="c9aa91da-2e15-46cf-a8c4-b4cee9b8e514" providerId="ADAL" clId="{4D39B9F2-2A26-5844-9159-FAC44B83CB06}" dt="2022-05-16T02:49:24.057" v="139" actId="1076"/>
          <ac:spMkLst>
            <pc:docMk/>
            <pc:sldMk cId="109857222" sldId="256"/>
            <ac:spMk id="11" creationId="{51C3C997-41C1-7247-BB0B-5044F4E47364}"/>
          </ac:spMkLst>
        </pc:spChg>
        <pc:spChg chg="add mod">
          <ac:chgData name="Jake Kendrick" userId="c9aa91da-2e15-46cf-a8c4-b4cee9b8e514" providerId="ADAL" clId="{4D39B9F2-2A26-5844-9159-FAC44B83CB06}" dt="2022-05-16T02:49:24.057" v="139" actId="1076"/>
          <ac:spMkLst>
            <pc:docMk/>
            <pc:sldMk cId="109857222" sldId="256"/>
            <ac:spMk id="12" creationId="{CBAAA63C-1BA9-DA4A-A878-9EC83D20AC07}"/>
          </ac:spMkLst>
        </pc:spChg>
        <pc:spChg chg="add mod">
          <ac:chgData name="Jake Kendrick" userId="c9aa91da-2e15-46cf-a8c4-b4cee9b8e514" providerId="ADAL" clId="{4D39B9F2-2A26-5844-9159-FAC44B83CB06}" dt="2022-05-16T06:21:44.646" v="1059" actId="255"/>
          <ac:spMkLst>
            <pc:docMk/>
            <pc:sldMk cId="109857222" sldId="256"/>
            <ac:spMk id="13" creationId="{A9A32FB2-2064-654E-9855-BDC1D5C342CA}"/>
          </ac:spMkLst>
        </pc:spChg>
        <pc:picChg chg="add mod modCrop">
          <ac:chgData name="Jake Kendrick" userId="c9aa91da-2e15-46cf-a8c4-b4cee9b8e514" providerId="ADAL" clId="{4D39B9F2-2A26-5844-9159-FAC44B83CB06}" dt="2022-05-16T02:48:12.368" v="79" actId="1076"/>
          <ac:picMkLst>
            <pc:docMk/>
            <pc:sldMk cId="109857222" sldId="256"/>
            <ac:picMk id="5" creationId="{D0D72CDC-DB73-4A46-BC72-65F82BD2E953}"/>
          </ac:picMkLst>
        </pc:picChg>
        <pc:picChg chg="add mod modCrop">
          <ac:chgData name="Jake Kendrick" userId="c9aa91da-2e15-46cf-a8c4-b4cee9b8e514" providerId="ADAL" clId="{4D39B9F2-2A26-5844-9159-FAC44B83CB06}" dt="2022-05-16T02:49:24.057" v="139" actId="1076"/>
          <ac:picMkLst>
            <pc:docMk/>
            <pc:sldMk cId="109857222" sldId="256"/>
            <ac:picMk id="7" creationId="{39AFEE4A-488A-8545-A74A-679028501F65}"/>
          </ac:picMkLst>
        </pc:picChg>
        <pc:picChg chg="add mod">
          <ac:chgData name="Jake Kendrick" userId="c9aa91da-2e15-46cf-a8c4-b4cee9b8e514" providerId="ADAL" clId="{4D39B9F2-2A26-5844-9159-FAC44B83CB06}" dt="2022-05-16T02:49:24.057" v="139" actId="1076"/>
          <ac:picMkLst>
            <pc:docMk/>
            <pc:sldMk cId="109857222" sldId="256"/>
            <ac:picMk id="9" creationId="{7534F080-3019-5945-A870-517575C07067}"/>
          </ac:picMkLst>
        </pc:picChg>
        <pc:cxnChg chg="add mod">
          <ac:chgData name="Jake Kendrick" userId="c9aa91da-2e15-46cf-a8c4-b4cee9b8e514" providerId="ADAL" clId="{4D39B9F2-2A26-5844-9159-FAC44B83CB06}" dt="2022-05-16T02:50:12.996" v="143" actId="1076"/>
          <ac:cxnSpMkLst>
            <pc:docMk/>
            <pc:sldMk cId="109857222" sldId="256"/>
            <ac:cxnSpMk id="15" creationId="{31A8256A-2223-0045-8866-AF2EE0DBAA26}"/>
          </ac:cxnSpMkLst>
        </pc:cxnChg>
      </pc:sldChg>
      <pc:sldMasterChg chg="modSp modSldLayout">
        <pc:chgData name="Jake Kendrick" userId="c9aa91da-2e15-46cf-a8c4-b4cee9b8e514" providerId="ADAL" clId="{4D39B9F2-2A26-5844-9159-FAC44B83CB06}" dt="2022-05-16T02:37:19.615" v="2"/>
        <pc:sldMasterMkLst>
          <pc:docMk/>
          <pc:sldMasterMk cId="2460954070" sldId="2147483660"/>
        </pc:sldMasterMkLst>
        <pc:spChg chg="mod">
          <ac:chgData name="Jake Kendrick" userId="c9aa91da-2e15-46cf-a8c4-b4cee9b8e514" providerId="ADAL" clId="{4D39B9F2-2A26-5844-9159-FAC44B83CB06}" dt="2022-05-16T02:37:19.615" v="2"/>
          <ac:spMkLst>
            <pc:docMk/>
            <pc:sldMasterMk cId="2460954070" sldId="2147483660"/>
            <ac:spMk id="2" creationId="{00000000-0000-0000-0000-000000000000}"/>
          </ac:spMkLst>
        </pc:spChg>
        <pc:spChg chg="mod">
          <ac:chgData name="Jake Kendrick" userId="c9aa91da-2e15-46cf-a8c4-b4cee9b8e514" providerId="ADAL" clId="{4D39B9F2-2A26-5844-9159-FAC44B83CB06}" dt="2022-05-16T02:37:19.615" v="2"/>
          <ac:spMkLst>
            <pc:docMk/>
            <pc:sldMasterMk cId="2460954070" sldId="2147483660"/>
            <ac:spMk id="3" creationId="{00000000-0000-0000-0000-000000000000}"/>
          </ac:spMkLst>
        </pc:spChg>
        <pc:spChg chg="mod">
          <ac:chgData name="Jake Kendrick" userId="c9aa91da-2e15-46cf-a8c4-b4cee9b8e514" providerId="ADAL" clId="{4D39B9F2-2A26-5844-9159-FAC44B83CB06}" dt="2022-05-16T02:37:19.615" v="2"/>
          <ac:spMkLst>
            <pc:docMk/>
            <pc:sldMasterMk cId="2460954070" sldId="2147483660"/>
            <ac:spMk id="4" creationId="{00000000-0000-0000-0000-000000000000}"/>
          </ac:spMkLst>
        </pc:spChg>
        <pc:spChg chg="mod">
          <ac:chgData name="Jake Kendrick" userId="c9aa91da-2e15-46cf-a8c4-b4cee9b8e514" providerId="ADAL" clId="{4D39B9F2-2A26-5844-9159-FAC44B83CB06}" dt="2022-05-16T02:37:19.615" v="2"/>
          <ac:spMkLst>
            <pc:docMk/>
            <pc:sldMasterMk cId="2460954070" sldId="2147483660"/>
            <ac:spMk id="5" creationId="{00000000-0000-0000-0000-000000000000}"/>
          </ac:spMkLst>
        </pc:spChg>
        <pc:spChg chg="mod">
          <ac:chgData name="Jake Kendrick" userId="c9aa91da-2e15-46cf-a8c4-b4cee9b8e514" providerId="ADAL" clId="{4D39B9F2-2A26-5844-9159-FAC44B83CB06}" dt="2022-05-16T02:37:19.615" v="2"/>
          <ac:spMkLst>
            <pc:docMk/>
            <pc:sldMasterMk cId="2460954070" sldId="2147483660"/>
            <ac:spMk id="6" creationId="{00000000-0000-0000-0000-000000000000}"/>
          </ac:spMkLst>
        </pc:spChg>
        <pc:sldLayoutChg chg="modSp">
          <pc:chgData name="Jake Kendrick" userId="c9aa91da-2e15-46cf-a8c4-b4cee9b8e514" providerId="ADAL" clId="{4D39B9F2-2A26-5844-9159-FAC44B83CB06}" dt="2022-05-16T02:37:19.615" v="2"/>
          <pc:sldLayoutMkLst>
            <pc:docMk/>
            <pc:sldMasterMk cId="2460954070" sldId="2147483660"/>
            <pc:sldLayoutMk cId="2385387890" sldId="2147483661"/>
          </pc:sldLayoutMkLst>
          <pc:spChg chg="mod">
            <ac:chgData name="Jake Kendrick" userId="c9aa91da-2e15-46cf-a8c4-b4cee9b8e514" providerId="ADAL" clId="{4D39B9F2-2A26-5844-9159-FAC44B83CB06}" dt="2022-05-16T02:37:19.615" v="2"/>
            <ac:spMkLst>
              <pc:docMk/>
              <pc:sldMasterMk cId="2460954070" sldId="2147483660"/>
              <pc:sldLayoutMk cId="2385387890" sldId="2147483661"/>
              <ac:spMk id="2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19.615" v="2"/>
            <ac:spMkLst>
              <pc:docMk/>
              <pc:sldMasterMk cId="2460954070" sldId="2147483660"/>
              <pc:sldLayoutMk cId="2385387890" sldId="2147483661"/>
              <ac:spMk id="3" creationId="{00000000-0000-0000-0000-000000000000}"/>
            </ac:spMkLst>
          </pc:spChg>
        </pc:sldLayoutChg>
        <pc:sldLayoutChg chg="modSp">
          <pc:chgData name="Jake Kendrick" userId="c9aa91da-2e15-46cf-a8c4-b4cee9b8e514" providerId="ADAL" clId="{4D39B9F2-2A26-5844-9159-FAC44B83CB06}" dt="2022-05-16T02:37:19.615" v="2"/>
          <pc:sldLayoutMkLst>
            <pc:docMk/>
            <pc:sldMasterMk cId="2460954070" sldId="2147483660"/>
            <pc:sldLayoutMk cId="2591524520" sldId="2147483663"/>
          </pc:sldLayoutMkLst>
          <pc:spChg chg="mod">
            <ac:chgData name="Jake Kendrick" userId="c9aa91da-2e15-46cf-a8c4-b4cee9b8e514" providerId="ADAL" clId="{4D39B9F2-2A26-5844-9159-FAC44B83CB06}" dt="2022-05-16T02:37:19.615" v="2"/>
            <ac:spMkLst>
              <pc:docMk/>
              <pc:sldMasterMk cId="2460954070" sldId="2147483660"/>
              <pc:sldLayoutMk cId="2591524520" sldId="2147483663"/>
              <ac:spMk id="2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19.615" v="2"/>
            <ac:spMkLst>
              <pc:docMk/>
              <pc:sldMasterMk cId="2460954070" sldId="2147483660"/>
              <pc:sldLayoutMk cId="2591524520" sldId="2147483663"/>
              <ac:spMk id="3" creationId="{00000000-0000-0000-0000-000000000000}"/>
            </ac:spMkLst>
          </pc:spChg>
        </pc:sldLayoutChg>
        <pc:sldLayoutChg chg="modSp">
          <pc:chgData name="Jake Kendrick" userId="c9aa91da-2e15-46cf-a8c4-b4cee9b8e514" providerId="ADAL" clId="{4D39B9F2-2A26-5844-9159-FAC44B83CB06}" dt="2022-05-16T02:37:19.615" v="2"/>
          <pc:sldLayoutMkLst>
            <pc:docMk/>
            <pc:sldMasterMk cId="2460954070" sldId="2147483660"/>
            <pc:sldLayoutMk cId="1203092039" sldId="2147483664"/>
          </pc:sldLayoutMkLst>
          <pc:spChg chg="mod">
            <ac:chgData name="Jake Kendrick" userId="c9aa91da-2e15-46cf-a8c4-b4cee9b8e514" providerId="ADAL" clId="{4D39B9F2-2A26-5844-9159-FAC44B83CB06}" dt="2022-05-16T02:37:19.615" v="2"/>
            <ac:spMkLst>
              <pc:docMk/>
              <pc:sldMasterMk cId="2460954070" sldId="2147483660"/>
              <pc:sldLayoutMk cId="1203092039" sldId="2147483664"/>
              <ac:spMk id="3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19.615" v="2"/>
            <ac:spMkLst>
              <pc:docMk/>
              <pc:sldMasterMk cId="2460954070" sldId="2147483660"/>
              <pc:sldLayoutMk cId="1203092039" sldId="2147483664"/>
              <ac:spMk id="4" creationId="{00000000-0000-0000-0000-000000000000}"/>
            </ac:spMkLst>
          </pc:spChg>
        </pc:sldLayoutChg>
        <pc:sldLayoutChg chg="modSp">
          <pc:chgData name="Jake Kendrick" userId="c9aa91da-2e15-46cf-a8c4-b4cee9b8e514" providerId="ADAL" clId="{4D39B9F2-2A26-5844-9159-FAC44B83CB06}" dt="2022-05-16T02:37:19.615" v="2"/>
          <pc:sldLayoutMkLst>
            <pc:docMk/>
            <pc:sldMasterMk cId="2460954070" sldId="2147483660"/>
            <pc:sldLayoutMk cId="3733172339" sldId="2147483665"/>
          </pc:sldLayoutMkLst>
          <pc:spChg chg="mod">
            <ac:chgData name="Jake Kendrick" userId="c9aa91da-2e15-46cf-a8c4-b4cee9b8e514" providerId="ADAL" clId="{4D39B9F2-2A26-5844-9159-FAC44B83CB06}" dt="2022-05-16T02:37:19.615" v="2"/>
            <ac:spMkLst>
              <pc:docMk/>
              <pc:sldMasterMk cId="2460954070" sldId="2147483660"/>
              <pc:sldLayoutMk cId="3733172339" sldId="2147483665"/>
              <ac:spMk id="2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19.615" v="2"/>
            <ac:spMkLst>
              <pc:docMk/>
              <pc:sldMasterMk cId="2460954070" sldId="2147483660"/>
              <pc:sldLayoutMk cId="3733172339" sldId="2147483665"/>
              <ac:spMk id="3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19.615" v="2"/>
            <ac:spMkLst>
              <pc:docMk/>
              <pc:sldMasterMk cId="2460954070" sldId="2147483660"/>
              <pc:sldLayoutMk cId="3733172339" sldId="2147483665"/>
              <ac:spMk id="4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19.615" v="2"/>
            <ac:spMkLst>
              <pc:docMk/>
              <pc:sldMasterMk cId="2460954070" sldId="2147483660"/>
              <pc:sldLayoutMk cId="3733172339" sldId="2147483665"/>
              <ac:spMk id="5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19.615" v="2"/>
            <ac:spMkLst>
              <pc:docMk/>
              <pc:sldMasterMk cId="2460954070" sldId="2147483660"/>
              <pc:sldLayoutMk cId="3733172339" sldId="2147483665"/>
              <ac:spMk id="6" creationId="{00000000-0000-0000-0000-000000000000}"/>
            </ac:spMkLst>
          </pc:spChg>
        </pc:sldLayoutChg>
        <pc:sldLayoutChg chg="modSp">
          <pc:chgData name="Jake Kendrick" userId="c9aa91da-2e15-46cf-a8c4-b4cee9b8e514" providerId="ADAL" clId="{4D39B9F2-2A26-5844-9159-FAC44B83CB06}" dt="2022-05-16T02:37:19.615" v="2"/>
          <pc:sldLayoutMkLst>
            <pc:docMk/>
            <pc:sldMasterMk cId="2460954070" sldId="2147483660"/>
            <pc:sldLayoutMk cId="3171841454" sldId="2147483668"/>
          </pc:sldLayoutMkLst>
          <pc:spChg chg="mod">
            <ac:chgData name="Jake Kendrick" userId="c9aa91da-2e15-46cf-a8c4-b4cee9b8e514" providerId="ADAL" clId="{4D39B9F2-2A26-5844-9159-FAC44B83CB06}" dt="2022-05-16T02:37:19.615" v="2"/>
            <ac:spMkLst>
              <pc:docMk/>
              <pc:sldMasterMk cId="2460954070" sldId="2147483660"/>
              <pc:sldLayoutMk cId="3171841454" sldId="2147483668"/>
              <ac:spMk id="2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19.615" v="2"/>
            <ac:spMkLst>
              <pc:docMk/>
              <pc:sldMasterMk cId="2460954070" sldId="2147483660"/>
              <pc:sldLayoutMk cId="3171841454" sldId="2147483668"/>
              <ac:spMk id="3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19.615" v="2"/>
            <ac:spMkLst>
              <pc:docMk/>
              <pc:sldMasterMk cId="2460954070" sldId="2147483660"/>
              <pc:sldLayoutMk cId="3171841454" sldId="2147483668"/>
              <ac:spMk id="4" creationId="{00000000-0000-0000-0000-000000000000}"/>
            </ac:spMkLst>
          </pc:spChg>
        </pc:sldLayoutChg>
        <pc:sldLayoutChg chg="modSp">
          <pc:chgData name="Jake Kendrick" userId="c9aa91da-2e15-46cf-a8c4-b4cee9b8e514" providerId="ADAL" clId="{4D39B9F2-2A26-5844-9159-FAC44B83CB06}" dt="2022-05-16T02:37:19.615" v="2"/>
          <pc:sldLayoutMkLst>
            <pc:docMk/>
            <pc:sldMasterMk cId="2460954070" sldId="2147483660"/>
            <pc:sldLayoutMk cId="1718958274" sldId="2147483669"/>
          </pc:sldLayoutMkLst>
          <pc:spChg chg="mod">
            <ac:chgData name="Jake Kendrick" userId="c9aa91da-2e15-46cf-a8c4-b4cee9b8e514" providerId="ADAL" clId="{4D39B9F2-2A26-5844-9159-FAC44B83CB06}" dt="2022-05-16T02:37:19.615" v="2"/>
            <ac:spMkLst>
              <pc:docMk/>
              <pc:sldMasterMk cId="2460954070" sldId="2147483660"/>
              <pc:sldLayoutMk cId="1718958274" sldId="2147483669"/>
              <ac:spMk id="2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19.615" v="2"/>
            <ac:spMkLst>
              <pc:docMk/>
              <pc:sldMasterMk cId="2460954070" sldId="2147483660"/>
              <pc:sldLayoutMk cId="1718958274" sldId="2147483669"/>
              <ac:spMk id="3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19.615" v="2"/>
            <ac:spMkLst>
              <pc:docMk/>
              <pc:sldMasterMk cId="2460954070" sldId="2147483660"/>
              <pc:sldLayoutMk cId="1718958274" sldId="2147483669"/>
              <ac:spMk id="4" creationId="{00000000-0000-0000-0000-000000000000}"/>
            </ac:spMkLst>
          </pc:spChg>
        </pc:sldLayoutChg>
        <pc:sldLayoutChg chg="modSp">
          <pc:chgData name="Jake Kendrick" userId="c9aa91da-2e15-46cf-a8c4-b4cee9b8e514" providerId="ADAL" clId="{4D39B9F2-2A26-5844-9159-FAC44B83CB06}" dt="2022-05-16T02:37:19.615" v="2"/>
          <pc:sldLayoutMkLst>
            <pc:docMk/>
            <pc:sldMasterMk cId="2460954070" sldId="2147483660"/>
            <pc:sldLayoutMk cId="3479445657" sldId="2147483671"/>
          </pc:sldLayoutMkLst>
          <pc:spChg chg="mod">
            <ac:chgData name="Jake Kendrick" userId="c9aa91da-2e15-46cf-a8c4-b4cee9b8e514" providerId="ADAL" clId="{4D39B9F2-2A26-5844-9159-FAC44B83CB06}" dt="2022-05-16T02:37:19.615" v="2"/>
            <ac:spMkLst>
              <pc:docMk/>
              <pc:sldMasterMk cId="2460954070" sldId="2147483660"/>
              <pc:sldLayoutMk cId="3479445657" sldId="2147483671"/>
              <ac:spMk id="2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19.615" v="2"/>
            <ac:spMkLst>
              <pc:docMk/>
              <pc:sldMasterMk cId="2460954070" sldId="2147483660"/>
              <pc:sldLayoutMk cId="3479445657" sldId="2147483671"/>
              <ac:spMk id="3" creationId="{00000000-0000-0000-0000-000000000000}"/>
            </ac:spMkLst>
          </pc:spChg>
        </pc:sldLayoutChg>
      </pc:sldMasterChg>
      <pc:sldMasterChg chg="modSp modSldLayout">
        <pc:chgData name="Jake Kendrick" userId="c9aa91da-2e15-46cf-a8c4-b4cee9b8e514" providerId="ADAL" clId="{4D39B9F2-2A26-5844-9159-FAC44B83CB06}" dt="2022-05-16T02:37:31.962" v="3"/>
        <pc:sldMasterMkLst>
          <pc:docMk/>
          <pc:sldMasterMk cId="1448422383" sldId="2147483672"/>
        </pc:sldMasterMkLst>
        <pc:spChg chg="mod">
          <ac:chgData name="Jake Kendrick" userId="c9aa91da-2e15-46cf-a8c4-b4cee9b8e514" providerId="ADAL" clId="{4D39B9F2-2A26-5844-9159-FAC44B83CB06}" dt="2022-05-16T02:37:31.962" v="3"/>
          <ac:spMkLst>
            <pc:docMk/>
            <pc:sldMasterMk cId="1448422383" sldId="2147483672"/>
            <ac:spMk id="2" creationId="{00000000-0000-0000-0000-000000000000}"/>
          </ac:spMkLst>
        </pc:spChg>
        <pc:spChg chg="mod">
          <ac:chgData name="Jake Kendrick" userId="c9aa91da-2e15-46cf-a8c4-b4cee9b8e514" providerId="ADAL" clId="{4D39B9F2-2A26-5844-9159-FAC44B83CB06}" dt="2022-05-16T02:37:31.962" v="3"/>
          <ac:spMkLst>
            <pc:docMk/>
            <pc:sldMasterMk cId="1448422383" sldId="2147483672"/>
            <ac:spMk id="3" creationId="{00000000-0000-0000-0000-000000000000}"/>
          </ac:spMkLst>
        </pc:spChg>
        <pc:spChg chg="mod">
          <ac:chgData name="Jake Kendrick" userId="c9aa91da-2e15-46cf-a8c4-b4cee9b8e514" providerId="ADAL" clId="{4D39B9F2-2A26-5844-9159-FAC44B83CB06}" dt="2022-05-16T02:37:31.962" v="3"/>
          <ac:spMkLst>
            <pc:docMk/>
            <pc:sldMasterMk cId="1448422383" sldId="2147483672"/>
            <ac:spMk id="4" creationId="{00000000-0000-0000-0000-000000000000}"/>
          </ac:spMkLst>
        </pc:spChg>
        <pc:spChg chg="mod">
          <ac:chgData name="Jake Kendrick" userId="c9aa91da-2e15-46cf-a8c4-b4cee9b8e514" providerId="ADAL" clId="{4D39B9F2-2A26-5844-9159-FAC44B83CB06}" dt="2022-05-16T02:37:31.962" v="3"/>
          <ac:spMkLst>
            <pc:docMk/>
            <pc:sldMasterMk cId="1448422383" sldId="2147483672"/>
            <ac:spMk id="5" creationId="{00000000-0000-0000-0000-000000000000}"/>
          </ac:spMkLst>
        </pc:spChg>
        <pc:spChg chg="mod">
          <ac:chgData name="Jake Kendrick" userId="c9aa91da-2e15-46cf-a8c4-b4cee9b8e514" providerId="ADAL" clId="{4D39B9F2-2A26-5844-9159-FAC44B83CB06}" dt="2022-05-16T02:37:31.962" v="3"/>
          <ac:spMkLst>
            <pc:docMk/>
            <pc:sldMasterMk cId="1448422383" sldId="2147483672"/>
            <ac:spMk id="6" creationId="{00000000-0000-0000-0000-000000000000}"/>
          </ac:spMkLst>
        </pc:spChg>
        <pc:sldLayoutChg chg="modSp">
          <pc:chgData name="Jake Kendrick" userId="c9aa91da-2e15-46cf-a8c4-b4cee9b8e514" providerId="ADAL" clId="{4D39B9F2-2A26-5844-9159-FAC44B83CB06}" dt="2022-05-16T02:37:31.962" v="3"/>
          <pc:sldLayoutMkLst>
            <pc:docMk/>
            <pc:sldMasterMk cId="1448422383" sldId="2147483672"/>
            <pc:sldLayoutMk cId="2719679625" sldId="2147483673"/>
          </pc:sldLayoutMkLst>
          <pc:spChg chg="mod">
            <ac:chgData name="Jake Kendrick" userId="c9aa91da-2e15-46cf-a8c4-b4cee9b8e514" providerId="ADAL" clId="{4D39B9F2-2A26-5844-9159-FAC44B83CB06}" dt="2022-05-16T02:37:31.962" v="3"/>
            <ac:spMkLst>
              <pc:docMk/>
              <pc:sldMasterMk cId="1448422383" sldId="2147483672"/>
              <pc:sldLayoutMk cId="2719679625" sldId="2147483673"/>
              <ac:spMk id="2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31.962" v="3"/>
            <ac:spMkLst>
              <pc:docMk/>
              <pc:sldMasterMk cId="1448422383" sldId="2147483672"/>
              <pc:sldLayoutMk cId="2719679625" sldId="2147483673"/>
              <ac:spMk id="3" creationId="{00000000-0000-0000-0000-000000000000}"/>
            </ac:spMkLst>
          </pc:spChg>
        </pc:sldLayoutChg>
        <pc:sldLayoutChg chg="modSp">
          <pc:chgData name="Jake Kendrick" userId="c9aa91da-2e15-46cf-a8c4-b4cee9b8e514" providerId="ADAL" clId="{4D39B9F2-2A26-5844-9159-FAC44B83CB06}" dt="2022-05-16T02:37:31.962" v="3"/>
          <pc:sldLayoutMkLst>
            <pc:docMk/>
            <pc:sldMasterMk cId="1448422383" sldId="2147483672"/>
            <pc:sldLayoutMk cId="2619595333" sldId="2147483675"/>
          </pc:sldLayoutMkLst>
          <pc:spChg chg="mod">
            <ac:chgData name="Jake Kendrick" userId="c9aa91da-2e15-46cf-a8c4-b4cee9b8e514" providerId="ADAL" clId="{4D39B9F2-2A26-5844-9159-FAC44B83CB06}" dt="2022-05-16T02:37:31.962" v="3"/>
            <ac:spMkLst>
              <pc:docMk/>
              <pc:sldMasterMk cId="1448422383" sldId="2147483672"/>
              <pc:sldLayoutMk cId="2619595333" sldId="2147483675"/>
              <ac:spMk id="2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31.962" v="3"/>
            <ac:spMkLst>
              <pc:docMk/>
              <pc:sldMasterMk cId="1448422383" sldId="2147483672"/>
              <pc:sldLayoutMk cId="2619595333" sldId="2147483675"/>
              <ac:spMk id="3" creationId="{00000000-0000-0000-0000-000000000000}"/>
            </ac:spMkLst>
          </pc:spChg>
        </pc:sldLayoutChg>
        <pc:sldLayoutChg chg="modSp">
          <pc:chgData name="Jake Kendrick" userId="c9aa91da-2e15-46cf-a8c4-b4cee9b8e514" providerId="ADAL" clId="{4D39B9F2-2A26-5844-9159-FAC44B83CB06}" dt="2022-05-16T02:37:31.962" v="3"/>
          <pc:sldLayoutMkLst>
            <pc:docMk/>
            <pc:sldMasterMk cId="1448422383" sldId="2147483672"/>
            <pc:sldLayoutMk cId="7411637" sldId="2147483676"/>
          </pc:sldLayoutMkLst>
          <pc:spChg chg="mod">
            <ac:chgData name="Jake Kendrick" userId="c9aa91da-2e15-46cf-a8c4-b4cee9b8e514" providerId="ADAL" clId="{4D39B9F2-2A26-5844-9159-FAC44B83CB06}" dt="2022-05-16T02:37:31.962" v="3"/>
            <ac:spMkLst>
              <pc:docMk/>
              <pc:sldMasterMk cId="1448422383" sldId="2147483672"/>
              <pc:sldLayoutMk cId="7411637" sldId="2147483676"/>
              <ac:spMk id="3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31.962" v="3"/>
            <ac:spMkLst>
              <pc:docMk/>
              <pc:sldMasterMk cId="1448422383" sldId="2147483672"/>
              <pc:sldLayoutMk cId="7411637" sldId="2147483676"/>
              <ac:spMk id="4" creationId="{00000000-0000-0000-0000-000000000000}"/>
            </ac:spMkLst>
          </pc:spChg>
        </pc:sldLayoutChg>
        <pc:sldLayoutChg chg="modSp">
          <pc:chgData name="Jake Kendrick" userId="c9aa91da-2e15-46cf-a8c4-b4cee9b8e514" providerId="ADAL" clId="{4D39B9F2-2A26-5844-9159-FAC44B83CB06}" dt="2022-05-16T02:37:31.962" v="3"/>
          <pc:sldLayoutMkLst>
            <pc:docMk/>
            <pc:sldMasterMk cId="1448422383" sldId="2147483672"/>
            <pc:sldLayoutMk cId="236591791" sldId="2147483677"/>
          </pc:sldLayoutMkLst>
          <pc:spChg chg="mod">
            <ac:chgData name="Jake Kendrick" userId="c9aa91da-2e15-46cf-a8c4-b4cee9b8e514" providerId="ADAL" clId="{4D39B9F2-2A26-5844-9159-FAC44B83CB06}" dt="2022-05-16T02:37:31.962" v="3"/>
            <ac:spMkLst>
              <pc:docMk/>
              <pc:sldMasterMk cId="1448422383" sldId="2147483672"/>
              <pc:sldLayoutMk cId="236591791" sldId="2147483677"/>
              <ac:spMk id="2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31.962" v="3"/>
            <ac:spMkLst>
              <pc:docMk/>
              <pc:sldMasterMk cId="1448422383" sldId="2147483672"/>
              <pc:sldLayoutMk cId="236591791" sldId="2147483677"/>
              <ac:spMk id="3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31.962" v="3"/>
            <ac:spMkLst>
              <pc:docMk/>
              <pc:sldMasterMk cId="1448422383" sldId="2147483672"/>
              <pc:sldLayoutMk cId="236591791" sldId="2147483677"/>
              <ac:spMk id="4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31.962" v="3"/>
            <ac:spMkLst>
              <pc:docMk/>
              <pc:sldMasterMk cId="1448422383" sldId="2147483672"/>
              <pc:sldLayoutMk cId="236591791" sldId="2147483677"/>
              <ac:spMk id="5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31.962" v="3"/>
            <ac:spMkLst>
              <pc:docMk/>
              <pc:sldMasterMk cId="1448422383" sldId="2147483672"/>
              <pc:sldLayoutMk cId="236591791" sldId="2147483677"/>
              <ac:spMk id="6" creationId="{00000000-0000-0000-0000-000000000000}"/>
            </ac:spMkLst>
          </pc:spChg>
        </pc:sldLayoutChg>
        <pc:sldLayoutChg chg="modSp">
          <pc:chgData name="Jake Kendrick" userId="c9aa91da-2e15-46cf-a8c4-b4cee9b8e514" providerId="ADAL" clId="{4D39B9F2-2A26-5844-9159-FAC44B83CB06}" dt="2022-05-16T02:37:31.962" v="3"/>
          <pc:sldLayoutMkLst>
            <pc:docMk/>
            <pc:sldMasterMk cId="1448422383" sldId="2147483672"/>
            <pc:sldLayoutMk cId="936506105" sldId="2147483680"/>
          </pc:sldLayoutMkLst>
          <pc:spChg chg="mod">
            <ac:chgData name="Jake Kendrick" userId="c9aa91da-2e15-46cf-a8c4-b4cee9b8e514" providerId="ADAL" clId="{4D39B9F2-2A26-5844-9159-FAC44B83CB06}" dt="2022-05-16T02:37:31.962" v="3"/>
            <ac:spMkLst>
              <pc:docMk/>
              <pc:sldMasterMk cId="1448422383" sldId="2147483672"/>
              <pc:sldLayoutMk cId="936506105" sldId="2147483680"/>
              <ac:spMk id="2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31.962" v="3"/>
            <ac:spMkLst>
              <pc:docMk/>
              <pc:sldMasterMk cId="1448422383" sldId="2147483672"/>
              <pc:sldLayoutMk cId="936506105" sldId="2147483680"/>
              <ac:spMk id="3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31.962" v="3"/>
            <ac:spMkLst>
              <pc:docMk/>
              <pc:sldMasterMk cId="1448422383" sldId="2147483672"/>
              <pc:sldLayoutMk cId="936506105" sldId="2147483680"/>
              <ac:spMk id="4" creationId="{00000000-0000-0000-0000-000000000000}"/>
            </ac:spMkLst>
          </pc:spChg>
        </pc:sldLayoutChg>
        <pc:sldLayoutChg chg="modSp">
          <pc:chgData name="Jake Kendrick" userId="c9aa91da-2e15-46cf-a8c4-b4cee9b8e514" providerId="ADAL" clId="{4D39B9F2-2A26-5844-9159-FAC44B83CB06}" dt="2022-05-16T02:37:31.962" v="3"/>
          <pc:sldLayoutMkLst>
            <pc:docMk/>
            <pc:sldMasterMk cId="1448422383" sldId="2147483672"/>
            <pc:sldLayoutMk cId="3131925715" sldId="2147483681"/>
          </pc:sldLayoutMkLst>
          <pc:spChg chg="mod">
            <ac:chgData name="Jake Kendrick" userId="c9aa91da-2e15-46cf-a8c4-b4cee9b8e514" providerId="ADAL" clId="{4D39B9F2-2A26-5844-9159-FAC44B83CB06}" dt="2022-05-16T02:37:31.962" v="3"/>
            <ac:spMkLst>
              <pc:docMk/>
              <pc:sldMasterMk cId="1448422383" sldId="2147483672"/>
              <pc:sldLayoutMk cId="3131925715" sldId="2147483681"/>
              <ac:spMk id="2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31.962" v="3"/>
            <ac:spMkLst>
              <pc:docMk/>
              <pc:sldMasterMk cId="1448422383" sldId="2147483672"/>
              <pc:sldLayoutMk cId="3131925715" sldId="2147483681"/>
              <ac:spMk id="3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31.962" v="3"/>
            <ac:spMkLst>
              <pc:docMk/>
              <pc:sldMasterMk cId="1448422383" sldId="2147483672"/>
              <pc:sldLayoutMk cId="3131925715" sldId="2147483681"/>
              <ac:spMk id="4" creationId="{00000000-0000-0000-0000-000000000000}"/>
            </ac:spMkLst>
          </pc:spChg>
        </pc:sldLayoutChg>
        <pc:sldLayoutChg chg="modSp">
          <pc:chgData name="Jake Kendrick" userId="c9aa91da-2e15-46cf-a8c4-b4cee9b8e514" providerId="ADAL" clId="{4D39B9F2-2A26-5844-9159-FAC44B83CB06}" dt="2022-05-16T02:37:31.962" v="3"/>
          <pc:sldLayoutMkLst>
            <pc:docMk/>
            <pc:sldMasterMk cId="1448422383" sldId="2147483672"/>
            <pc:sldLayoutMk cId="867567097" sldId="2147483683"/>
          </pc:sldLayoutMkLst>
          <pc:spChg chg="mod">
            <ac:chgData name="Jake Kendrick" userId="c9aa91da-2e15-46cf-a8c4-b4cee9b8e514" providerId="ADAL" clId="{4D39B9F2-2A26-5844-9159-FAC44B83CB06}" dt="2022-05-16T02:37:31.962" v="3"/>
            <ac:spMkLst>
              <pc:docMk/>
              <pc:sldMasterMk cId="1448422383" sldId="2147483672"/>
              <pc:sldLayoutMk cId="867567097" sldId="2147483683"/>
              <ac:spMk id="2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7:31.962" v="3"/>
            <ac:spMkLst>
              <pc:docMk/>
              <pc:sldMasterMk cId="1448422383" sldId="2147483672"/>
              <pc:sldLayoutMk cId="867567097" sldId="2147483683"/>
              <ac:spMk id="3" creationId="{00000000-0000-0000-0000-000000000000}"/>
            </ac:spMkLst>
          </pc:spChg>
        </pc:sldLayoutChg>
      </pc:sldMasterChg>
      <pc:sldMasterChg chg="modSp modSldLayout">
        <pc:chgData name="Jake Kendrick" userId="c9aa91da-2e15-46cf-a8c4-b4cee9b8e514" providerId="ADAL" clId="{4D39B9F2-2A26-5844-9159-FAC44B83CB06}" dt="2022-05-16T02:38:17.140" v="4"/>
        <pc:sldMasterMkLst>
          <pc:docMk/>
          <pc:sldMasterMk cId="2382013965" sldId="2147483684"/>
        </pc:sldMasterMkLst>
        <pc:spChg chg="mod">
          <ac:chgData name="Jake Kendrick" userId="c9aa91da-2e15-46cf-a8c4-b4cee9b8e514" providerId="ADAL" clId="{4D39B9F2-2A26-5844-9159-FAC44B83CB06}" dt="2022-05-16T02:38:17.140" v="4"/>
          <ac:spMkLst>
            <pc:docMk/>
            <pc:sldMasterMk cId="2382013965" sldId="2147483684"/>
            <ac:spMk id="2" creationId="{00000000-0000-0000-0000-000000000000}"/>
          </ac:spMkLst>
        </pc:spChg>
        <pc:spChg chg="mod">
          <ac:chgData name="Jake Kendrick" userId="c9aa91da-2e15-46cf-a8c4-b4cee9b8e514" providerId="ADAL" clId="{4D39B9F2-2A26-5844-9159-FAC44B83CB06}" dt="2022-05-16T02:38:17.140" v="4"/>
          <ac:spMkLst>
            <pc:docMk/>
            <pc:sldMasterMk cId="2382013965" sldId="2147483684"/>
            <ac:spMk id="3" creationId="{00000000-0000-0000-0000-000000000000}"/>
          </ac:spMkLst>
        </pc:spChg>
        <pc:spChg chg="mod">
          <ac:chgData name="Jake Kendrick" userId="c9aa91da-2e15-46cf-a8c4-b4cee9b8e514" providerId="ADAL" clId="{4D39B9F2-2A26-5844-9159-FAC44B83CB06}" dt="2022-05-16T02:38:17.140" v="4"/>
          <ac:spMkLst>
            <pc:docMk/>
            <pc:sldMasterMk cId="2382013965" sldId="2147483684"/>
            <ac:spMk id="4" creationId="{00000000-0000-0000-0000-000000000000}"/>
          </ac:spMkLst>
        </pc:spChg>
        <pc:spChg chg="mod">
          <ac:chgData name="Jake Kendrick" userId="c9aa91da-2e15-46cf-a8c4-b4cee9b8e514" providerId="ADAL" clId="{4D39B9F2-2A26-5844-9159-FAC44B83CB06}" dt="2022-05-16T02:38:17.140" v="4"/>
          <ac:spMkLst>
            <pc:docMk/>
            <pc:sldMasterMk cId="2382013965" sldId="2147483684"/>
            <ac:spMk id="5" creationId="{00000000-0000-0000-0000-000000000000}"/>
          </ac:spMkLst>
        </pc:spChg>
        <pc:spChg chg="mod">
          <ac:chgData name="Jake Kendrick" userId="c9aa91da-2e15-46cf-a8c4-b4cee9b8e514" providerId="ADAL" clId="{4D39B9F2-2A26-5844-9159-FAC44B83CB06}" dt="2022-05-16T02:38:17.140" v="4"/>
          <ac:spMkLst>
            <pc:docMk/>
            <pc:sldMasterMk cId="2382013965" sldId="2147483684"/>
            <ac:spMk id="6" creationId="{00000000-0000-0000-0000-000000000000}"/>
          </ac:spMkLst>
        </pc:spChg>
        <pc:sldLayoutChg chg="modSp">
          <pc:chgData name="Jake Kendrick" userId="c9aa91da-2e15-46cf-a8c4-b4cee9b8e514" providerId="ADAL" clId="{4D39B9F2-2A26-5844-9159-FAC44B83CB06}" dt="2022-05-16T02:38:17.140" v="4"/>
          <pc:sldLayoutMkLst>
            <pc:docMk/>
            <pc:sldMasterMk cId="2382013965" sldId="2147483684"/>
            <pc:sldLayoutMk cId="996975112" sldId="2147483685"/>
          </pc:sldLayoutMkLst>
          <pc:spChg chg="mod">
            <ac:chgData name="Jake Kendrick" userId="c9aa91da-2e15-46cf-a8c4-b4cee9b8e514" providerId="ADAL" clId="{4D39B9F2-2A26-5844-9159-FAC44B83CB06}" dt="2022-05-16T02:38:17.140" v="4"/>
            <ac:spMkLst>
              <pc:docMk/>
              <pc:sldMasterMk cId="2382013965" sldId="2147483684"/>
              <pc:sldLayoutMk cId="996975112" sldId="2147483685"/>
              <ac:spMk id="2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8:17.140" v="4"/>
            <ac:spMkLst>
              <pc:docMk/>
              <pc:sldMasterMk cId="2382013965" sldId="2147483684"/>
              <pc:sldLayoutMk cId="996975112" sldId="2147483685"/>
              <ac:spMk id="3" creationId="{00000000-0000-0000-0000-000000000000}"/>
            </ac:spMkLst>
          </pc:spChg>
        </pc:sldLayoutChg>
        <pc:sldLayoutChg chg="modSp">
          <pc:chgData name="Jake Kendrick" userId="c9aa91da-2e15-46cf-a8c4-b4cee9b8e514" providerId="ADAL" clId="{4D39B9F2-2A26-5844-9159-FAC44B83CB06}" dt="2022-05-16T02:38:17.140" v="4"/>
          <pc:sldLayoutMkLst>
            <pc:docMk/>
            <pc:sldMasterMk cId="2382013965" sldId="2147483684"/>
            <pc:sldLayoutMk cId="2857899147" sldId="2147483687"/>
          </pc:sldLayoutMkLst>
          <pc:spChg chg="mod">
            <ac:chgData name="Jake Kendrick" userId="c9aa91da-2e15-46cf-a8c4-b4cee9b8e514" providerId="ADAL" clId="{4D39B9F2-2A26-5844-9159-FAC44B83CB06}" dt="2022-05-16T02:38:17.140" v="4"/>
            <ac:spMkLst>
              <pc:docMk/>
              <pc:sldMasterMk cId="2382013965" sldId="2147483684"/>
              <pc:sldLayoutMk cId="2857899147" sldId="2147483687"/>
              <ac:spMk id="2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8:17.140" v="4"/>
            <ac:spMkLst>
              <pc:docMk/>
              <pc:sldMasterMk cId="2382013965" sldId="2147483684"/>
              <pc:sldLayoutMk cId="2857899147" sldId="2147483687"/>
              <ac:spMk id="3" creationId="{00000000-0000-0000-0000-000000000000}"/>
            </ac:spMkLst>
          </pc:spChg>
        </pc:sldLayoutChg>
        <pc:sldLayoutChg chg="modSp">
          <pc:chgData name="Jake Kendrick" userId="c9aa91da-2e15-46cf-a8c4-b4cee9b8e514" providerId="ADAL" clId="{4D39B9F2-2A26-5844-9159-FAC44B83CB06}" dt="2022-05-16T02:38:17.140" v="4"/>
          <pc:sldLayoutMkLst>
            <pc:docMk/>
            <pc:sldMasterMk cId="2382013965" sldId="2147483684"/>
            <pc:sldLayoutMk cId="79401963" sldId="2147483688"/>
          </pc:sldLayoutMkLst>
          <pc:spChg chg="mod">
            <ac:chgData name="Jake Kendrick" userId="c9aa91da-2e15-46cf-a8c4-b4cee9b8e514" providerId="ADAL" clId="{4D39B9F2-2A26-5844-9159-FAC44B83CB06}" dt="2022-05-16T02:38:17.140" v="4"/>
            <ac:spMkLst>
              <pc:docMk/>
              <pc:sldMasterMk cId="2382013965" sldId="2147483684"/>
              <pc:sldLayoutMk cId="79401963" sldId="2147483688"/>
              <ac:spMk id="3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8:17.140" v="4"/>
            <ac:spMkLst>
              <pc:docMk/>
              <pc:sldMasterMk cId="2382013965" sldId="2147483684"/>
              <pc:sldLayoutMk cId="79401963" sldId="2147483688"/>
              <ac:spMk id="4" creationId="{00000000-0000-0000-0000-000000000000}"/>
            </ac:spMkLst>
          </pc:spChg>
        </pc:sldLayoutChg>
        <pc:sldLayoutChg chg="modSp">
          <pc:chgData name="Jake Kendrick" userId="c9aa91da-2e15-46cf-a8c4-b4cee9b8e514" providerId="ADAL" clId="{4D39B9F2-2A26-5844-9159-FAC44B83CB06}" dt="2022-05-16T02:38:17.140" v="4"/>
          <pc:sldLayoutMkLst>
            <pc:docMk/>
            <pc:sldMasterMk cId="2382013965" sldId="2147483684"/>
            <pc:sldLayoutMk cId="4289396409" sldId="2147483689"/>
          </pc:sldLayoutMkLst>
          <pc:spChg chg="mod">
            <ac:chgData name="Jake Kendrick" userId="c9aa91da-2e15-46cf-a8c4-b4cee9b8e514" providerId="ADAL" clId="{4D39B9F2-2A26-5844-9159-FAC44B83CB06}" dt="2022-05-16T02:38:17.140" v="4"/>
            <ac:spMkLst>
              <pc:docMk/>
              <pc:sldMasterMk cId="2382013965" sldId="2147483684"/>
              <pc:sldLayoutMk cId="4289396409" sldId="2147483689"/>
              <ac:spMk id="2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8:17.140" v="4"/>
            <ac:spMkLst>
              <pc:docMk/>
              <pc:sldMasterMk cId="2382013965" sldId="2147483684"/>
              <pc:sldLayoutMk cId="4289396409" sldId="2147483689"/>
              <ac:spMk id="3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8:17.140" v="4"/>
            <ac:spMkLst>
              <pc:docMk/>
              <pc:sldMasterMk cId="2382013965" sldId="2147483684"/>
              <pc:sldLayoutMk cId="4289396409" sldId="2147483689"/>
              <ac:spMk id="4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8:17.140" v="4"/>
            <ac:spMkLst>
              <pc:docMk/>
              <pc:sldMasterMk cId="2382013965" sldId="2147483684"/>
              <pc:sldLayoutMk cId="4289396409" sldId="2147483689"/>
              <ac:spMk id="5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8:17.140" v="4"/>
            <ac:spMkLst>
              <pc:docMk/>
              <pc:sldMasterMk cId="2382013965" sldId="2147483684"/>
              <pc:sldLayoutMk cId="4289396409" sldId="2147483689"/>
              <ac:spMk id="6" creationId="{00000000-0000-0000-0000-000000000000}"/>
            </ac:spMkLst>
          </pc:spChg>
        </pc:sldLayoutChg>
        <pc:sldLayoutChg chg="modSp">
          <pc:chgData name="Jake Kendrick" userId="c9aa91da-2e15-46cf-a8c4-b4cee9b8e514" providerId="ADAL" clId="{4D39B9F2-2A26-5844-9159-FAC44B83CB06}" dt="2022-05-16T02:38:17.140" v="4"/>
          <pc:sldLayoutMkLst>
            <pc:docMk/>
            <pc:sldMasterMk cId="2382013965" sldId="2147483684"/>
            <pc:sldLayoutMk cId="57237556" sldId="2147483692"/>
          </pc:sldLayoutMkLst>
          <pc:spChg chg="mod">
            <ac:chgData name="Jake Kendrick" userId="c9aa91da-2e15-46cf-a8c4-b4cee9b8e514" providerId="ADAL" clId="{4D39B9F2-2A26-5844-9159-FAC44B83CB06}" dt="2022-05-16T02:38:17.140" v="4"/>
            <ac:spMkLst>
              <pc:docMk/>
              <pc:sldMasterMk cId="2382013965" sldId="2147483684"/>
              <pc:sldLayoutMk cId="57237556" sldId="2147483692"/>
              <ac:spMk id="2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8:17.140" v="4"/>
            <ac:spMkLst>
              <pc:docMk/>
              <pc:sldMasterMk cId="2382013965" sldId="2147483684"/>
              <pc:sldLayoutMk cId="57237556" sldId="2147483692"/>
              <ac:spMk id="3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8:17.140" v="4"/>
            <ac:spMkLst>
              <pc:docMk/>
              <pc:sldMasterMk cId="2382013965" sldId="2147483684"/>
              <pc:sldLayoutMk cId="57237556" sldId="2147483692"/>
              <ac:spMk id="4" creationId="{00000000-0000-0000-0000-000000000000}"/>
            </ac:spMkLst>
          </pc:spChg>
        </pc:sldLayoutChg>
        <pc:sldLayoutChg chg="modSp">
          <pc:chgData name="Jake Kendrick" userId="c9aa91da-2e15-46cf-a8c4-b4cee9b8e514" providerId="ADAL" clId="{4D39B9F2-2A26-5844-9159-FAC44B83CB06}" dt="2022-05-16T02:38:17.140" v="4"/>
          <pc:sldLayoutMkLst>
            <pc:docMk/>
            <pc:sldMasterMk cId="2382013965" sldId="2147483684"/>
            <pc:sldLayoutMk cId="4223698147" sldId="2147483693"/>
          </pc:sldLayoutMkLst>
          <pc:spChg chg="mod">
            <ac:chgData name="Jake Kendrick" userId="c9aa91da-2e15-46cf-a8c4-b4cee9b8e514" providerId="ADAL" clId="{4D39B9F2-2A26-5844-9159-FAC44B83CB06}" dt="2022-05-16T02:38:17.140" v="4"/>
            <ac:spMkLst>
              <pc:docMk/>
              <pc:sldMasterMk cId="2382013965" sldId="2147483684"/>
              <pc:sldLayoutMk cId="4223698147" sldId="2147483693"/>
              <ac:spMk id="2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8:17.140" v="4"/>
            <ac:spMkLst>
              <pc:docMk/>
              <pc:sldMasterMk cId="2382013965" sldId="2147483684"/>
              <pc:sldLayoutMk cId="4223698147" sldId="2147483693"/>
              <ac:spMk id="3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8:17.140" v="4"/>
            <ac:spMkLst>
              <pc:docMk/>
              <pc:sldMasterMk cId="2382013965" sldId="2147483684"/>
              <pc:sldLayoutMk cId="4223698147" sldId="2147483693"/>
              <ac:spMk id="4" creationId="{00000000-0000-0000-0000-000000000000}"/>
            </ac:spMkLst>
          </pc:spChg>
        </pc:sldLayoutChg>
        <pc:sldLayoutChg chg="modSp">
          <pc:chgData name="Jake Kendrick" userId="c9aa91da-2e15-46cf-a8c4-b4cee9b8e514" providerId="ADAL" clId="{4D39B9F2-2A26-5844-9159-FAC44B83CB06}" dt="2022-05-16T02:38:17.140" v="4"/>
          <pc:sldLayoutMkLst>
            <pc:docMk/>
            <pc:sldMasterMk cId="2382013965" sldId="2147483684"/>
            <pc:sldLayoutMk cId="2881034104" sldId="2147483695"/>
          </pc:sldLayoutMkLst>
          <pc:spChg chg="mod">
            <ac:chgData name="Jake Kendrick" userId="c9aa91da-2e15-46cf-a8c4-b4cee9b8e514" providerId="ADAL" clId="{4D39B9F2-2A26-5844-9159-FAC44B83CB06}" dt="2022-05-16T02:38:17.140" v="4"/>
            <ac:spMkLst>
              <pc:docMk/>
              <pc:sldMasterMk cId="2382013965" sldId="2147483684"/>
              <pc:sldLayoutMk cId="2881034104" sldId="2147483695"/>
              <ac:spMk id="2" creationId="{00000000-0000-0000-0000-000000000000}"/>
            </ac:spMkLst>
          </pc:spChg>
          <pc:spChg chg="mod">
            <ac:chgData name="Jake Kendrick" userId="c9aa91da-2e15-46cf-a8c4-b4cee9b8e514" providerId="ADAL" clId="{4D39B9F2-2A26-5844-9159-FAC44B83CB06}" dt="2022-05-16T02:38:17.140" v="4"/>
            <ac:spMkLst>
              <pc:docMk/>
              <pc:sldMasterMk cId="2382013965" sldId="2147483684"/>
              <pc:sldLayoutMk cId="2881034104" sldId="2147483695"/>
              <ac:spMk id="3" creationId="{00000000-0000-0000-0000-000000000000}"/>
            </ac:spMkLst>
          </pc:spChg>
        </pc:sldLayoutChg>
      </pc:sldMasterChg>
    </pc:docChg>
  </pc:docChgLst>
  <pc:docChgLst>
    <pc:chgData name="Jake Kendrick" userId="S::21308325@student.uwa.edu.au::ab142299-a4dd-4def-8b03-8ee3e1d9a7dd" providerId="AD" clId="Web-{AA208596-E5C7-306F-58B7-9DDD618441BA}"/>
    <pc:docChg chg="modSld">
      <pc:chgData name="Jake Kendrick" userId="S::21308325@student.uwa.edu.au::ab142299-a4dd-4def-8b03-8ee3e1d9a7dd" providerId="AD" clId="Web-{AA208596-E5C7-306F-58B7-9DDD618441BA}" dt="2023-04-12T01:55:29.277" v="5" actId="1076"/>
      <pc:docMkLst>
        <pc:docMk/>
      </pc:docMkLst>
      <pc:sldChg chg="addSp delSp modSp">
        <pc:chgData name="Jake Kendrick" userId="S::21308325@student.uwa.edu.au::ab142299-a4dd-4def-8b03-8ee3e1d9a7dd" providerId="AD" clId="Web-{AA208596-E5C7-306F-58B7-9DDD618441BA}" dt="2023-04-12T01:55:29.277" v="5" actId="1076"/>
        <pc:sldMkLst>
          <pc:docMk/>
          <pc:sldMk cId="109857222" sldId="256"/>
        </pc:sldMkLst>
        <pc:picChg chg="add mod">
          <ac:chgData name="Jake Kendrick" userId="S::21308325@student.uwa.edu.au::ab142299-a4dd-4def-8b03-8ee3e1d9a7dd" providerId="AD" clId="Web-{AA208596-E5C7-306F-58B7-9DDD618441BA}" dt="2023-04-12T01:55:29.277" v="5" actId="1076"/>
          <ac:picMkLst>
            <pc:docMk/>
            <pc:sldMk cId="109857222" sldId="256"/>
            <ac:picMk id="3" creationId="{29DC028C-C003-0D26-6833-956F84B48A13}"/>
          </ac:picMkLst>
        </pc:picChg>
        <pc:picChg chg="del mod">
          <ac:chgData name="Jake Kendrick" userId="S::21308325@student.uwa.edu.au::ab142299-a4dd-4def-8b03-8ee3e1d9a7dd" providerId="AD" clId="Web-{AA208596-E5C7-306F-58B7-9DDD618441BA}" dt="2023-04-12T01:46:24.370" v="1"/>
          <ac:picMkLst>
            <pc:docMk/>
            <pc:sldMk cId="109857222" sldId="256"/>
            <ac:picMk id="25" creationId="{567B6BDE-80CA-5047-A305-5EA45DC74A1A}"/>
          </ac:picMkLst>
        </pc:picChg>
      </pc:sldChg>
    </pc:docChg>
  </pc:docChgLst>
  <pc:docChgLst>
    <pc:chgData name="Jake Kendrick" userId="S::21308325@student.uwa.edu.au::ab142299-a4dd-4def-8b03-8ee3e1d9a7dd" providerId="AD" clId="Web-{2300E28E-24E7-D8A2-D92A-67962088FF3E}"/>
    <pc:docChg chg="modSld">
      <pc:chgData name="Jake Kendrick" userId="S::21308325@student.uwa.edu.au::ab142299-a4dd-4def-8b03-8ee3e1d9a7dd" providerId="AD" clId="Web-{2300E28E-24E7-D8A2-D92A-67962088FF3E}" dt="2023-04-12T01:21:40.936" v="31" actId="1076"/>
      <pc:docMkLst>
        <pc:docMk/>
      </pc:docMkLst>
      <pc:sldChg chg="addSp delSp modSp">
        <pc:chgData name="Jake Kendrick" userId="S::21308325@student.uwa.edu.au::ab142299-a4dd-4def-8b03-8ee3e1d9a7dd" providerId="AD" clId="Web-{2300E28E-24E7-D8A2-D92A-67962088FF3E}" dt="2023-04-12T01:21:40.936" v="31" actId="1076"/>
        <pc:sldMkLst>
          <pc:docMk/>
          <pc:sldMk cId="109857222" sldId="256"/>
        </pc:sldMkLst>
        <pc:spChg chg="del">
          <ac:chgData name="Jake Kendrick" userId="S::21308325@student.uwa.edu.au::ab142299-a4dd-4def-8b03-8ee3e1d9a7dd" providerId="AD" clId="Web-{2300E28E-24E7-D8A2-D92A-67962088FF3E}" dt="2023-04-12T01:10:25.330" v="15"/>
          <ac:spMkLst>
            <pc:docMk/>
            <pc:sldMk cId="109857222" sldId="256"/>
            <ac:spMk id="3" creationId="{752B7F05-BB20-FF7C-46AD-19DB3DCBC1C5}"/>
          </ac:spMkLst>
        </pc:spChg>
        <pc:spChg chg="del">
          <ac:chgData name="Jake Kendrick" userId="S::21308325@student.uwa.edu.au::ab142299-a4dd-4def-8b03-8ee3e1d9a7dd" providerId="AD" clId="Web-{2300E28E-24E7-D8A2-D92A-67962088FF3E}" dt="2023-04-12T01:10:25.330" v="12"/>
          <ac:spMkLst>
            <pc:docMk/>
            <pc:sldMk cId="109857222" sldId="256"/>
            <ac:spMk id="4" creationId="{86CE8CDC-9512-5222-4EE8-5652CBCF6ABC}"/>
          </ac:spMkLst>
        </pc:spChg>
        <pc:spChg chg="del">
          <ac:chgData name="Jake Kendrick" userId="S::21308325@student.uwa.edu.au::ab142299-a4dd-4def-8b03-8ee3e1d9a7dd" providerId="AD" clId="Web-{2300E28E-24E7-D8A2-D92A-67962088FF3E}" dt="2023-04-12T01:10:25.330" v="14"/>
          <ac:spMkLst>
            <pc:docMk/>
            <pc:sldMk cId="109857222" sldId="256"/>
            <ac:spMk id="5" creationId="{98293BB6-3D40-E604-EEC1-B02802083163}"/>
          </ac:spMkLst>
        </pc:spChg>
        <pc:spChg chg="del">
          <ac:chgData name="Jake Kendrick" userId="S::21308325@student.uwa.edu.au::ab142299-a4dd-4def-8b03-8ee3e1d9a7dd" providerId="AD" clId="Web-{2300E28E-24E7-D8A2-D92A-67962088FF3E}" dt="2023-04-12T01:10:25.330" v="13"/>
          <ac:spMkLst>
            <pc:docMk/>
            <pc:sldMk cId="109857222" sldId="256"/>
            <ac:spMk id="6" creationId="{54EB5050-2446-CEE9-5B90-ABA19520141F}"/>
          </ac:spMkLst>
        </pc:spChg>
        <pc:spChg chg="del">
          <ac:chgData name="Jake Kendrick" userId="S::21308325@student.uwa.edu.au::ab142299-a4dd-4def-8b03-8ee3e1d9a7dd" providerId="AD" clId="Web-{2300E28E-24E7-D8A2-D92A-67962088FF3E}" dt="2023-04-12T01:10:25.330" v="11"/>
          <ac:spMkLst>
            <pc:docMk/>
            <pc:sldMk cId="109857222" sldId="256"/>
            <ac:spMk id="7" creationId="{FE0A73F2-CF4D-A099-752C-FBC0496EC9FB}"/>
          </ac:spMkLst>
        </pc:spChg>
        <pc:spChg chg="del">
          <ac:chgData name="Jake Kendrick" userId="S::21308325@student.uwa.edu.au::ab142299-a4dd-4def-8b03-8ee3e1d9a7dd" providerId="AD" clId="Web-{2300E28E-24E7-D8A2-D92A-67962088FF3E}" dt="2023-04-12T01:10:25.330" v="10"/>
          <ac:spMkLst>
            <pc:docMk/>
            <pc:sldMk cId="109857222" sldId="256"/>
            <ac:spMk id="8" creationId="{652A4ECA-6D7A-BB55-9BF9-65FC0D43B2E1}"/>
          </ac:spMkLst>
        </pc:spChg>
        <pc:spChg chg="del">
          <ac:chgData name="Jake Kendrick" userId="S::21308325@student.uwa.edu.au::ab142299-a4dd-4def-8b03-8ee3e1d9a7dd" providerId="AD" clId="Web-{2300E28E-24E7-D8A2-D92A-67962088FF3E}" dt="2023-04-12T01:10:25.330" v="16"/>
          <ac:spMkLst>
            <pc:docMk/>
            <pc:sldMk cId="109857222" sldId="256"/>
            <ac:spMk id="10" creationId="{77A02ED0-8423-0C42-930A-6F5D1DA6A053}"/>
          </ac:spMkLst>
        </pc:spChg>
        <pc:spChg chg="del">
          <ac:chgData name="Jake Kendrick" userId="S::21308325@student.uwa.edu.au::ab142299-a4dd-4def-8b03-8ee3e1d9a7dd" providerId="AD" clId="Web-{2300E28E-24E7-D8A2-D92A-67962088FF3E}" dt="2023-04-12T01:10:26.986" v="17"/>
          <ac:spMkLst>
            <pc:docMk/>
            <pc:sldMk cId="109857222" sldId="256"/>
            <ac:spMk id="13" creationId="{A9A32FB2-2064-654E-9855-BDC1D5C342CA}"/>
          </ac:spMkLst>
        </pc:spChg>
        <pc:spChg chg="del">
          <ac:chgData name="Jake Kendrick" userId="S::21308325@student.uwa.edu.au::ab142299-a4dd-4def-8b03-8ee3e1d9a7dd" providerId="AD" clId="Web-{2300E28E-24E7-D8A2-D92A-67962088FF3E}" dt="2023-04-12T01:10:25.330" v="7"/>
          <ac:spMkLst>
            <pc:docMk/>
            <pc:sldMk cId="109857222" sldId="256"/>
            <ac:spMk id="16" creationId="{E4575559-6DEE-6DAD-40D2-9E0F91EC9366}"/>
          </ac:spMkLst>
        </pc:spChg>
        <pc:spChg chg="del">
          <ac:chgData name="Jake Kendrick" userId="S::21308325@student.uwa.edu.au::ab142299-a4dd-4def-8b03-8ee3e1d9a7dd" providerId="AD" clId="Web-{2300E28E-24E7-D8A2-D92A-67962088FF3E}" dt="2023-04-12T01:10:25.330" v="6"/>
          <ac:spMkLst>
            <pc:docMk/>
            <pc:sldMk cId="109857222" sldId="256"/>
            <ac:spMk id="17" creationId="{7E019E43-18AA-B263-69F2-148E44F4699A}"/>
          </ac:spMkLst>
        </pc:spChg>
        <pc:spChg chg="del">
          <ac:chgData name="Jake Kendrick" userId="S::21308325@student.uwa.edu.au::ab142299-a4dd-4def-8b03-8ee3e1d9a7dd" providerId="AD" clId="Web-{2300E28E-24E7-D8A2-D92A-67962088FF3E}" dt="2023-04-12T01:10:25.330" v="5"/>
          <ac:spMkLst>
            <pc:docMk/>
            <pc:sldMk cId="109857222" sldId="256"/>
            <ac:spMk id="18" creationId="{9F88437A-F819-661A-C1BD-CEDB174DA3B3}"/>
          </ac:spMkLst>
        </pc:spChg>
        <pc:spChg chg="del">
          <ac:chgData name="Jake Kendrick" userId="S::21308325@student.uwa.edu.au::ab142299-a4dd-4def-8b03-8ee3e1d9a7dd" providerId="AD" clId="Web-{2300E28E-24E7-D8A2-D92A-67962088FF3E}" dt="2023-04-12T01:10:25.330" v="4"/>
          <ac:spMkLst>
            <pc:docMk/>
            <pc:sldMk cId="109857222" sldId="256"/>
            <ac:spMk id="19" creationId="{2605BFF7-D100-AF1D-0E5D-732E19142129}"/>
          </ac:spMkLst>
        </pc:spChg>
        <pc:spChg chg="del">
          <ac:chgData name="Jake Kendrick" userId="S::21308325@student.uwa.edu.au::ab142299-a4dd-4def-8b03-8ee3e1d9a7dd" providerId="AD" clId="Web-{2300E28E-24E7-D8A2-D92A-67962088FF3E}" dt="2023-04-12T01:10:25.330" v="1"/>
          <ac:spMkLst>
            <pc:docMk/>
            <pc:sldMk cId="109857222" sldId="256"/>
            <ac:spMk id="22" creationId="{B0EE2EF5-4329-FE4B-53FB-5CFD97EF403C}"/>
          </ac:spMkLst>
        </pc:spChg>
        <pc:spChg chg="del">
          <ac:chgData name="Jake Kendrick" userId="S::21308325@student.uwa.edu.au::ab142299-a4dd-4def-8b03-8ee3e1d9a7dd" providerId="AD" clId="Web-{2300E28E-24E7-D8A2-D92A-67962088FF3E}" dt="2023-04-12T01:10:25.330" v="0"/>
          <ac:spMkLst>
            <pc:docMk/>
            <pc:sldMk cId="109857222" sldId="256"/>
            <ac:spMk id="23" creationId="{6F1E9DD4-B235-0D4A-7380-9AFFF9787E36}"/>
          </ac:spMkLst>
        </pc:spChg>
        <pc:picChg chg="add del mod">
          <ac:chgData name="Jake Kendrick" userId="S::21308325@student.uwa.edu.au::ab142299-a4dd-4def-8b03-8ee3e1d9a7dd" providerId="AD" clId="Web-{2300E28E-24E7-D8A2-D92A-67962088FF3E}" dt="2023-04-12T01:14:51.810" v="22"/>
          <ac:picMkLst>
            <pc:docMk/>
            <pc:sldMk cId="109857222" sldId="256"/>
            <ac:picMk id="11" creationId="{B5BE79C2-96E3-8B66-4480-F497C7448B62}"/>
          </ac:picMkLst>
        </pc:picChg>
        <pc:picChg chg="add del mod">
          <ac:chgData name="Jake Kendrick" userId="S::21308325@student.uwa.edu.au::ab142299-a4dd-4def-8b03-8ee3e1d9a7dd" providerId="AD" clId="Web-{2300E28E-24E7-D8A2-D92A-67962088FF3E}" dt="2023-04-12T01:21:17.169" v="26"/>
          <ac:picMkLst>
            <pc:docMk/>
            <pc:sldMk cId="109857222" sldId="256"/>
            <ac:picMk id="24" creationId="{B574E964-15CE-4F8B-C65E-BB9DABB74F5A}"/>
          </ac:picMkLst>
        </pc:picChg>
        <pc:picChg chg="add mod">
          <ac:chgData name="Jake Kendrick" userId="S::21308325@student.uwa.edu.au::ab142299-a4dd-4def-8b03-8ee3e1d9a7dd" providerId="AD" clId="Web-{2300E28E-24E7-D8A2-D92A-67962088FF3E}" dt="2023-04-12T01:21:40.936" v="31" actId="1076"/>
          <ac:picMkLst>
            <pc:docMk/>
            <pc:sldMk cId="109857222" sldId="256"/>
            <ac:picMk id="25" creationId="{567B6BDE-80CA-5047-A305-5EA45DC74A1A}"/>
          </ac:picMkLst>
        </pc:picChg>
        <pc:cxnChg chg="del">
          <ac:chgData name="Jake Kendrick" userId="S::21308325@student.uwa.edu.au::ab142299-a4dd-4def-8b03-8ee3e1d9a7dd" providerId="AD" clId="Web-{2300E28E-24E7-D8A2-D92A-67962088FF3E}" dt="2023-04-12T01:10:25.330" v="9"/>
          <ac:cxnSpMkLst>
            <pc:docMk/>
            <pc:sldMk cId="109857222" sldId="256"/>
            <ac:cxnSpMk id="9" creationId="{A179DD93-6A7C-87EA-40AB-B385E5C66F0A}"/>
          </ac:cxnSpMkLst>
        </pc:cxnChg>
        <pc:cxnChg chg="del">
          <ac:chgData name="Jake Kendrick" userId="S::21308325@student.uwa.edu.au::ab142299-a4dd-4def-8b03-8ee3e1d9a7dd" providerId="AD" clId="Web-{2300E28E-24E7-D8A2-D92A-67962088FF3E}" dt="2023-04-12T01:10:25.330" v="8"/>
          <ac:cxnSpMkLst>
            <pc:docMk/>
            <pc:sldMk cId="109857222" sldId="256"/>
            <ac:cxnSpMk id="14" creationId="{5847464F-683F-D09C-582A-3723821AE0BF}"/>
          </ac:cxnSpMkLst>
        </pc:cxnChg>
        <pc:cxnChg chg="del">
          <ac:chgData name="Jake Kendrick" userId="S::21308325@student.uwa.edu.au::ab142299-a4dd-4def-8b03-8ee3e1d9a7dd" providerId="AD" clId="Web-{2300E28E-24E7-D8A2-D92A-67962088FF3E}" dt="2023-04-12T01:10:25.330" v="3"/>
          <ac:cxnSpMkLst>
            <pc:docMk/>
            <pc:sldMk cId="109857222" sldId="256"/>
            <ac:cxnSpMk id="20" creationId="{FE856398-D58E-ECCA-F962-CAB3B6257EFA}"/>
          </ac:cxnSpMkLst>
        </pc:cxnChg>
        <pc:cxnChg chg="del">
          <ac:chgData name="Jake Kendrick" userId="S::21308325@student.uwa.edu.au::ab142299-a4dd-4def-8b03-8ee3e1d9a7dd" providerId="AD" clId="Web-{2300E28E-24E7-D8A2-D92A-67962088FF3E}" dt="2023-04-12T01:10:25.330" v="2"/>
          <ac:cxnSpMkLst>
            <pc:docMk/>
            <pc:sldMk cId="109857222" sldId="256"/>
            <ac:cxnSpMk id="21" creationId="{2D5AE94A-DA00-6E17-3C9B-A1DD50C1DC79}"/>
          </ac:cxnSpMkLst>
        </pc:cxnChg>
      </pc:sldChg>
    </pc:docChg>
  </pc:docChgLst>
  <pc:docChgLst>
    <pc:chgData name="Jake Kendrick" userId="S::21308325@student.uwa.edu.au::ab142299-a4dd-4def-8b03-8ee3e1d9a7dd" providerId="AD" clId="Web-{D42B9FDD-B555-D143-C7AC-A78E9BD1E16F}"/>
    <pc:docChg chg="modSld">
      <pc:chgData name="Jake Kendrick" userId="S::21308325@student.uwa.edu.au::ab142299-a4dd-4def-8b03-8ee3e1d9a7dd" providerId="AD" clId="Web-{D42B9FDD-B555-D143-C7AC-A78E9BD1E16F}" dt="2023-04-03T00:20:47.796" v="154" actId="1076"/>
      <pc:docMkLst>
        <pc:docMk/>
      </pc:docMkLst>
      <pc:sldChg chg="addSp delSp modSp">
        <pc:chgData name="Jake Kendrick" userId="S::21308325@student.uwa.edu.au::ab142299-a4dd-4def-8b03-8ee3e1d9a7dd" providerId="AD" clId="Web-{D42B9FDD-B555-D143-C7AC-A78E9BD1E16F}" dt="2023-04-03T00:20:47.796" v="154" actId="1076"/>
        <pc:sldMkLst>
          <pc:docMk/>
          <pc:sldMk cId="109857222" sldId="256"/>
        </pc:sldMkLst>
        <pc:spChg chg="add mod">
          <ac:chgData name="Jake Kendrick" userId="S::21308325@student.uwa.edu.au::ab142299-a4dd-4def-8b03-8ee3e1d9a7dd" providerId="AD" clId="Web-{D42B9FDD-B555-D143-C7AC-A78E9BD1E16F}" dt="2023-04-03T00:09:12.120" v="21" actId="1076"/>
          <ac:spMkLst>
            <pc:docMk/>
            <pc:sldMk cId="109857222" sldId="256"/>
            <ac:spMk id="4" creationId="{86CE8CDC-9512-5222-4EE8-5652CBCF6ABC}"/>
          </ac:spMkLst>
        </pc:spChg>
        <pc:spChg chg="mod">
          <ac:chgData name="Jake Kendrick" userId="S::21308325@student.uwa.edu.au::ab142299-a4dd-4def-8b03-8ee3e1d9a7dd" providerId="AD" clId="Web-{D42B9FDD-B555-D143-C7AC-A78E9BD1E16F}" dt="2023-04-03T00:20:47.796" v="154" actId="1076"/>
          <ac:spMkLst>
            <pc:docMk/>
            <pc:sldMk cId="109857222" sldId="256"/>
            <ac:spMk id="5" creationId="{98293BB6-3D40-E604-EEC1-B02802083163}"/>
          </ac:spMkLst>
        </pc:spChg>
        <pc:spChg chg="mod">
          <ac:chgData name="Jake Kendrick" userId="S::21308325@student.uwa.edu.au::ab142299-a4dd-4def-8b03-8ee3e1d9a7dd" providerId="AD" clId="Web-{D42B9FDD-B555-D143-C7AC-A78E9BD1E16F}" dt="2023-04-03T00:08:58.167" v="14" actId="1076"/>
          <ac:spMkLst>
            <pc:docMk/>
            <pc:sldMk cId="109857222" sldId="256"/>
            <ac:spMk id="6" creationId="{54EB5050-2446-CEE9-5B90-ABA19520141F}"/>
          </ac:spMkLst>
        </pc:spChg>
        <pc:spChg chg="add mod">
          <ac:chgData name="Jake Kendrick" userId="S::21308325@student.uwa.edu.au::ab142299-a4dd-4def-8b03-8ee3e1d9a7dd" providerId="AD" clId="Web-{D42B9FDD-B555-D143-C7AC-A78E9BD1E16F}" dt="2023-04-03T00:09:20.980" v="24" actId="1076"/>
          <ac:spMkLst>
            <pc:docMk/>
            <pc:sldMk cId="109857222" sldId="256"/>
            <ac:spMk id="7" creationId="{FE0A73F2-CF4D-A099-752C-FBC0496EC9FB}"/>
          </ac:spMkLst>
        </pc:spChg>
        <pc:spChg chg="add mod">
          <ac:chgData name="Jake Kendrick" userId="S::21308325@student.uwa.edu.au::ab142299-a4dd-4def-8b03-8ee3e1d9a7dd" providerId="AD" clId="Web-{D42B9FDD-B555-D143-C7AC-A78E9BD1E16F}" dt="2023-04-03T00:09:56.418" v="32" actId="1076"/>
          <ac:spMkLst>
            <pc:docMk/>
            <pc:sldMk cId="109857222" sldId="256"/>
            <ac:spMk id="8" creationId="{652A4ECA-6D7A-BB55-9BF9-65FC0D43B2E1}"/>
          </ac:spMkLst>
        </pc:spChg>
        <pc:spChg chg="add mod">
          <ac:chgData name="Jake Kendrick" userId="S::21308325@student.uwa.edu.au::ab142299-a4dd-4def-8b03-8ee3e1d9a7dd" providerId="AD" clId="Web-{D42B9FDD-B555-D143-C7AC-A78E9BD1E16F}" dt="2023-04-03T00:17:23.822" v="58" actId="14100"/>
          <ac:spMkLst>
            <pc:docMk/>
            <pc:sldMk cId="109857222" sldId="256"/>
            <ac:spMk id="16" creationId="{E4575559-6DEE-6DAD-40D2-9E0F91EC9366}"/>
          </ac:spMkLst>
        </pc:spChg>
        <pc:spChg chg="add mod">
          <ac:chgData name="Jake Kendrick" userId="S::21308325@student.uwa.edu.au::ab142299-a4dd-4def-8b03-8ee3e1d9a7dd" providerId="AD" clId="Web-{D42B9FDD-B555-D143-C7AC-A78E9BD1E16F}" dt="2023-04-03T00:20:32.968" v="146" actId="1076"/>
          <ac:spMkLst>
            <pc:docMk/>
            <pc:sldMk cId="109857222" sldId="256"/>
            <ac:spMk id="17" creationId="{7E019E43-18AA-B263-69F2-148E44F4699A}"/>
          </ac:spMkLst>
        </pc:spChg>
        <pc:spChg chg="add mod">
          <ac:chgData name="Jake Kendrick" userId="S::21308325@student.uwa.edu.au::ab142299-a4dd-4def-8b03-8ee3e1d9a7dd" providerId="AD" clId="Web-{D42B9FDD-B555-D143-C7AC-A78E9BD1E16F}" dt="2023-04-03T00:19:07.731" v="108" actId="1076"/>
          <ac:spMkLst>
            <pc:docMk/>
            <pc:sldMk cId="109857222" sldId="256"/>
            <ac:spMk id="18" creationId="{9F88437A-F819-661A-C1BD-CEDB174DA3B3}"/>
          </ac:spMkLst>
        </pc:spChg>
        <pc:spChg chg="add mod">
          <ac:chgData name="Jake Kendrick" userId="S::21308325@student.uwa.edu.au::ab142299-a4dd-4def-8b03-8ee3e1d9a7dd" providerId="AD" clId="Web-{D42B9FDD-B555-D143-C7AC-A78E9BD1E16F}" dt="2023-04-03T00:19:29.716" v="116" actId="20577"/>
          <ac:spMkLst>
            <pc:docMk/>
            <pc:sldMk cId="109857222" sldId="256"/>
            <ac:spMk id="19" creationId="{2605BFF7-D100-AF1D-0E5D-732E19142129}"/>
          </ac:spMkLst>
        </pc:spChg>
        <pc:spChg chg="add mod">
          <ac:chgData name="Jake Kendrick" userId="S::21308325@student.uwa.edu.au::ab142299-a4dd-4def-8b03-8ee3e1d9a7dd" providerId="AD" clId="Web-{D42B9FDD-B555-D143-C7AC-A78E9BD1E16F}" dt="2023-04-03T00:19:07.809" v="112" actId="1076"/>
          <ac:spMkLst>
            <pc:docMk/>
            <pc:sldMk cId="109857222" sldId="256"/>
            <ac:spMk id="22" creationId="{B0EE2EF5-4329-FE4B-53FB-5CFD97EF403C}"/>
          </ac:spMkLst>
        </pc:spChg>
        <pc:spChg chg="add mod">
          <ac:chgData name="Jake Kendrick" userId="S::21308325@student.uwa.edu.au::ab142299-a4dd-4def-8b03-8ee3e1d9a7dd" providerId="AD" clId="Web-{D42B9FDD-B555-D143-C7AC-A78E9BD1E16F}" dt="2023-04-03T00:20:24.046" v="144" actId="20577"/>
          <ac:spMkLst>
            <pc:docMk/>
            <pc:sldMk cId="109857222" sldId="256"/>
            <ac:spMk id="23" creationId="{6F1E9DD4-B235-0D4A-7380-9AFFF9787E36}"/>
          </ac:spMkLst>
        </pc:spChg>
        <pc:cxnChg chg="add mod">
          <ac:chgData name="Jake Kendrick" userId="S::21308325@student.uwa.edu.au::ab142299-a4dd-4def-8b03-8ee3e1d9a7dd" providerId="AD" clId="Web-{D42B9FDD-B555-D143-C7AC-A78E9BD1E16F}" dt="2023-04-03T00:10:53.795" v="39"/>
          <ac:cxnSpMkLst>
            <pc:docMk/>
            <pc:sldMk cId="109857222" sldId="256"/>
            <ac:cxnSpMk id="9" creationId="{A179DD93-6A7C-87EA-40AB-B385E5C66F0A}"/>
          </ac:cxnSpMkLst>
        </pc:cxnChg>
        <pc:cxnChg chg="add del mod">
          <ac:chgData name="Jake Kendrick" userId="S::21308325@student.uwa.edu.au::ab142299-a4dd-4def-8b03-8ee3e1d9a7dd" providerId="AD" clId="Web-{D42B9FDD-B555-D143-C7AC-A78E9BD1E16F}" dt="2023-04-03T00:11:18.968" v="43"/>
          <ac:cxnSpMkLst>
            <pc:docMk/>
            <pc:sldMk cId="109857222" sldId="256"/>
            <ac:cxnSpMk id="11" creationId="{366F5384-1687-A920-C20D-7A7ED62E8B97}"/>
          </ac:cxnSpMkLst>
        </pc:cxnChg>
        <pc:cxnChg chg="add mod">
          <ac:chgData name="Jake Kendrick" userId="S::21308325@student.uwa.edu.au::ab142299-a4dd-4def-8b03-8ee3e1d9a7dd" providerId="AD" clId="Web-{D42B9FDD-B555-D143-C7AC-A78E9BD1E16F}" dt="2023-04-03T00:17:10.962" v="55" actId="14100"/>
          <ac:cxnSpMkLst>
            <pc:docMk/>
            <pc:sldMk cId="109857222" sldId="256"/>
            <ac:cxnSpMk id="14" creationId="{5847464F-683F-D09C-582A-3723821AE0BF}"/>
          </ac:cxnSpMkLst>
        </pc:cxnChg>
        <pc:cxnChg chg="add mod">
          <ac:chgData name="Jake Kendrick" userId="S::21308325@student.uwa.edu.au::ab142299-a4dd-4def-8b03-8ee3e1d9a7dd" providerId="AD" clId="Web-{D42B9FDD-B555-D143-C7AC-A78E9BD1E16F}" dt="2023-04-03T00:19:07.778" v="110" actId="1076"/>
          <ac:cxnSpMkLst>
            <pc:docMk/>
            <pc:sldMk cId="109857222" sldId="256"/>
            <ac:cxnSpMk id="20" creationId="{FE856398-D58E-ECCA-F962-CAB3B6257EFA}"/>
          </ac:cxnSpMkLst>
        </pc:cxnChg>
        <pc:cxnChg chg="add mod">
          <ac:chgData name="Jake Kendrick" userId="S::21308325@student.uwa.edu.au::ab142299-a4dd-4def-8b03-8ee3e1d9a7dd" providerId="AD" clId="Web-{D42B9FDD-B555-D143-C7AC-A78E9BD1E16F}" dt="2023-04-03T00:19:07.793" v="111" actId="1076"/>
          <ac:cxnSpMkLst>
            <pc:docMk/>
            <pc:sldMk cId="109857222" sldId="256"/>
            <ac:cxnSpMk id="21" creationId="{2D5AE94A-DA00-6E17-3C9B-A1DD50C1DC79}"/>
          </ac:cxnSpMkLst>
        </pc:cxnChg>
      </pc:sldChg>
    </pc:docChg>
  </pc:docChgLst>
  <pc:docChgLst>
    <pc:chgData name="Jake Kendrick" userId="S::21308325@student.uwa.edu.au::ab142299-a4dd-4def-8b03-8ee3e1d9a7dd" providerId="AD" clId="Web-{7F97B290-1F6C-EB53-7E45-EA0976673536}"/>
    <pc:docChg chg="delSld modSld">
      <pc:chgData name="Jake Kendrick" userId="S::21308325@student.uwa.edu.au::ab142299-a4dd-4def-8b03-8ee3e1d9a7dd" providerId="AD" clId="Web-{7F97B290-1F6C-EB53-7E45-EA0976673536}" dt="2023-05-31T04:40:42.474" v="10"/>
      <pc:docMkLst>
        <pc:docMk/>
      </pc:docMkLst>
      <pc:sldChg chg="addSp delSp modSp">
        <pc:chgData name="Jake Kendrick" userId="S::21308325@student.uwa.edu.au::ab142299-a4dd-4def-8b03-8ee3e1d9a7dd" providerId="AD" clId="Web-{7F97B290-1F6C-EB53-7E45-EA0976673536}" dt="2023-05-31T04:40:40.958" v="9" actId="1076"/>
        <pc:sldMkLst>
          <pc:docMk/>
          <pc:sldMk cId="109857222" sldId="256"/>
        </pc:sldMkLst>
        <pc:spChg chg="add mod">
          <ac:chgData name="Jake Kendrick" userId="S::21308325@student.uwa.edu.au::ab142299-a4dd-4def-8b03-8ee3e1d9a7dd" providerId="AD" clId="Web-{7F97B290-1F6C-EB53-7E45-EA0976673536}" dt="2023-05-31T04:40:40.958" v="9" actId="1076"/>
          <ac:spMkLst>
            <pc:docMk/>
            <pc:sldMk cId="109857222" sldId="256"/>
            <ac:spMk id="4" creationId="{B78966BB-B4FE-5DBC-C3FF-9E2ADA0C6ACF}"/>
          </ac:spMkLst>
        </pc:spChg>
        <pc:spChg chg="del">
          <ac:chgData name="Jake Kendrick" userId="S::21308325@student.uwa.edu.au::ab142299-a4dd-4def-8b03-8ee3e1d9a7dd" providerId="AD" clId="Web-{7F97B290-1F6C-EB53-7E45-EA0976673536}" dt="2023-05-31T04:39:38.488" v="0"/>
          <ac:spMkLst>
            <pc:docMk/>
            <pc:sldMk cId="109857222" sldId="256"/>
            <ac:spMk id="13" creationId="{DA3BCD9B-837D-5E60-A267-BFE9F61A15F4}"/>
          </ac:spMkLst>
        </pc:spChg>
      </pc:sldChg>
      <pc:sldChg chg="modSp del">
        <pc:chgData name="Jake Kendrick" userId="S::21308325@student.uwa.edu.au::ab142299-a4dd-4def-8b03-8ee3e1d9a7dd" providerId="AD" clId="Web-{7F97B290-1F6C-EB53-7E45-EA0976673536}" dt="2023-05-31T04:40:42.474" v="10"/>
        <pc:sldMkLst>
          <pc:docMk/>
          <pc:sldMk cId="169461359" sldId="257"/>
        </pc:sldMkLst>
        <pc:spChg chg="mod">
          <ac:chgData name="Jake Kendrick" userId="S::21308325@student.uwa.edu.au::ab142299-a4dd-4def-8b03-8ee3e1d9a7dd" providerId="AD" clId="Web-{7F97B290-1F6C-EB53-7E45-EA0976673536}" dt="2023-05-31T04:40:11.879" v="7" actId="20577"/>
          <ac:spMkLst>
            <pc:docMk/>
            <pc:sldMk cId="169461359" sldId="257"/>
            <ac:spMk id="4" creationId="{DA2CAD60-077B-2071-8974-928108A43881}"/>
          </ac:spMkLst>
        </pc:spChg>
      </pc:sldChg>
    </pc:docChg>
  </pc:docChgLst>
  <pc:docChgLst>
    <pc:chgData name="Jake Kendrick" userId="S::21308325@student.uwa.edu.au::ab142299-a4dd-4def-8b03-8ee3e1d9a7dd" providerId="AD" clId="Web-{4B8B7ED1-59F9-4AAA-ACBA-529D23FAF7D0}"/>
    <pc:docChg chg="modSld">
      <pc:chgData name="Jake Kendrick" userId="S::21308325@student.uwa.edu.au::ab142299-a4dd-4def-8b03-8ee3e1d9a7dd" providerId="AD" clId="Web-{4B8B7ED1-59F9-4AAA-ACBA-529D23FAF7D0}" dt="2023-03-23T04:53:22.489" v="5"/>
      <pc:docMkLst>
        <pc:docMk/>
      </pc:docMkLst>
      <pc:sldChg chg="delSp">
        <pc:chgData name="Jake Kendrick" userId="S::21308325@student.uwa.edu.au::ab142299-a4dd-4def-8b03-8ee3e1d9a7dd" providerId="AD" clId="Web-{4B8B7ED1-59F9-4AAA-ACBA-529D23FAF7D0}" dt="2023-03-23T04:53:22.489" v="5"/>
        <pc:sldMkLst>
          <pc:docMk/>
          <pc:sldMk cId="109857222" sldId="256"/>
        </pc:sldMkLst>
        <pc:spChg chg="del">
          <ac:chgData name="Jake Kendrick" userId="S::21308325@student.uwa.edu.au::ab142299-a4dd-4def-8b03-8ee3e1d9a7dd" providerId="AD" clId="Web-{4B8B7ED1-59F9-4AAA-ACBA-529D23FAF7D0}" dt="2023-03-23T04:53:21.207" v="4"/>
          <ac:spMkLst>
            <pc:docMk/>
            <pc:sldMk cId="109857222" sldId="256"/>
            <ac:spMk id="8" creationId="{49AF7FBA-0E18-CB4F-B3BE-BE18C90D7AC9}"/>
          </ac:spMkLst>
        </pc:spChg>
        <pc:spChg chg="del">
          <ac:chgData name="Jake Kendrick" userId="S::21308325@student.uwa.edu.au::ab142299-a4dd-4def-8b03-8ee3e1d9a7dd" providerId="AD" clId="Web-{4B8B7ED1-59F9-4AAA-ACBA-529D23FAF7D0}" dt="2023-03-23T04:53:22.489" v="5"/>
          <ac:spMkLst>
            <pc:docMk/>
            <pc:sldMk cId="109857222" sldId="256"/>
            <ac:spMk id="16" creationId="{80964941-725D-582D-85CF-54E8FAAD5688}"/>
          </ac:spMkLst>
        </pc:spChg>
        <pc:picChg chg="del">
          <ac:chgData name="Jake Kendrick" userId="S::21308325@student.uwa.edu.au::ab142299-a4dd-4def-8b03-8ee3e1d9a7dd" providerId="AD" clId="Web-{4B8B7ED1-59F9-4AAA-ACBA-529D23FAF7D0}" dt="2023-03-23T04:53:10.144" v="0"/>
          <ac:picMkLst>
            <pc:docMk/>
            <pc:sldMk cId="109857222" sldId="256"/>
            <ac:picMk id="7" creationId="{B88E6ABA-78B8-3F49-417A-A1784A1552E1}"/>
          </ac:picMkLst>
        </pc:picChg>
        <pc:picChg chg="del">
          <ac:chgData name="Jake Kendrick" userId="S::21308325@student.uwa.edu.au::ab142299-a4dd-4def-8b03-8ee3e1d9a7dd" providerId="AD" clId="Web-{4B8B7ED1-59F9-4AAA-ACBA-529D23FAF7D0}" dt="2023-03-23T04:53:13.223" v="1"/>
          <ac:picMkLst>
            <pc:docMk/>
            <pc:sldMk cId="109857222" sldId="256"/>
            <ac:picMk id="9" creationId="{B78580BA-CA6C-E0AA-1F4E-8B6EE9A4EC2E}"/>
          </ac:picMkLst>
        </pc:picChg>
        <pc:picChg chg="del">
          <ac:chgData name="Jake Kendrick" userId="S::21308325@student.uwa.edu.au::ab142299-a4dd-4def-8b03-8ee3e1d9a7dd" providerId="AD" clId="Web-{4B8B7ED1-59F9-4AAA-ACBA-529D23FAF7D0}" dt="2023-03-23T04:53:14.520" v="3"/>
          <ac:picMkLst>
            <pc:docMk/>
            <pc:sldMk cId="109857222" sldId="256"/>
            <ac:picMk id="11" creationId="{6BE05963-DA49-5BEA-3DD4-BA88C3DA3C8D}"/>
          </ac:picMkLst>
        </pc:picChg>
        <pc:picChg chg="del">
          <ac:chgData name="Jake Kendrick" userId="S::21308325@student.uwa.edu.au::ab142299-a4dd-4def-8b03-8ee3e1d9a7dd" providerId="AD" clId="Web-{4B8B7ED1-59F9-4AAA-ACBA-529D23FAF7D0}" dt="2023-03-23T04:53:14.238" v="2"/>
          <ac:picMkLst>
            <pc:docMk/>
            <pc:sldMk cId="109857222" sldId="256"/>
            <ac:picMk id="14" creationId="{C1B7684E-4813-5A71-C5D5-92C5E7636AEF}"/>
          </ac:picMkLst>
        </pc:picChg>
      </pc:sldChg>
    </pc:docChg>
  </pc:docChgLst>
  <pc:docChgLst>
    <pc:chgData name="Jake Kendrick" userId="c9aa91da-2e15-46cf-a8c4-b4cee9b8e514" providerId="ADAL" clId="{6C47EE7B-D14A-B640-B63F-15FD0480AF3B}"/>
    <pc:docChg chg="modSld">
      <pc:chgData name="Jake Kendrick" userId="c9aa91da-2e15-46cf-a8c4-b4cee9b8e514" providerId="ADAL" clId="{6C47EE7B-D14A-B640-B63F-15FD0480AF3B}" dt="2023-04-17T07:08:00.172" v="1" actId="1076"/>
      <pc:docMkLst>
        <pc:docMk/>
      </pc:docMkLst>
      <pc:sldChg chg="modSp mod">
        <pc:chgData name="Jake Kendrick" userId="c9aa91da-2e15-46cf-a8c4-b4cee9b8e514" providerId="ADAL" clId="{6C47EE7B-D14A-B640-B63F-15FD0480AF3B}" dt="2023-04-17T07:08:00.172" v="1" actId="1076"/>
        <pc:sldMkLst>
          <pc:docMk/>
          <pc:sldMk cId="109857222" sldId="256"/>
        </pc:sldMkLst>
        <pc:picChg chg="mod">
          <ac:chgData name="Jake Kendrick" userId="c9aa91da-2e15-46cf-a8c4-b4cee9b8e514" providerId="ADAL" clId="{6C47EE7B-D14A-B640-B63F-15FD0480AF3B}" dt="2023-04-17T07:08:00.172" v="1" actId="1076"/>
          <ac:picMkLst>
            <pc:docMk/>
            <pc:sldMk cId="109857222" sldId="256"/>
            <ac:picMk id="5" creationId="{13FEBA5D-98B5-BD5E-A1E3-17D7DBF59A5C}"/>
          </ac:picMkLst>
        </pc:picChg>
        <pc:picChg chg="mod">
          <ac:chgData name="Jake Kendrick" userId="c9aa91da-2e15-46cf-a8c4-b4cee9b8e514" providerId="ADAL" clId="{6C47EE7B-D14A-B640-B63F-15FD0480AF3B}" dt="2023-04-17T06:23:48.239" v="0" actId="1076"/>
          <ac:picMkLst>
            <pc:docMk/>
            <pc:sldMk cId="109857222" sldId="256"/>
            <ac:picMk id="14" creationId="{1ABC57BB-7811-14DC-67C6-0012269BFF74}"/>
          </ac:picMkLst>
        </pc:picChg>
      </pc:sldChg>
    </pc:docChg>
  </pc:docChgLst>
  <pc:docChgLst>
    <pc:chgData name="Jake Kendrick" userId="S::21308325@student.uwa.edu.au::ab142299-a4dd-4def-8b03-8ee3e1d9a7dd" providerId="AD" clId="Web-{9A25FDF3-48D6-B8AD-6E63-84E9F4CB4DFE}"/>
    <pc:docChg chg="modSld">
      <pc:chgData name="Jake Kendrick" userId="S::21308325@student.uwa.edu.au::ab142299-a4dd-4def-8b03-8ee3e1d9a7dd" providerId="AD" clId="Web-{9A25FDF3-48D6-B8AD-6E63-84E9F4CB4DFE}" dt="2023-09-28T11:59:48.409" v="3"/>
      <pc:docMkLst>
        <pc:docMk/>
      </pc:docMkLst>
      <pc:sldChg chg="addSp modSp">
        <pc:chgData name="Jake Kendrick" userId="S::21308325@student.uwa.edu.au::ab142299-a4dd-4def-8b03-8ee3e1d9a7dd" providerId="AD" clId="Web-{9A25FDF3-48D6-B8AD-6E63-84E9F4CB4DFE}" dt="2023-09-28T11:59:48.409" v="3"/>
        <pc:sldMkLst>
          <pc:docMk/>
          <pc:sldMk cId="109857222" sldId="256"/>
        </pc:sldMkLst>
        <pc:picChg chg="add mod">
          <ac:chgData name="Jake Kendrick" userId="S::21308325@student.uwa.edu.au::ab142299-a4dd-4def-8b03-8ee3e1d9a7dd" providerId="AD" clId="Web-{9A25FDF3-48D6-B8AD-6E63-84E9F4CB4DFE}" dt="2023-09-28T11:56:50.131" v="2"/>
          <ac:picMkLst>
            <pc:docMk/>
            <pc:sldMk cId="109857222" sldId="256"/>
            <ac:picMk id="3" creationId="{B7BCCCC1-74AC-0FF5-36CE-0181F35A3917}"/>
          </ac:picMkLst>
        </pc:picChg>
        <pc:picChg chg="add mod">
          <ac:chgData name="Jake Kendrick" userId="S::21308325@student.uwa.edu.au::ab142299-a4dd-4def-8b03-8ee3e1d9a7dd" providerId="AD" clId="Web-{9A25FDF3-48D6-B8AD-6E63-84E9F4CB4DFE}" dt="2023-09-28T11:59:48.409" v="3"/>
          <ac:picMkLst>
            <pc:docMk/>
            <pc:sldMk cId="109857222" sldId="256"/>
            <ac:picMk id="5" creationId="{977180E6-C268-ABFB-2E4F-53D3AA20B421}"/>
          </ac:picMkLst>
        </pc:picChg>
        <pc:picChg chg="add mod">
          <ac:chgData name="Jake Kendrick" userId="S::21308325@student.uwa.edu.au::ab142299-a4dd-4def-8b03-8ee3e1d9a7dd" providerId="AD" clId="Web-{9A25FDF3-48D6-B8AD-6E63-84E9F4CB4DFE}" dt="2023-09-28T11:52:11.815" v="0"/>
          <ac:picMkLst>
            <pc:docMk/>
            <pc:sldMk cId="109857222" sldId="256"/>
            <ac:picMk id="14" creationId="{BBE2731B-A5A1-7545-B9E3-B01B473E1634}"/>
          </ac:picMkLst>
        </pc:picChg>
        <pc:picChg chg="add mod">
          <ac:chgData name="Jake Kendrick" userId="S::21308325@student.uwa.edu.au::ab142299-a4dd-4def-8b03-8ee3e1d9a7dd" providerId="AD" clId="Web-{9A25FDF3-48D6-B8AD-6E63-84E9F4CB4DFE}" dt="2023-09-28T11:53:25.414" v="1"/>
          <ac:picMkLst>
            <pc:docMk/>
            <pc:sldMk cId="109857222" sldId="256"/>
            <ac:picMk id="16" creationId="{63EA3BCA-1D1C-EB6D-F52A-7EAC7F7D2AAC}"/>
          </ac:picMkLst>
        </pc:picChg>
      </pc:sldChg>
    </pc:docChg>
  </pc:docChgLst>
  <pc:docChgLst>
    <pc:chgData name="Jake Kendrick" userId="ab142299-a4dd-4def-8b03-8ee3e1d9a7dd" providerId="ADAL" clId="{25649298-DD26-4F4D-B18D-C527EF47EC56}"/>
    <pc:docChg chg="modSld">
      <pc:chgData name="Jake Kendrick" userId="ab142299-a4dd-4def-8b03-8ee3e1d9a7dd" providerId="ADAL" clId="{25649298-DD26-4F4D-B18D-C527EF47EC56}" dt="2023-05-04T05:21:17.640" v="34" actId="14100"/>
      <pc:docMkLst>
        <pc:docMk/>
      </pc:docMkLst>
      <pc:sldChg chg="addSp modSp mod">
        <pc:chgData name="Jake Kendrick" userId="ab142299-a4dd-4def-8b03-8ee3e1d9a7dd" providerId="ADAL" clId="{25649298-DD26-4F4D-B18D-C527EF47EC56}" dt="2023-05-04T05:21:17.640" v="34" actId="14100"/>
        <pc:sldMkLst>
          <pc:docMk/>
          <pc:sldMk cId="109857222" sldId="256"/>
        </pc:sldMkLst>
        <pc:spChg chg="add mod">
          <ac:chgData name="Jake Kendrick" userId="ab142299-a4dd-4def-8b03-8ee3e1d9a7dd" providerId="ADAL" clId="{25649298-DD26-4F4D-B18D-C527EF47EC56}" dt="2023-05-04T05:17:52.067" v="19" actId="1076"/>
          <ac:spMkLst>
            <pc:docMk/>
            <pc:sldMk cId="109857222" sldId="256"/>
            <ac:spMk id="8" creationId="{041D0248-A10B-9F46-5A61-C090DA7913F3}"/>
          </ac:spMkLst>
        </pc:spChg>
        <pc:spChg chg="add mod">
          <ac:chgData name="Jake Kendrick" userId="ab142299-a4dd-4def-8b03-8ee3e1d9a7dd" providerId="ADAL" clId="{25649298-DD26-4F4D-B18D-C527EF47EC56}" dt="2023-05-04T05:18:59.540" v="24" actId="20577"/>
          <ac:spMkLst>
            <pc:docMk/>
            <pc:sldMk cId="109857222" sldId="256"/>
            <ac:spMk id="9" creationId="{6C3B6FDF-F768-36A2-9015-C260E85FB4D9}"/>
          </ac:spMkLst>
        </pc:spChg>
        <pc:spChg chg="add mod">
          <ac:chgData name="Jake Kendrick" userId="ab142299-a4dd-4def-8b03-8ee3e1d9a7dd" providerId="ADAL" clId="{25649298-DD26-4F4D-B18D-C527EF47EC56}" dt="2023-05-04T05:19:46.704" v="29" actId="20577"/>
          <ac:spMkLst>
            <pc:docMk/>
            <pc:sldMk cId="109857222" sldId="256"/>
            <ac:spMk id="10" creationId="{DF6790C0-0DCA-2251-715A-2652703863E9}"/>
          </ac:spMkLst>
        </pc:spChg>
        <pc:spChg chg="add mod">
          <ac:chgData name="Jake Kendrick" userId="ab142299-a4dd-4def-8b03-8ee3e1d9a7dd" providerId="ADAL" clId="{25649298-DD26-4F4D-B18D-C527EF47EC56}" dt="2023-05-04T05:19:48.911" v="31" actId="20577"/>
          <ac:spMkLst>
            <pc:docMk/>
            <pc:sldMk cId="109857222" sldId="256"/>
            <ac:spMk id="11" creationId="{FBF1C41F-63C6-7F23-2E67-7A5EC0A32D6A}"/>
          </ac:spMkLst>
        </pc:spChg>
        <pc:graphicFrameChg chg="mod modGraphic">
          <ac:chgData name="Jake Kendrick" userId="ab142299-a4dd-4def-8b03-8ee3e1d9a7dd" providerId="ADAL" clId="{25649298-DD26-4F4D-B18D-C527EF47EC56}" dt="2023-05-04T05:16:42.903" v="8" actId="1076"/>
          <ac:graphicFrameMkLst>
            <pc:docMk/>
            <pc:sldMk cId="109857222" sldId="256"/>
            <ac:graphicFrameMk id="7" creationId="{277382E6-C6E4-6D8E-B6CB-723A91E54FAC}"/>
          </ac:graphicFrameMkLst>
        </pc:graphicFrameChg>
        <pc:picChg chg="mod">
          <ac:chgData name="Jake Kendrick" userId="ab142299-a4dd-4def-8b03-8ee3e1d9a7dd" providerId="ADAL" clId="{25649298-DD26-4F4D-B18D-C527EF47EC56}" dt="2023-05-04T05:21:17.640" v="34" actId="14100"/>
          <ac:picMkLst>
            <pc:docMk/>
            <pc:sldMk cId="109857222" sldId="256"/>
            <ac:picMk id="3" creationId="{E8F764C4-D6FF-C1CE-BFD9-596111DAFC0C}"/>
          </ac:picMkLst>
        </pc:picChg>
        <pc:picChg chg="mod">
          <ac:chgData name="Jake Kendrick" userId="ab142299-a4dd-4def-8b03-8ee3e1d9a7dd" providerId="ADAL" clId="{25649298-DD26-4F4D-B18D-C527EF47EC56}" dt="2023-05-04T05:16:30.201" v="7" actId="1076"/>
          <ac:picMkLst>
            <pc:docMk/>
            <pc:sldMk cId="109857222" sldId="256"/>
            <ac:picMk id="4" creationId="{42A5408E-8D63-B43B-E4A4-8E3F4E4FB538}"/>
          </ac:picMkLst>
        </pc:picChg>
        <pc:picChg chg="mod">
          <ac:chgData name="Jake Kendrick" userId="ab142299-a4dd-4def-8b03-8ee3e1d9a7dd" providerId="ADAL" clId="{25649298-DD26-4F4D-B18D-C527EF47EC56}" dt="2023-05-04T05:19:38.049" v="27" actId="1076"/>
          <ac:picMkLst>
            <pc:docMk/>
            <pc:sldMk cId="109857222" sldId="256"/>
            <ac:picMk id="5" creationId="{13FEBA5D-98B5-BD5E-A1E3-17D7DBF59A5C}"/>
          </ac:picMkLst>
        </pc:picChg>
        <pc:picChg chg="mod">
          <ac:chgData name="Jake Kendrick" userId="ab142299-a4dd-4def-8b03-8ee3e1d9a7dd" providerId="ADAL" clId="{25649298-DD26-4F4D-B18D-C527EF47EC56}" dt="2023-05-04T05:16:42.903" v="8" actId="1076"/>
          <ac:picMkLst>
            <pc:docMk/>
            <pc:sldMk cId="109857222" sldId="256"/>
            <ac:picMk id="6" creationId="{B919A257-4724-3984-FC02-16DECF9DA3E1}"/>
          </ac:picMkLst>
        </pc:picChg>
        <pc:picChg chg="mod">
          <ac:chgData name="Jake Kendrick" userId="ab142299-a4dd-4def-8b03-8ee3e1d9a7dd" providerId="ADAL" clId="{25649298-DD26-4F4D-B18D-C527EF47EC56}" dt="2023-05-04T05:16:42.903" v="8" actId="1076"/>
          <ac:picMkLst>
            <pc:docMk/>
            <pc:sldMk cId="109857222" sldId="256"/>
            <ac:picMk id="17" creationId="{48672E4C-F164-1CC7-B618-3D75C583825D}"/>
          </ac:picMkLst>
        </pc:picChg>
      </pc:sldChg>
    </pc:docChg>
  </pc:docChgLst>
  <pc:docChgLst>
    <pc:chgData name="Jake Kendrick" userId="S::21308325@student.uwa.edu.au::ab142299-a4dd-4def-8b03-8ee3e1d9a7dd" providerId="AD" clId="Web-{2260643A-B1E9-17F4-5A9C-56531C9CA807}"/>
    <pc:docChg chg="modSld">
      <pc:chgData name="Jake Kendrick" userId="S::21308325@student.uwa.edu.au::ab142299-a4dd-4def-8b03-8ee3e1d9a7dd" providerId="AD" clId="Web-{2260643A-B1E9-17F4-5A9C-56531C9CA807}" dt="2023-05-04T05:26:19.658" v="15" actId="1076"/>
      <pc:docMkLst>
        <pc:docMk/>
      </pc:docMkLst>
      <pc:sldChg chg="addSp delSp modSp">
        <pc:chgData name="Jake Kendrick" userId="S::21308325@student.uwa.edu.au::ab142299-a4dd-4def-8b03-8ee3e1d9a7dd" providerId="AD" clId="Web-{2260643A-B1E9-17F4-5A9C-56531C9CA807}" dt="2023-05-04T05:26:19.658" v="15" actId="1076"/>
        <pc:sldMkLst>
          <pc:docMk/>
          <pc:sldMk cId="109857222" sldId="256"/>
        </pc:sldMkLst>
        <pc:picChg chg="mod">
          <ac:chgData name="Jake Kendrick" userId="S::21308325@student.uwa.edu.au::ab142299-a4dd-4def-8b03-8ee3e1d9a7dd" providerId="AD" clId="Web-{2260643A-B1E9-17F4-5A9C-56531C9CA807}" dt="2023-05-04T05:26:19.658" v="15" actId="1076"/>
          <ac:picMkLst>
            <pc:docMk/>
            <pc:sldMk cId="109857222" sldId="256"/>
            <ac:picMk id="3" creationId="{E8F764C4-D6FF-C1CE-BFD9-596111DAFC0C}"/>
          </ac:picMkLst>
        </pc:picChg>
        <pc:picChg chg="add del mod">
          <ac:chgData name="Jake Kendrick" userId="S::21308325@student.uwa.edu.au::ab142299-a4dd-4def-8b03-8ee3e1d9a7dd" providerId="AD" clId="Web-{2260643A-B1E9-17F4-5A9C-56531C9CA807}" dt="2023-05-04T05:23:06.388" v="3"/>
          <ac:picMkLst>
            <pc:docMk/>
            <pc:sldMk cId="109857222" sldId="256"/>
            <ac:picMk id="13" creationId="{5571C695-10CA-D5B4-D844-B0A92692EDF8}"/>
          </ac:picMkLst>
        </pc:picChg>
        <pc:picChg chg="add del mod">
          <ac:chgData name="Jake Kendrick" userId="S::21308325@student.uwa.edu.au::ab142299-a4dd-4def-8b03-8ee3e1d9a7dd" providerId="AD" clId="Web-{2260643A-B1E9-17F4-5A9C-56531C9CA807}" dt="2023-05-04T05:23:36.279" v="13"/>
          <ac:picMkLst>
            <pc:docMk/>
            <pc:sldMk cId="109857222" sldId="256"/>
            <ac:picMk id="14" creationId="{EC48A5D4-888B-3B10-87E8-6E4DA076BA3C}"/>
          </ac:picMkLst>
        </pc:picChg>
      </pc:sldChg>
    </pc:docChg>
  </pc:docChgLst>
  <pc:docChgLst>
    <pc:chgData name="Jake Kendrick" userId="S::21308325@student.uwa.edu.au::ab142299-a4dd-4def-8b03-8ee3e1d9a7dd" providerId="AD" clId="Web-{129B7036-A487-4283-AEBC-0E151928EE2F}"/>
    <pc:docChg chg="modSld">
      <pc:chgData name="Jake Kendrick" userId="S::21308325@student.uwa.edu.au::ab142299-a4dd-4def-8b03-8ee3e1d9a7dd" providerId="AD" clId="Web-{129B7036-A487-4283-AEBC-0E151928EE2F}" dt="2022-12-30T01:00:12.775" v="63" actId="1076"/>
      <pc:docMkLst>
        <pc:docMk/>
      </pc:docMkLst>
      <pc:sldChg chg="addSp delSp modSp">
        <pc:chgData name="Jake Kendrick" userId="S::21308325@student.uwa.edu.au::ab142299-a4dd-4def-8b03-8ee3e1d9a7dd" providerId="AD" clId="Web-{129B7036-A487-4283-AEBC-0E151928EE2F}" dt="2022-12-30T01:00:12.775" v="63" actId="1076"/>
        <pc:sldMkLst>
          <pc:docMk/>
          <pc:sldMk cId="109857222" sldId="256"/>
        </pc:sldMkLst>
        <pc:spChg chg="del mod">
          <ac:chgData name="Jake Kendrick" userId="S::21308325@student.uwa.edu.au::ab142299-a4dd-4def-8b03-8ee3e1d9a7dd" providerId="AD" clId="Web-{129B7036-A487-4283-AEBC-0E151928EE2F}" dt="2022-12-30T01:00:06.556" v="62"/>
          <ac:spMkLst>
            <pc:docMk/>
            <pc:sldMk cId="109857222" sldId="256"/>
            <ac:spMk id="4" creationId="{10C2DED3-698D-7ED0-B399-35C69A59F96F}"/>
          </ac:spMkLst>
        </pc:spChg>
        <pc:spChg chg="mod ord">
          <ac:chgData name="Jake Kendrick" userId="S::21308325@student.uwa.edu.au::ab142299-a4dd-4def-8b03-8ee3e1d9a7dd" providerId="AD" clId="Web-{129B7036-A487-4283-AEBC-0E151928EE2F}" dt="2022-12-30T00:43:40.603" v="46" actId="1076"/>
          <ac:spMkLst>
            <pc:docMk/>
            <pc:sldMk cId="109857222" sldId="256"/>
            <ac:spMk id="8" creationId="{49AF7FBA-0E18-CB4F-B3BE-BE18C90D7AC9}"/>
          </ac:spMkLst>
        </pc:spChg>
        <pc:spChg chg="mod">
          <ac:chgData name="Jake Kendrick" userId="S::21308325@student.uwa.edu.au::ab142299-a4dd-4def-8b03-8ee3e1d9a7dd" providerId="AD" clId="Web-{129B7036-A487-4283-AEBC-0E151928EE2F}" dt="2022-12-30T00:41:38.505" v="36" actId="1076"/>
          <ac:spMkLst>
            <pc:docMk/>
            <pc:sldMk cId="109857222" sldId="256"/>
            <ac:spMk id="12" creationId="{CBAAA63C-1BA9-DA4A-A878-9EC83D20AC07}"/>
          </ac:spMkLst>
        </pc:spChg>
        <pc:spChg chg="mod">
          <ac:chgData name="Jake Kendrick" userId="S::21308325@student.uwa.edu.au::ab142299-a4dd-4def-8b03-8ee3e1d9a7dd" providerId="AD" clId="Web-{129B7036-A487-4283-AEBC-0E151928EE2F}" dt="2022-12-30T01:00:12.775" v="63" actId="1076"/>
          <ac:spMkLst>
            <pc:docMk/>
            <pc:sldMk cId="109857222" sldId="256"/>
            <ac:spMk id="13" creationId="{A9A32FB2-2064-654E-9855-BDC1D5C342CA}"/>
          </ac:spMkLst>
        </pc:spChg>
        <pc:spChg chg="add mod">
          <ac:chgData name="Jake Kendrick" userId="S::21308325@student.uwa.edu.au::ab142299-a4dd-4def-8b03-8ee3e1d9a7dd" providerId="AD" clId="Web-{129B7036-A487-4283-AEBC-0E151928EE2F}" dt="2022-12-30T00:45:33.091" v="58" actId="1076"/>
          <ac:spMkLst>
            <pc:docMk/>
            <pc:sldMk cId="109857222" sldId="256"/>
            <ac:spMk id="16" creationId="{80964941-725D-582D-85CF-54E8FAAD5688}"/>
          </ac:spMkLst>
        </pc:spChg>
        <pc:picChg chg="del mod">
          <ac:chgData name="Jake Kendrick" userId="S::21308325@student.uwa.edu.au::ab142299-a4dd-4def-8b03-8ee3e1d9a7dd" providerId="AD" clId="Web-{129B7036-A487-4283-AEBC-0E151928EE2F}" dt="2022-12-30T00:46:50.781" v="61"/>
          <ac:picMkLst>
            <pc:docMk/>
            <pc:sldMk cId="109857222" sldId="256"/>
            <ac:picMk id="2" creationId="{A01C2D52-27EF-673E-93AD-928A3BE60015}"/>
          </ac:picMkLst>
        </pc:picChg>
        <pc:picChg chg="del mod">
          <ac:chgData name="Jake Kendrick" userId="S::21308325@student.uwa.edu.au::ab142299-a4dd-4def-8b03-8ee3e1d9a7dd" providerId="AD" clId="Web-{129B7036-A487-4283-AEBC-0E151928EE2F}" dt="2022-12-30T00:46:49.531" v="60"/>
          <ac:picMkLst>
            <pc:docMk/>
            <pc:sldMk cId="109857222" sldId="256"/>
            <ac:picMk id="3" creationId="{661A1E88-944A-AB5F-978C-33994634841E}"/>
          </ac:picMkLst>
        </pc:picChg>
        <pc:picChg chg="add del mod">
          <ac:chgData name="Jake Kendrick" userId="S::21308325@student.uwa.edu.au::ab142299-a4dd-4def-8b03-8ee3e1d9a7dd" providerId="AD" clId="Web-{129B7036-A487-4283-AEBC-0E151928EE2F}" dt="2022-12-30T00:34:57.875" v="7"/>
          <ac:picMkLst>
            <pc:docMk/>
            <pc:sldMk cId="109857222" sldId="256"/>
            <ac:picMk id="5" creationId="{A83FB03C-DDC2-EED4-37A9-6E3D6C87CB30}"/>
          </ac:picMkLst>
        </pc:picChg>
        <pc:picChg chg="del mod">
          <ac:chgData name="Jake Kendrick" userId="S::21308325@student.uwa.edu.au::ab142299-a4dd-4def-8b03-8ee3e1d9a7dd" providerId="AD" clId="Web-{129B7036-A487-4283-AEBC-0E151928EE2F}" dt="2022-12-30T00:46:48.156" v="59"/>
          <ac:picMkLst>
            <pc:docMk/>
            <pc:sldMk cId="109857222" sldId="256"/>
            <ac:picMk id="6" creationId="{C8430E77-9396-9DD5-0C58-64C6EC5B5743}"/>
          </ac:picMkLst>
        </pc:picChg>
        <pc:picChg chg="add mod">
          <ac:chgData name="Jake Kendrick" userId="S::21308325@student.uwa.edu.au::ab142299-a4dd-4def-8b03-8ee3e1d9a7dd" providerId="AD" clId="Web-{129B7036-A487-4283-AEBC-0E151928EE2F}" dt="2022-12-30T00:37:01.847" v="10" actId="1076"/>
          <ac:picMkLst>
            <pc:docMk/>
            <pc:sldMk cId="109857222" sldId="256"/>
            <ac:picMk id="7" creationId="{B88E6ABA-78B8-3F49-417A-A1784A1552E1}"/>
          </ac:picMkLst>
        </pc:picChg>
        <pc:picChg chg="add mod">
          <ac:chgData name="Jake Kendrick" userId="S::21308325@student.uwa.edu.au::ab142299-a4dd-4def-8b03-8ee3e1d9a7dd" providerId="AD" clId="Web-{129B7036-A487-4283-AEBC-0E151928EE2F}" dt="2022-12-30T00:45:19.450" v="57" actId="1076"/>
          <ac:picMkLst>
            <pc:docMk/>
            <pc:sldMk cId="109857222" sldId="256"/>
            <ac:picMk id="9" creationId="{B78580BA-CA6C-E0AA-1F4E-8B6EE9A4EC2E}"/>
          </ac:picMkLst>
        </pc:picChg>
        <pc:picChg chg="add mod modCrop">
          <ac:chgData name="Jake Kendrick" userId="S::21308325@student.uwa.edu.au::ab142299-a4dd-4def-8b03-8ee3e1d9a7dd" providerId="AD" clId="Web-{129B7036-A487-4283-AEBC-0E151928EE2F}" dt="2022-12-30T00:45:09.371" v="54" actId="1076"/>
          <ac:picMkLst>
            <pc:docMk/>
            <pc:sldMk cId="109857222" sldId="256"/>
            <ac:picMk id="11" creationId="{6BE05963-DA49-5BEA-3DD4-BA88C3DA3C8D}"/>
          </ac:picMkLst>
        </pc:picChg>
        <pc:picChg chg="add mod modCrop">
          <ac:chgData name="Jake Kendrick" userId="S::21308325@student.uwa.edu.au::ab142299-a4dd-4def-8b03-8ee3e1d9a7dd" providerId="AD" clId="Web-{129B7036-A487-4283-AEBC-0E151928EE2F}" dt="2022-12-30T00:44:42.277" v="51" actId="1076"/>
          <ac:picMkLst>
            <pc:docMk/>
            <pc:sldMk cId="109857222" sldId="256"/>
            <ac:picMk id="14" creationId="{C1B7684E-4813-5A71-C5D5-92C5E7636AEF}"/>
          </ac:picMkLst>
        </pc:picChg>
      </pc:sldChg>
    </pc:docChg>
  </pc:docChgLst>
  <pc:docChgLst>
    <pc:chgData name="Jake Kendrick" userId="S::21308325@student.uwa.edu.au::ab142299-a4dd-4def-8b03-8ee3e1d9a7dd" providerId="AD" clId="Web-{AAE6C946-4136-31A2-869C-DEFE42913482}"/>
    <pc:docChg chg="modSld">
      <pc:chgData name="Jake Kendrick" userId="S::21308325@student.uwa.edu.au::ab142299-a4dd-4def-8b03-8ee3e1d9a7dd" providerId="AD" clId="Web-{AAE6C946-4136-31A2-869C-DEFE42913482}" dt="2023-05-30T23:59:31.521" v="132"/>
      <pc:docMkLst>
        <pc:docMk/>
      </pc:docMkLst>
      <pc:sldChg chg="addSp delSp modSp">
        <pc:chgData name="Jake Kendrick" userId="S::21308325@student.uwa.edu.au::ab142299-a4dd-4def-8b03-8ee3e1d9a7dd" providerId="AD" clId="Web-{AAE6C946-4136-31A2-869C-DEFE42913482}" dt="2023-05-30T23:59:31.521" v="132"/>
        <pc:sldMkLst>
          <pc:docMk/>
          <pc:sldMk cId="109857222" sldId="256"/>
        </pc:sldMkLst>
        <pc:graphicFrameChg chg="mod modGraphic">
          <ac:chgData name="Jake Kendrick" userId="S::21308325@student.uwa.edu.au::ab142299-a4dd-4def-8b03-8ee3e1d9a7dd" providerId="AD" clId="Web-{AAE6C946-4136-31A2-869C-DEFE42913482}" dt="2023-05-30T23:59:31.521" v="132"/>
          <ac:graphicFrameMkLst>
            <pc:docMk/>
            <pc:sldMk cId="109857222" sldId="256"/>
            <ac:graphicFrameMk id="7" creationId="{277382E6-C6E4-6D8E-B6CB-723A91E54FAC}"/>
          </ac:graphicFrameMkLst>
        </pc:graphicFrameChg>
        <pc:picChg chg="del">
          <ac:chgData name="Jake Kendrick" userId="S::21308325@student.uwa.edu.au::ab142299-a4dd-4def-8b03-8ee3e1d9a7dd" providerId="AD" clId="Web-{AAE6C946-4136-31A2-869C-DEFE42913482}" dt="2023-05-30T23:47:05.411" v="4"/>
          <ac:picMkLst>
            <pc:docMk/>
            <pc:sldMk cId="109857222" sldId="256"/>
            <ac:picMk id="3" creationId="{E8F764C4-D6FF-C1CE-BFD9-596111DAFC0C}"/>
          </ac:picMkLst>
        </pc:picChg>
        <pc:picChg chg="del">
          <ac:chgData name="Jake Kendrick" userId="S::21308325@student.uwa.edu.au::ab142299-a4dd-4def-8b03-8ee3e1d9a7dd" providerId="AD" clId="Web-{AAE6C946-4136-31A2-869C-DEFE42913482}" dt="2023-05-30T23:47:03.895" v="2"/>
          <ac:picMkLst>
            <pc:docMk/>
            <pc:sldMk cId="109857222" sldId="256"/>
            <ac:picMk id="4" creationId="{42A5408E-8D63-B43B-E4A4-8E3F4E4FB538}"/>
          </ac:picMkLst>
        </pc:picChg>
        <pc:picChg chg="del">
          <ac:chgData name="Jake Kendrick" userId="S::21308325@student.uwa.edu.au::ab142299-a4dd-4def-8b03-8ee3e1d9a7dd" providerId="AD" clId="Web-{AAE6C946-4136-31A2-869C-DEFE42913482}" dt="2023-05-30T23:47:04.692" v="3"/>
          <ac:picMkLst>
            <pc:docMk/>
            <pc:sldMk cId="109857222" sldId="256"/>
            <ac:picMk id="5" creationId="{13FEBA5D-98B5-BD5E-A1E3-17D7DBF59A5C}"/>
          </ac:picMkLst>
        </pc:picChg>
        <pc:picChg chg="del">
          <ac:chgData name="Jake Kendrick" userId="S::21308325@student.uwa.edu.au::ab142299-a4dd-4def-8b03-8ee3e1d9a7dd" providerId="AD" clId="Web-{AAE6C946-4136-31A2-869C-DEFE42913482}" dt="2023-05-30T23:47:00.504" v="0"/>
          <ac:picMkLst>
            <pc:docMk/>
            <pc:sldMk cId="109857222" sldId="256"/>
            <ac:picMk id="6" creationId="{B919A257-4724-3984-FC02-16DECF9DA3E1}"/>
          </ac:picMkLst>
        </pc:picChg>
        <pc:picChg chg="add mod">
          <ac:chgData name="Jake Kendrick" userId="S::21308325@student.uwa.edu.au::ab142299-a4dd-4def-8b03-8ee3e1d9a7dd" providerId="AD" clId="Web-{AAE6C946-4136-31A2-869C-DEFE42913482}" dt="2023-05-30T23:47:30.849" v="6" actId="1076"/>
          <ac:picMkLst>
            <pc:docMk/>
            <pc:sldMk cId="109857222" sldId="256"/>
            <ac:picMk id="14" creationId="{4805575D-724B-0721-19D5-7969E57983AD}"/>
          </ac:picMkLst>
        </pc:picChg>
        <pc:picChg chg="add mod">
          <ac:chgData name="Jake Kendrick" userId="S::21308325@student.uwa.edu.au::ab142299-a4dd-4def-8b03-8ee3e1d9a7dd" providerId="AD" clId="Web-{AAE6C946-4136-31A2-869C-DEFE42913482}" dt="2023-05-30T23:56:07.345" v="32" actId="1076"/>
          <ac:picMkLst>
            <pc:docMk/>
            <pc:sldMk cId="109857222" sldId="256"/>
            <ac:picMk id="16" creationId="{075F939F-35E1-9D5B-02A2-E44724D26402}"/>
          </ac:picMkLst>
        </pc:picChg>
        <pc:picChg chg="del">
          <ac:chgData name="Jake Kendrick" userId="S::21308325@student.uwa.edu.au::ab142299-a4dd-4def-8b03-8ee3e1d9a7dd" providerId="AD" clId="Web-{AAE6C946-4136-31A2-869C-DEFE42913482}" dt="2023-05-30T23:47:03.114" v="1"/>
          <ac:picMkLst>
            <pc:docMk/>
            <pc:sldMk cId="109857222" sldId="256"/>
            <ac:picMk id="17" creationId="{48672E4C-F164-1CC7-B618-3D75C583825D}"/>
          </ac:picMkLst>
        </pc:picChg>
        <pc:picChg chg="add mod">
          <ac:chgData name="Jake Kendrick" userId="S::21308325@student.uwa.edu.au::ab142299-a4dd-4def-8b03-8ee3e1d9a7dd" providerId="AD" clId="Web-{AAE6C946-4136-31A2-869C-DEFE42913482}" dt="2023-05-30T23:53:10.106" v="29" actId="1076"/>
          <ac:picMkLst>
            <pc:docMk/>
            <pc:sldMk cId="109857222" sldId="256"/>
            <ac:picMk id="18" creationId="{9F50A6FB-A4FA-2BD4-D64C-BFB76E471CCC}"/>
          </ac:picMkLst>
        </pc:picChg>
        <pc:picChg chg="add mod">
          <ac:chgData name="Jake Kendrick" userId="S::21308325@student.uwa.edu.au::ab142299-a4dd-4def-8b03-8ee3e1d9a7dd" providerId="AD" clId="Web-{AAE6C946-4136-31A2-869C-DEFE42913482}" dt="2023-05-30T23:55:09.640" v="31" actId="1076"/>
          <ac:picMkLst>
            <pc:docMk/>
            <pc:sldMk cId="109857222" sldId="256"/>
            <ac:picMk id="19" creationId="{E4887A76-AD79-132E-7654-130AC7EEFA43}"/>
          </ac:picMkLst>
        </pc:picChg>
      </pc:sldChg>
      <pc:sldChg chg="modSp">
        <pc:chgData name="Jake Kendrick" userId="S::21308325@student.uwa.edu.au::ab142299-a4dd-4def-8b03-8ee3e1d9a7dd" providerId="AD" clId="Web-{AAE6C946-4136-31A2-869C-DEFE42913482}" dt="2023-05-30T23:48:02.599" v="22" actId="20577"/>
        <pc:sldMkLst>
          <pc:docMk/>
          <pc:sldMk cId="169461359" sldId="257"/>
        </pc:sldMkLst>
        <pc:spChg chg="mod">
          <ac:chgData name="Jake Kendrick" userId="S::21308325@student.uwa.edu.au::ab142299-a4dd-4def-8b03-8ee3e1d9a7dd" providerId="AD" clId="Web-{AAE6C946-4136-31A2-869C-DEFE42913482}" dt="2023-05-30T23:48:02.599" v="22" actId="20577"/>
          <ac:spMkLst>
            <pc:docMk/>
            <pc:sldMk cId="169461359" sldId="257"/>
            <ac:spMk id="4" creationId="{DA2CAD60-077B-2071-8974-928108A43881}"/>
          </ac:spMkLst>
        </pc:spChg>
      </pc:sldChg>
    </pc:docChg>
  </pc:docChgLst>
  <pc:docChgLst>
    <pc:chgData name="Jake Kendrick" userId="S::21308325@student.uwa.edu.au::ab142299-a4dd-4def-8b03-8ee3e1d9a7dd" providerId="AD" clId="Web-{C03803D1-1C85-5D23-C361-C88872B49E3E}"/>
    <pc:docChg chg="modSld">
      <pc:chgData name="Jake Kendrick" userId="S::21308325@student.uwa.edu.au::ab142299-a4dd-4def-8b03-8ee3e1d9a7dd" providerId="AD" clId="Web-{C03803D1-1C85-5D23-C361-C88872B49E3E}" dt="2023-04-13T01:47:22.198" v="30" actId="1076"/>
      <pc:docMkLst>
        <pc:docMk/>
      </pc:docMkLst>
      <pc:sldChg chg="addSp delSp modSp">
        <pc:chgData name="Jake Kendrick" userId="S::21308325@student.uwa.edu.au::ab142299-a4dd-4def-8b03-8ee3e1d9a7dd" providerId="AD" clId="Web-{C03803D1-1C85-5D23-C361-C88872B49E3E}" dt="2023-04-13T01:47:22.198" v="30" actId="1076"/>
        <pc:sldMkLst>
          <pc:docMk/>
          <pc:sldMk cId="109857222" sldId="256"/>
        </pc:sldMkLst>
        <pc:picChg chg="del mod">
          <ac:chgData name="Jake Kendrick" userId="S::21308325@student.uwa.edu.au::ab142299-a4dd-4def-8b03-8ee3e1d9a7dd" providerId="AD" clId="Web-{C03803D1-1C85-5D23-C361-C88872B49E3E}" dt="2023-04-12T23:14:56.554" v="20"/>
          <ac:picMkLst>
            <pc:docMk/>
            <pc:sldMk cId="109857222" sldId="256"/>
            <ac:picMk id="3" creationId="{29DC028C-C003-0D26-6833-956F84B48A13}"/>
          </ac:picMkLst>
        </pc:picChg>
        <pc:picChg chg="add mod">
          <ac:chgData name="Jake Kendrick" userId="S::21308325@student.uwa.edu.au::ab142299-a4dd-4def-8b03-8ee3e1d9a7dd" providerId="AD" clId="Web-{C03803D1-1C85-5D23-C361-C88872B49E3E}" dt="2023-04-13T01:45:31.410" v="28" actId="1076"/>
          <ac:picMkLst>
            <pc:docMk/>
            <pc:sldMk cId="109857222" sldId="256"/>
            <ac:picMk id="3" creationId="{D4FCBEE6-8C41-CF50-C664-5CE7048A8A46}"/>
          </ac:picMkLst>
        </pc:picChg>
        <pc:picChg chg="add mod">
          <ac:chgData name="Jake Kendrick" userId="S::21308325@student.uwa.edu.au::ab142299-a4dd-4def-8b03-8ee3e1d9a7dd" providerId="AD" clId="Web-{C03803D1-1C85-5D23-C361-C88872B49E3E}" dt="2023-04-13T01:47:22.198" v="30" actId="1076"/>
          <ac:picMkLst>
            <pc:docMk/>
            <pc:sldMk cId="109857222" sldId="256"/>
            <ac:picMk id="4" creationId="{3778CDEF-44B7-F2C1-0189-6FCA3A94E4CF}"/>
          </ac:picMkLst>
        </pc:picChg>
        <pc:picChg chg="add del mod">
          <ac:chgData name="Jake Kendrick" userId="S::21308325@student.uwa.edu.au::ab142299-a4dd-4def-8b03-8ee3e1d9a7dd" providerId="AD" clId="Web-{C03803D1-1C85-5D23-C361-C88872B49E3E}" dt="2023-04-12T23:14:54.382" v="19"/>
          <ac:picMkLst>
            <pc:docMk/>
            <pc:sldMk cId="109857222" sldId="256"/>
            <ac:picMk id="4" creationId="{4E05FCDF-F04F-DB15-25E4-56D5DAFF29F4}"/>
          </ac:picMkLst>
        </pc:picChg>
        <pc:picChg chg="add del mod">
          <ac:chgData name="Jake Kendrick" userId="S::21308325@student.uwa.edu.au::ab142299-a4dd-4def-8b03-8ee3e1d9a7dd" providerId="AD" clId="Web-{C03803D1-1C85-5D23-C361-C88872B49E3E}" dt="2023-04-12T23:14:18.537" v="17"/>
          <ac:picMkLst>
            <pc:docMk/>
            <pc:sldMk cId="109857222" sldId="256"/>
            <ac:picMk id="5" creationId="{F9054200-568D-FAB3-6138-41B22D6BEAAF}"/>
          </ac:picMkLst>
        </pc:picChg>
        <pc:picChg chg="add del">
          <ac:chgData name="Jake Kendrick" userId="S::21308325@student.uwa.edu.au::ab142299-a4dd-4def-8b03-8ee3e1d9a7dd" providerId="AD" clId="Web-{C03803D1-1C85-5D23-C361-C88872B49E3E}" dt="2023-04-12T23:14:15.100" v="14"/>
          <ac:picMkLst>
            <pc:docMk/>
            <pc:sldMk cId="109857222" sldId="256"/>
            <ac:picMk id="6" creationId="{ABFBBB8A-126B-A003-AE90-F407FAA09CE3}"/>
          </ac:picMkLst>
        </pc:picChg>
        <pc:picChg chg="add del mod">
          <ac:chgData name="Jake Kendrick" userId="S::21308325@student.uwa.edu.au::ab142299-a4dd-4def-8b03-8ee3e1d9a7dd" providerId="AD" clId="Web-{C03803D1-1C85-5D23-C361-C88872B49E3E}" dt="2023-04-12T23:14:16.256" v="15"/>
          <ac:picMkLst>
            <pc:docMk/>
            <pc:sldMk cId="109857222" sldId="256"/>
            <ac:picMk id="7" creationId="{E033AFBC-8390-4D4D-8422-640F744999EE}"/>
          </ac:picMkLst>
        </pc:picChg>
        <pc:picChg chg="add del mod">
          <ac:chgData name="Jake Kendrick" userId="S::21308325@student.uwa.edu.au::ab142299-a4dd-4def-8b03-8ee3e1d9a7dd" providerId="AD" clId="Web-{C03803D1-1C85-5D23-C361-C88872B49E3E}" dt="2023-04-12T23:17:40.857" v="24"/>
          <ac:picMkLst>
            <pc:docMk/>
            <pc:sldMk cId="109857222" sldId="256"/>
            <ac:picMk id="8" creationId="{CF318008-E25F-308E-65C2-722F4E3DEF6A}"/>
          </ac:picMkLst>
        </pc:picChg>
      </pc:sldChg>
    </pc:docChg>
  </pc:docChgLst>
  <pc:docChgLst>
    <pc:chgData name="Jake Kendrick" userId="S::21308325@student.uwa.edu.au::ab142299-a4dd-4def-8b03-8ee3e1d9a7dd" providerId="AD" clId="Web-{6D6101D7-A54C-4AAD-8566-F402E60BB197}"/>
    <pc:docChg chg="modSld">
      <pc:chgData name="Jake Kendrick" userId="S::21308325@student.uwa.edu.au::ab142299-a4dd-4def-8b03-8ee3e1d9a7dd" providerId="AD" clId="Web-{6D6101D7-A54C-4AAD-8566-F402E60BB197}" dt="2023-04-12T01:10:06.515" v="16"/>
      <pc:docMkLst>
        <pc:docMk/>
      </pc:docMkLst>
      <pc:sldChg chg="delSp">
        <pc:chgData name="Jake Kendrick" userId="S::21308325@student.uwa.edu.au::ab142299-a4dd-4def-8b03-8ee3e1d9a7dd" providerId="AD" clId="Web-{6D6101D7-A54C-4AAD-8566-F402E60BB197}" dt="2023-04-12T01:10:06.515" v="16"/>
        <pc:sldMkLst>
          <pc:docMk/>
          <pc:sldMk cId="109857222" sldId="256"/>
        </pc:sldMkLst>
        <pc:spChg chg="del">
          <ac:chgData name="Jake Kendrick" userId="S::21308325@student.uwa.edu.au::ab142299-a4dd-4def-8b03-8ee3e1d9a7dd" providerId="AD" clId="Web-{6D6101D7-A54C-4AAD-8566-F402E60BB197}" dt="2023-04-12T01:10:04.577" v="0"/>
          <ac:spMkLst>
            <pc:docMk/>
            <pc:sldMk cId="109857222" sldId="256"/>
            <ac:spMk id="3" creationId="{752B7F05-BB20-FF7C-46AD-19DB3DCBC1C5}"/>
          </ac:spMkLst>
        </pc:spChg>
        <pc:spChg chg="del">
          <ac:chgData name="Jake Kendrick" userId="S::21308325@student.uwa.edu.au::ab142299-a4dd-4def-8b03-8ee3e1d9a7dd" providerId="AD" clId="Web-{6D6101D7-A54C-4AAD-8566-F402E60BB197}" dt="2023-04-12T01:10:06.515" v="13"/>
          <ac:spMkLst>
            <pc:docMk/>
            <pc:sldMk cId="109857222" sldId="256"/>
            <ac:spMk id="4" creationId="{86CE8CDC-9512-5222-4EE8-5652CBCF6ABC}"/>
          </ac:spMkLst>
        </pc:spChg>
        <pc:spChg chg="del">
          <ac:chgData name="Jake Kendrick" userId="S::21308325@student.uwa.edu.au::ab142299-a4dd-4def-8b03-8ee3e1d9a7dd" providerId="AD" clId="Web-{6D6101D7-A54C-4AAD-8566-F402E60BB197}" dt="2023-04-12T01:10:06.515" v="15"/>
          <ac:spMkLst>
            <pc:docMk/>
            <pc:sldMk cId="109857222" sldId="256"/>
            <ac:spMk id="5" creationId="{98293BB6-3D40-E604-EEC1-B02802083163}"/>
          </ac:spMkLst>
        </pc:spChg>
        <pc:spChg chg="del">
          <ac:chgData name="Jake Kendrick" userId="S::21308325@student.uwa.edu.au::ab142299-a4dd-4def-8b03-8ee3e1d9a7dd" providerId="AD" clId="Web-{6D6101D7-A54C-4AAD-8566-F402E60BB197}" dt="2023-04-12T01:10:06.515" v="14"/>
          <ac:spMkLst>
            <pc:docMk/>
            <pc:sldMk cId="109857222" sldId="256"/>
            <ac:spMk id="6" creationId="{54EB5050-2446-CEE9-5B90-ABA19520141F}"/>
          </ac:spMkLst>
        </pc:spChg>
        <pc:spChg chg="del">
          <ac:chgData name="Jake Kendrick" userId="S::21308325@student.uwa.edu.au::ab142299-a4dd-4def-8b03-8ee3e1d9a7dd" providerId="AD" clId="Web-{6D6101D7-A54C-4AAD-8566-F402E60BB197}" dt="2023-04-12T01:10:06.499" v="12"/>
          <ac:spMkLst>
            <pc:docMk/>
            <pc:sldMk cId="109857222" sldId="256"/>
            <ac:spMk id="7" creationId="{FE0A73F2-CF4D-A099-752C-FBC0496EC9FB}"/>
          </ac:spMkLst>
        </pc:spChg>
        <pc:spChg chg="del">
          <ac:chgData name="Jake Kendrick" userId="S::21308325@student.uwa.edu.au::ab142299-a4dd-4def-8b03-8ee3e1d9a7dd" providerId="AD" clId="Web-{6D6101D7-A54C-4AAD-8566-F402E60BB197}" dt="2023-04-12T01:10:06.499" v="11"/>
          <ac:spMkLst>
            <pc:docMk/>
            <pc:sldMk cId="109857222" sldId="256"/>
            <ac:spMk id="8" creationId="{652A4ECA-6D7A-BB55-9BF9-65FC0D43B2E1}"/>
          </ac:spMkLst>
        </pc:spChg>
        <pc:spChg chg="del">
          <ac:chgData name="Jake Kendrick" userId="S::21308325@student.uwa.edu.au::ab142299-a4dd-4def-8b03-8ee3e1d9a7dd" providerId="AD" clId="Web-{6D6101D7-A54C-4AAD-8566-F402E60BB197}" dt="2023-04-12T01:10:06.515" v="16"/>
          <ac:spMkLst>
            <pc:docMk/>
            <pc:sldMk cId="109857222" sldId="256"/>
            <ac:spMk id="10" creationId="{77A02ED0-8423-0C42-930A-6F5D1DA6A053}"/>
          </ac:spMkLst>
        </pc:spChg>
        <pc:spChg chg="del">
          <ac:chgData name="Jake Kendrick" userId="S::21308325@student.uwa.edu.au::ab142299-a4dd-4def-8b03-8ee3e1d9a7dd" providerId="AD" clId="Web-{6D6101D7-A54C-4AAD-8566-F402E60BB197}" dt="2023-04-12T01:10:06.499" v="8"/>
          <ac:spMkLst>
            <pc:docMk/>
            <pc:sldMk cId="109857222" sldId="256"/>
            <ac:spMk id="16" creationId="{E4575559-6DEE-6DAD-40D2-9E0F91EC9366}"/>
          </ac:spMkLst>
        </pc:spChg>
        <pc:spChg chg="del">
          <ac:chgData name="Jake Kendrick" userId="S::21308325@student.uwa.edu.au::ab142299-a4dd-4def-8b03-8ee3e1d9a7dd" providerId="AD" clId="Web-{6D6101D7-A54C-4AAD-8566-F402E60BB197}" dt="2023-04-12T01:10:06.499" v="7"/>
          <ac:spMkLst>
            <pc:docMk/>
            <pc:sldMk cId="109857222" sldId="256"/>
            <ac:spMk id="17" creationId="{7E019E43-18AA-B263-69F2-148E44F4699A}"/>
          </ac:spMkLst>
        </pc:spChg>
        <pc:spChg chg="del">
          <ac:chgData name="Jake Kendrick" userId="S::21308325@student.uwa.edu.au::ab142299-a4dd-4def-8b03-8ee3e1d9a7dd" providerId="AD" clId="Web-{6D6101D7-A54C-4AAD-8566-F402E60BB197}" dt="2023-04-12T01:10:06.499" v="6"/>
          <ac:spMkLst>
            <pc:docMk/>
            <pc:sldMk cId="109857222" sldId="256"/>
            <ac:spMk id="18" creationId="{9F88437A-F819-661A-C1BD-CEDB174DA3B3}"/>
          </ac:spMkLst>
        </pc:spChg>
        <pc:spChg chg="del">
          <ac:chgData name="Jake Kendrick" userId="S::21308325@student.uwa.edu.au::ab142299-a4dd-4def-8b03-8ee3e1d9a7dd" providerId="AD" clId="Web-{6D6101D7-A54C-4AAD-8566-F402E60BB197}" dt="2023-04-12T01:10:06.499" v="5"/>
          <ac:spMkLst>
            <pc:docMk/>
            <pc:sldMk cId="109857222" sldId="256"/>
            <ac:spMk id="19" creationId="{2605BFF7-D100-AF1D-0E5D-732E19142129}"/>
          </ac:spMkLst>
        </pc:spChg>
        <pc:spChg chg="del">
          <ac:chgData name="Jake Kendrick" userId="S::21308325@student.uwa.edu.au::ab142299-a4dd-4def-8b03-8ee3e1d9a7dd" providerId="AD" clId="Web-{6D6101D7-A54C-4AAD-8566-F402E60BB197}" dt="2023-04-12T01:10:06.499" v="2"/>
          <ac:spMkLst>
            <pc:docMk/>
            <pc:sldMk cId="109857222" sldId="256"/>
            <ac:spMk id="22" creationId="{B0EE2EF5-4329-FE4B-53FB-5CFD97EF403C}"/>
          </ac:spMkLst>
        </pc:spChg>
        <pc:spChg chg="del">
          <ac:chgData name="Jake Kendrick" userId="S::21308325@student.uwa.edu.au::ab142299-a4dd-4def-8b03-8ee3e1d9a7dd" providerId="AD" clId="Web-{6D6101D7-A54C-4AAD-8566-F402E60BB197}" dt="2023-04-12T01:10:06.499" v="1"/>
          <ac:spMkLst>
            <pc:docMk/>
            <pc:sldMk cId="109857222" sldId="256"/>
            <ac:spMk id="23" creationId="{6F1E9DD4-B235-0D4A-7380-9AFFF9787E36}"/>
          </ac:spMkLst>
        </pc:spChg>
        <pc:cxnChg chg="del">
          <ac:chgData name="Jake Kendrick" userId="S::21308325@student.uwa.edu.au::ab142299-a4dd-4def-8b03-8ee3e1d9a7dd" providerId="AD" clId="Web-{6D6101D7-A54C-4AAD-8566-F402E60BB197}" dt="2023-04-12T01:10:06.499" v="10"/>
          <ac:cxnSpMkLst>
            <pc:docMk/>
            <pc:sldMk cId="109857222" sldId="256"/>
            <ac:cxnSpMk id="9" creationId="{A179DD93-6A7C-87EA-40AB-B385E5C66F0A}"/>
          </ac:cxnSpMkLst>
        </pc:cxnChg>
        <pc:cxnChg chg="del">
          <ac:chgData name="Jake Kendrick" userId="S::21308325@student.uwa.edu.au::ab142299-a4dd-4def-8b03-8ee3e1d9a7dd" providerId="AD" clId="Web-{6D6101D7-A54C-4AAD-8566-F402E60BB197}" dt="2023-04-12T01:10:06.499" v="9"/>
          <ac:cxnSpMkLst>
            <pc:docMk/>
            <pc:sldMk cId="109857222" sldId="256"/>
            <ac:cxnSpMk id="14" creationId="{5847464F-683F-D09C-582A-3723821AE0BF}"/>
          </ac:cxnSpMkLst>
        </pc:cxnChg>
        <pc:cxnChg chg="del">
          <ac:chgData name="Jake Kendrick" userId="S::21308325@student.uwa.edu.au::ab142299-a4dd-4def-8b03-8ee3e1d9a7dd" providerId="AD" clId="Web-{6D6101D7-A54C-4AAD-8566-F402E60BB197}" dt="2023-04-12T01:10:06.499" v="4"/>
          <ac:cxnSpMkLst>
            <pc:docMk/>
            <pc:sldMk cId="109857222" sldId="256"/>
            <ac:cxnSpMk id="20" creationId="{FE856398-D58E-ECCA-F962-CAB3B6257EFA}"/>
          </ac:cxnSpMkLst>
        </pc:cxnChg>
        <pc:cxnChg chg="del">
          <ac:chgData name="Jake Kendrick" userId="S::21308325@student.uwa.edu.au::ab142299-a4dd-4def-8b03-8ee3e1d9a7dd" providerId="AD" clId="Web-{6D6101D7-A54C-4AAD-8566-F402E60BB197}" dt="2023-04-12T01:10:06.499" v="3"/>
          <ac:cxnSpMkLst>
            <pc:docMk/>
            <pc:sldMk cId="109857222" sldId="256"/>
            <ac:cxnSpMk id="21" creationId="{2D5AE94A-DA00-6E17-3C9B-A1DD50C1DC79}"/>
          </ac:cxnSpMkLst>
        </pc:cxnChg>
      </pc:sldChg>
    </pc:docChg>
  </pc:docChgLst>
  <pc:docChgLst>
    <pc:chgData name="Jake Kendrick" userId="ab142299-a4dd-4def-8b03-8ee3e1d9a7dd" providerId="ADAL" clId="{70C85604-EA4B-134F-A7CF-9DCF41547B65}"/>
    <pc:docChg chg="modSld">
      <pc:chgData name="Jake Kendrick" userId="ab142299-a4dd-4def-8b03-8ee3e1d9a7dd" providerId="ADAL" clId="{70C85604-EA4B-134F-A7CF-9DCF41547B65}" dt="2023-04-13T01:52:31.032" v="4" actId="1076"/>
      <pc:docMkLst>
        <pc:docMk/>
      </pc:docMkLst>
      <pc:sldChg chg="modSp mod">
        <pc:chgData name="Jake Kendrick" userId="ab142299-a4dd-4def-8b03-8ee3e1d9a7dd" providerId="ADAL" clId="{70C85604-EA4B-134F-A7CF-9DCF41547B65}" dt="2023-04-13T01:52:31.032" v="4" actId="1076"/>
        <pc:sldMkLst>
          <pc:docMk/>
          <pc:sldMk cId="109857222" sldId="256"/>
        </pc:sldMkLst>
        <pc:picChg chg="mod modCrop">
          <ac:chgData name="Jake Kendrick" userId="ab142299-a4dd-4def-8b03-8ee3e1d9a7dd" providerId="ADAL" clId="{70C85604-EA4B-134F-A7CF-9DCF41547B65}" dt="2023-04-13T01:49:19.575" v="2" actId="1076"/>
          <ac:picMkLst>
            <pc:docMk/>
            <pc:sldMk cId="109857222" sldId="256"/>
            <ac:picMk id="4" creationId="{3778CDEF-44B7-F2C1-0189-6FCA3A94E4CF}"/>
          </ac:picMkLst>
        </pc:picChg>
        <pc:picChg chg="mod modCrop">
          <ac:chgData name="Jake Kendrick" userId="ab142299-a4dd-4def-8b03-8ee3e1d9a7dd" providerId="ADAL" clId="{70C85604-EA4B-134F-A7CF-9DCF41547B65}" dt="2023-04-13T01:52:31.032" v="4" actId="1076"/>
          <ac:picMkLst>
            <pc:docMk/>
            <pc:sldMk cId="109857222" sldId="256"/>
            <ac:picMk id="5" creationId="{BBED81FA-1167-3EB8-F332-059E25B64E73}"/>
          </ac:picMkLst>
        </pc:picChg>
      </pc:sldChg>
    </pc:docChg>
  </pc:docChgLst>
  <pc:docChgLst>
    <pc:chgData name="Jake Kendrick" userId="S::21308325@student.uwa.edu.au::ab142299-a4dd-4def-8b03-8ee3e1d9a7dd" providerId="AD" clId="Web-{C9C15643-D0C5-44B8-BAA7-AB85D2AF82BA}"/>
    <pc:docChg chg="modSld">
      <pc:chgData name="Jake Kendrick" userId="S::21308325@student.uwa.edu.au::ab142299-a4dd-4def-8b03-8ee3e1d9a7dd" providerId="AD" clId="Web-{C9C15643-D0C5-44B8-BAA7-AB85D2AF82BA}" dt="2022-12-29T23:58:52.205" v="84" actId="14100"/>
      <pc:docMkLst>
        <pc:docMk/>
      </pc:docMkLst>
      <pc:sldChg chg="addSp delSp modSp">
        <pc:chgData name="Jake Kendrick" userId="S::21308325@student.uwa.edu.au::ab142299-a4dd-4def-8b03-8ee3e1d9a7dd" providerId="AD" clId="Web-{C9C15643-D0C5-44B8-BAA7-AB85D2AF82BA}" dt="2022-12-29T23:58:52.205" v="84" actId="14100"/>
        <pc:sldMkLst>
          <pc:docMk/>
          <pc:sldMk cId="109857222" sldId="256"/>
        </pc:sldMkLst>
        <pc:spChg chg="add mod">
          <ac:chgData name="Jake Kendrick" userId="S::21308325@student.uwa.edu.au::ab142299-a4dd-4def-8b03-8ee3e1d9a7dd" providerId="AD" clId="Web-{C9C15643-D0C5-44B8-BAA7-AB85D2AF82BA}" dt="2022-12-29T23:55:22.518" v="70" actId="1076"/>
          <ac:spMkLst>
            <pc:docMk/>
            <pc:sldMk cId="109857222" sldId="256"/>
            <ac:spMk id="4" creationId="{10C2DED3-698D-7ED0-B399-35C69A59F96F}"/>
          </ac:spMkLst>
        </pc:spChg>
        <pc:spChg chg="add mod">
          <ac:chgData name="Jake Kendrick" userId="S::21308325@student.uwa.edu.au::ab142299-a4dd-4def-8b03-8ee3e1d9a7dd" providerId="AD" clId="Web-{C9C15643-D0C5-44B8-BAA7-AB85D2AF82BA}" dt="2022-12-29T23:58:52.205" v="84" actId="14100"/>
          <ac:spMkLst>
            <pc:docMk/>
            <pc:sldMk cId="109857222" sldId="256"/>
            <ac:spMk id="8" creationId="{49AF7FBA-0E18-CB4F-B3BE-BE18C90D7AC9}"/>
          </ac:spMkLst>
        </pc:spChg>
        <pc:spChg chg="del">
          <ac:chgData name="Jake Kendrick" userId="S::21308325@student.uwa.edu.au::ab142299-a4dd-4def-8b03-8ee3e1d9a7dd" providerId="AD" clId="Web-{C9C15643-D0C5-44B8-BAA7-AB85D2AF82BA}" dt="2022-12-29T23:43:44.745" v="3"/>
          <ac:spMkLst>
            <pc:docMk/>
            <pc:sldMk cId="109857222" sldId="256"/>
            <ac:spMk id="11" creationId="{51C3C997-41C1-7247-BB0B-5044F4E47364}"/>
          </ac:spMkLst>
        </pc:spChg>
        <pc:picChg chg="add mod modCrop">
          <ac:chgData name="Jake Kendrick" userId="S::21308325@student.uwa.edu.au::ab142299-a4dd-4def-8b03-8ee3e1d9a7dd" providerId="AD" clId="Web-{C9C15643-D0C5-44B8-BAA7-AB85D2AF82BA}" dt="2022-12-29T23:55:00.268" v="65" actId="1076"/>
          <ac:picMkLst>
            <pc:docMk/>
            <pc:sldMk cId="109857222" sldId="256"/>
            <ac:picMk id="2" creationId="{A01C2D52-27EF-673E-93AD-928A3BE60015}"/>
          </ac:picMkLst>
        </pc:picChg>
        <pc:picChg chg="add mod modCrop">
          <ac:chgData name="Jake Kendrick" userId="S::21308325@student.uwa.edu.au::ab142299-a4dd-4def-8b03-8ee3e1d9a7dd" providerId="AD" clId="Web-{C9C15643-D0C5-44B8-BAA7-AB85D2AF82BA}" dt="2022-12-29T23:55:17.706" v="68" actId="1076"/>
          <ac:picMkLst>
            <pc:docMk/>
            <pc:sldMk cId="109857222" sldId="256"/>
            <ac:picMk id="3" creationId="{661A1E88-944A-AB5F-978C-33994634841E}"/>
          </ac:picMkLst>
        </pc:picChg>
        <pc:picChg chg="del">
          <ac:chgData name="Jake Kendrick" userId="S::21308325@student.uwa.edu.au::ab142299-a4dd-4def-8b03-8ee3e1d9a7dd" providerId="AD" clId="Web-{C9C15643-D0C5-44B8-BAA7-AB85D2AF82BA}" dt="2022-12-29T23:43:38.713" v="0"/>
          <ac:picMkLst>
            <pc:docMk/>
            <pc:sldMk cId="109857222" sldId="256"/>
            <ac:picMk id="5" creationId="{D0D72CDC-DB73-4A46-BC72-65F82BD2E953}"/>
          </ac:picMkLst>
        </pc:picChg>
        <pc:picChg chg="add mod modCrop">
          <ac:chgData name="Jake Kendrick" userId="S::21308325@student.uwa.edu.au::ab142299-a4dd-4def-8b03-8ee3e1d9a7dd" providerId="AD" clId="Web-{C9C15643-D0C5-44B8-BAA7-AB85D2AF82BA}" dt="2022-12-29T23:57:03.224" v="74" actId="1076"/>
          <ac:picMkLst>
            <pc:docMk/>
            <pc:sldMk cId="109857222" sldId="256"/>
            <ac:picMk id="6" creationId="{C8430E77-9396-9DD5-0C58-64C6EC5B5743}"/>
          </ac:picMkLst>
        </pc:picChg>
        <pc:picChg chg="del">
          <ac:chgData name="Jake Kendrick" userId="S::21308325@student.uwa.edu.au::ab142299-a4dd-4def-8b03-8ee3e1d9a7dd" providerId="AD" clId="Web-{C9C15643-D0C5-44B8-BAA7-AB85D2AF82BA}" dt="2022-12-29T23:43:40.135" v="1"/>
          <ac:picMkLst>
            <pc:docMk/>
            <pc:sldMk cId="109857222" sldId="256"/>
            <ac:picMk id="7" creationId="{39AFEE4A-488A-8545-A74A-679028501F65}"/>
          </ac:picMkLst>
        </pc:picChg>
        <pc:picChg chg="del">
          <ac:chgData name="Jake Kendrick" userId="S::21308325@student.uwa.edu.au::ab142299-a4dd-4def-8b03-8ee3e1d9a7dd" providerId="AD" clId="Web-{C9C15643-D0C5-44B8-BAA7-AB85D2AF82BA}" dt="2022-12-29T23:43:42.120" v="2"/>
          <ac:picMkLst>
            <pc:docMk/>
            <pc:sldMk cId="109857222" sldId="256"/>
            <ac:picMk id="9" creationId="{7534F080-3019-5945-A870-517575C07067}"/>
          </ac:picMkLst>
        </pc:picChg>
      </pc:sldChg>
    </pc:docChg>
  </pc:docChgLst>
  <pc:docChgLst>
    <pc:chgData name="Jake Kendrick" userId="S::21308325@student.uwa.edu.au::ab142299-a4dd-4def-8b03-8ee3e1d9a7dd" providerId="AD" clId="Web-{A74D37FC-C8E0-46E6-8908-6CE0A5DCCB3B}"/>
    <pc:docChg chg="modSld">
      <pc:chgData name="Jake Kendrick" userId="S::21308325@student.uwa.edu.au::ab142299-a4dd-4def-8b03-8ee3e1d9a7dd" providerId="AD" clId="Web-{A74D37FC-C8E0-46E6-8908-6CE0A5DCCB3B}" dt="2023-03-03T06:57:00.397" v="28" actId="20577"/>
      <pc:docMkLst>
        <pc:docMk/>
      </pc:docMkLst>
      <pc:sldChg chg="modSp">
        <pc:chgData name="Jake Kendrick" userId="S::21308325@student.uwa.edu.au::ab142299-a4dd-4def-8b03-8ee3e1d9a7dd" providerId="AD" clId="Web-{A74D37FC-C8E0-46E6-8908-6CE0A5DCCB3B}" dt="2023-03-03T06:57:00.397" v="28" actId="20577"/>
        <pc:sldMkLst>
          <pc:docMk/>
          <pc:sldMk cId="109857222" sldId="256"/>
        </pc:sldMkLst>
        <pc:spChg chg="mod">
          <ac:chgData name="Jake Kendrick" userId="S::21308325@student.uwa.edu.au::ab142299-a4dd-4def-8b03-8ee3e1d9a7dd" providerId="AD" clId="Web-{A74D37FC-C8E0-46E6-8908-6CE0A5DCCB3B}" dt="2023-03-03T06:57:00.397" v="28" actId="20577"/>
          <ac:spMkLst>
            <pc:docMk/>
            <pc:sldMk cId="109857222" sldId="256"/>
            <ac:spMk id="13" creationId="{A9A32FB2-2064-654E-9855-BDC1D5C342CA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00726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98583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44943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69080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82465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08525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8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45356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8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95275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8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97663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50561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38514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6CE7D5-CF57-46EF-B807-FDD0502418D4}" type="datetimeFigureOut">
              <a:rPr lang="en-US" smtClean="0"/>
              <a:t>9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32564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svg"/><Relationship Id="rId7" Type="http://schemas.openxmlformats.org/officeDocument/2006/relationships/image" Target="../media/image6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svg"/><Relationship Id="rId4" Type="http://schemas.openxmlformats.org/officeDocument/2006/relationships/image" Target="../media/image3.png"/><Relationship Id="rId9" Type="http://schemas.openxmlformats.org/officeDocument/2006/relationships/image" Target="../media/image8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CBAAA63C-1BA9-DA4A-A878-9EC83D20AC07}"/>
              </a:ext>
            </a:extLst>
          </p:cNvPr>
          <p:cNvSpPr txBox="1"/>
          <p:nvPr/>
        </p:nvSpPr>
        <p:spPr>
          <a:xfrm>
            <a:off x="5453144" y="6042444"/>
            <a:ext cx="387350" cy="28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31A8256A-2223-0045-8866-AF2EE0DBAA26}"/>
              </a:ext>
            </a:extLst>
          </p:cNvPr>
          <p:cNvCxnSpPr/>
          <p:nvPr/>
        </p:nvCxnSpPr>
        <p:spPr>
          <a:xfrm>
            <a:off x="3022896" y="253811"/>
            <a:ext cx="0" cy="4924679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2EF2A381-DB62-ADB9-8061-FEE116D46C4B}"/>
              </a:ext>
            </a:extLst>
          </p:cNvPr>
          <p:cNvSpPr txBox="1"/>
          <p:nvPr/>
        </p:nvSpPr>
        <p:spPr>
          <a:xfrm>
            <a:off x="3307080" y="7924800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/>
          </a:p>
        </p:txBody>
      </p:sp>
      <p:graphicFrame>
        <p:nvGraphicFramePr>
          <p:cNvPr id="7" name="Table 7">
            <a:extLst>
              <a:ext uri="{FF2B5EF4-FFF2-40B4-BE49-F238E27FC236}">
                <a16:creationId xmlns:a16="http://schemas.microsoft.com/office/drawing/2014/main" id="{277382E6-C6E4-6D8E-B6CB-723A91E54FA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20667545"/>
              </p:ext>
            </p:extLst>
          </p:nvPr>
        </p:nvGraphicFramePr>
        <p:xfrm>
          <a:off x="2931065" y="2333551"/>
          <a:ext cx="3404110" cy="687624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769775">
                  <a:extLst>
                    <a:ext uri="{9D8B030D-6E8A-4147-A177-3AD203B41FA5}">
                      <a16:colId xmlns:a16="http://schemas.microsoft.com/office/drawing/2014/main" val="1738334099"/>
                    </a:ext>
                  </a:extLst>
                </a:gridCol>
                <a:gridCol w="446312">
                  <a:extLst>
                    <a:ext uri="{9D8B030D-6E8A-4147-A177-3AD203B41FA5}">
                      <a16:colId xmlns:a16="http://schemas.microsoft.com/office/drawing/2014/main" val="239161480"/>
                    </a:ext>
                  </a:extLst>
                </a:gridCol>
                <a:gridCol w="533399">
                  <a:extLst>
                    <a:ext uri="{9D8B030D-6E8A-4147-A177-3AD203B41FA5}">
                      <a16:colId xmlns:a16="http://schemas.microsoft.com/office/drawing/2014/main" val="2576386524"/>
                    </a:ext>
                  </a:extLst>
                </a:gridCol>
                <a:gridCol w="555171">
                  <a:extLst>
                    <a:ext uri="{9D8B030D-6E8A-4147-A177-3AD203B41FA5}">
                      <a16:colId xmlns:a16="http://schemas.microsoft.com/office/drawing/2014/main" val="4130437892"/>
                    </a:ext>
                  </a:extLst>
                </a:gridCol>
                <a:gridCol w="576940">
                  <a:extLst>
                    <a:ext uri="{9D8B030D-6E8A-4147-A177-3AD203B41FA5}">
                      <a16:colId xmlns:a16="http://schemas.microsoft.com/office/drawing/2014/main" val="367821362"/>
                    </a:ext>
                  </a:extLst>
                </a:gridCol>
                <a:gridCol w="522513">
                  <a:extLst>
                    <a:ext uri="{9D8B030D-6E8A-4147-A177-3AD203B41FA5}">
                      <a16:colId xmlns:a16="http://schemas.microsoft.com/office/drawing/2014/main" val="4244107396"/>
                    </a:ext>
                  </a:extLst>
                </a:gridCol>
              </a:tblGrid>
              <a:tr h="229208">
                <a:tc>
                  <a:txBody>
                    <a:bodyPr/>
                    <a:lstStyle/>
                    <a:p>
                      <a:pPr algn="ctr"/>
                      <a:r>
                        <a:rPr lang="en-GB" sz="800" b="1">
                          <a:latin typeface="Times New Roman"/>
                          <a:cs typeface="Times New Roman"/>
                        </a:rPr>
                        <a:t>Systemic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latin typeface="Times New Roman"/>
                          <a:cs typeface="Times New Roman"/>
                        </a:rPr>
                        <a:t>2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latin typeface="Times New Roman"/>
                          <a:cs typeface="Times New Roman"/>
                        </a:rPr>
                        <a:t>19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latin typeface="Times New Roman"/>
                          <a:cs typeface="Times New Roman"/>
                        </a:rPr>
                        <a:t>16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latin typeface="Times New Roman"/>
                          <a:cs typeface="Times New Roman"/>
                        </a:rPr>
                        <a:t>1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latin typeface="Times New Roman"/>
                          <a:cs typeface="Times New Roman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73161494"/>
                  </a:ext>
                </a:extLst>
              </a:tr>
              <a:tr h="229208"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GB" sz="800" b="1">
                          <a:latin typeface="Times New Roman"/>
                          <a:cs typeface="Times New Roman"/>
                        </a:rPr>
                        <a:t>Mixe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GB" sz="800">
                          <a:latin typeface="Times New Roman"/>
                          <a:cs typeface="Times New Roman"/>
                        </a:rPr>
                        <a:t>3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GB" sz="800">
                          <a:latin typeface="Times New Roman"/>
                          <a:cs typeface="Times New Roman"/>
                        </a:rPr>
                        <a:t>29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GB" sz="800">
                          <a:latin typeface="Times New Roman"/>
                          <a:cs typeface="Times New Roman"/>
                        </a:rPr>
                        <a:t>27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GB" sz="800">
                          <a:latin typeface="Times New Roman"/>
                          <a:cs typeface="Times New Roman"/>
                        </a:rPr>
                        <a:t>23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GB" sz="800">
                          <a:latin typeface="Times New Roman"/>
                          <a:cs typeface="Times New Roman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495613"/>
                  </a:ext>
                </a:extLst>
              </a:tr>
              <a:tr h="229208">
                <a:tc>
                  <a:txBody>
                    <a:bodyPr/>
                    <a:lstStyle/>
                    <a:p>
                      <a:pPr algn="ctr"/>
                      <a:r>
                        <a:rPr lang="en-GB" sz="800" b="1">
                          <a:latin typeface="Times New Roman"/>
                          <a:cs typeface="Times New Roman"/>
                        </a:rPr>
                        <a:t>No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latin typeface="Times New Roman"/>
                          <a:cs typeface="Times New Roman"/>
                        </a:rPr>
                        <a:t>86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latin typeface="Times New Roman"/>
                          <a:cs typeface="Times New Roman"/>
                        </a:rPr>
                        <a:t>8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latin typeface="Times New Roman"/>
                          <a:cs typeface="Times New Roman"/>
                        </a:rPr>
                        <a:t>8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latin typeface="Times New Roman"/>
                          <a:cs typeface="Times New Roman"/>
                        </a:rPr>
                        <a:t>7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latin typeface="Times New Roman"/>
                          <a:cs typeface="Times New Roman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17136274"/>
                  </a:ext>
                </a:extLst>
              </a:tr>
            </a:tbl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041D0248-A10B-9F46-5A61-C090DA7913F3}"/>
              </a:ext>
            </a:extLst>
          </p:cNvPr>
          <p:cNvSpPr txBox="1"/>
          <p:nvPr/>
        </p:nvSpPr>
        <p:spPr>
          <a:xfrm>
            <a:off x="1644305" y="24103"/>
            <a:ext cx="261610" cy="276999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C3B6FDF-F768-36A2-9015-C260E85FB4D9}"/>
              </a:ext>
            </a:extLst>
          </p:cNvPr>
          <p:cNvSpPr txBox="1"/>
          <p:nvPr/>
        </p:nvSpPr>
        <p:spPr>
          <a:xfrm>
            <a:off x="4789551" y="25200"/>
            <a:ext cx="269626" cy="276999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n-US" sz="1200" b="1">
                <a:latin typeface="Times New Roman"/>
                <a:cs typeface="Times New Roman"/>
              </a:rPr>
              <a:t>b</a:t>
            </a:r>
            <a:endParaRPr 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F6790C0-0DCA-2251-715A-2652703863E9}"/>
              </a:ext>
            </a:extLst>
          </p:cNvPr>
          <p:cNvSpPr txBox="1"/>
          <p:nvPr/>
        </p:nvSpPr>
        <p:spPr>
          <a:xfrm>
            <a:off x="1636846" y="3020078"/>
            <a:ext cx="253596" cy="276999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BF1C41F-63C6-7F23-2E67-7A5EC0A32D6A}"/>
              </a:ext>
            </a:extLst>
          </p:cNvPr>
          <p:cNvSpPr txBox="1"/>
          <p:nvPr/>
        </p:nvSpPr>
        <p:spPr>
          <a:xfrm>
            <a:off x="4782092" y="3021175"/>
            <a:ext cx="269626" cy="276999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n-US" sz="1200" b="1">
                <a:latin typeface="Times New Roman"/>
                <a:cs typeface="Times New Roman"/>
              </a:rPr>
              <a:t>d</a:t>
            </a:r>
            <a:endParaRPr 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78966BB-B4FE-5DBC-C3FF-9E2ADA0C6ACF}"/>
              </a:ext>
            </a:extLst>
          </p:cNvPr>
          <p:cNvSpPr txBox="1"/>
          <p:nvPr/>
        </p:nvSpPr>
        <p:spPr>
          <a:xfrm>
            <a:off x="472897" y="5533918"/>
            <a:ext cx="5710205" cy="156966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sz="1200" b="1">
                <a:latin typeface="Times New Roman"/>
                <a:cs typeface="Times New Roman"/>
              </a:rPr>
              <a:t>Supplementary Fig. 3</a:t>
            </a:r>
            <a:r>
              <a:rPr lang="en-US" sz="1200">
                <a:latin typeface="Times New Roman"/>
                <a:cs typeface="Times New Roman"/>
              </a:rPr>
              <a:t>. In depth analysis of the properties of the </a:t>
            </a:r>
            <a:r>
              <a:rPr lang="en-US" sz="1200" err="1">
                <a:latin typeface="Times New Roman"/>
                <a:cs typeface="Times New Roman"/>
              </a:rPr>
              <a:t>SUV</a:t>
            </a:r>
            <a:r>
              <a:rPr lang="en-US" sz="1200" baseline="-25000" err="1">
                <a:latin typeface="Times New Roman"/>
                <a:cs typeface="Times New Roman"/>
              </a:rPr>
              <a:t>peak</a:t>
            </a:r>
            <a:r>
              <a:rPr lang="en-US" sz="1200">
                <a:latin typeface="Times New Roman"/>
                <a:cs typeface="Times New Roman"/>
              </a:rPr>
              <a:t> biomarker (highest uptake area of tumor, spherical radius of 6.25mm) at the ±30% response assessment threshold. Figure shows: (a) pie chart showing percentage of patients with each pattern of progression; Kaplan-Meier curves with annotated log rank </a:t>
            </a:r>
            <a:r>
              <a:rPr lang="en-US" sz="1200" i="1">
                <a:latin typeface="Times New Roman"/>
                <a:cs typeface="Times New Roman"/>
              </a:rPr>
              <a:t>p</a:t>
            </a:r>
            <a:r>
              <a:rPr lang="en-US" sz="1200">
                <a:latin typeface="Times New Roman"/>
                <a:cs typeface="Times New Roman"/>
              </a:rPr>
              <a:t> values for (b)  systemic vs. no progression, (c) mixed vs. no progression, and (d) systemic vs. mixed progression. </a:t>
            </a:r>
            <a:r>
              <a:rPr lang="en-GB" sz="1200">
                <a:latin typeface="Times New Roman"/>
                <a:cs typeface="Times New Roman"/>
              </a:rPr>
              <a:t>The number of patients that are still at risk  at a given time point, defined as those patients that have either not experienced death or been censored, are shown below plot (b) (time points in the table align with the x-axes of the plot).</a:t>
            </a:r>
            <a:endParaRPr lang="en-US" sz="1200">
              <a:latin typeface="Times New Roman"/>
              <a:cs typeface="Times New Roman"/>
            </a:endParaRPr>
          </a:p>
        </p:txBody>
      </p:sp>
      <p:pic>
        <p:nvPicPr>
          <p:cNvPr id="14" name="Graphic 13">
            <a:extLst>
              <a:ext uri="{FF2B5EF4-FFF2-40B4-BE49-F238E27FC236}">
                <a16:creationId xmlns:a16="http://schemas.microsoft.com/office/drawing/2014/main" id="{BBE2731B-A5A1-7545-B9E3-B01B473E163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674916" y="168861"/>
            <a:ext cx="2743199" cy="1943856"/>
          </a:xfrm>
          <a:prstGeom prst="rect">
            <a:avLst/>
          </a:prstGeom>
        </p:spPr>
      </p:pic>
      <p:pic>
        <p:nvPicPr>
          <p:cNvPr id="16" name="Graphic 15">
            <a:extLst>
              <a:ext uri="{FF2B5EF4-FFF2-40B4-BE49-F238E27FC236}">
                <a16:creationId xmlns:a16="http://schemas.microsoft.com/office/drawing/2014/main" id="{63EA3BCA-1D1C-EB6D-F52A-7EAC7F7D2AA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3444408" y="255051"/>
            <a:ext cx="2743200" cy="2130932"/>
          </a:xfrm>
          <a:prstGeom prst="rect">
            <a:avLst/>
          </a:prstGeom>
        </p:spPr>
      </p:pic>
      <p:pic>
        <p:nvPicPr>
          <p:cNvPr id="3" name="Graphic 2">
            <a:extLst>
              <a:ext uri="{FF2B5EF4-FFF2-40B4-BE49-F238E27FC236}">
                <a16:creationId xmlns:a16="http://schemas.microsoft.com/office/drawing/2014/main" id="{B7BCCCC1-74AC-0FF5-36CE-0181F35A391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3444408" y="3297077"/>
            <a:ext cx="2743200" cy="2130932"/>
          </a:xfrm>
          <a:prstGeom prst="rect">
            <a:avLst/>
          </a:prstGeom>
        </p:spPr>
      </p:pic>
      <p:pic>
        <p:nvPicPr>
          <p:cNvPr id="5" name="Graphic 4">
            <a:extLst>
              <a:ext uri="{FF2B5EF4-FFF2-40B4-BE49-F238E27FC236}">
                <a16:creationId xmlns:a16="http://schemas.microsoft.com/office/drawing/2014/main" id="{977180E6-C268-ABFB-2E4F-53D3AA20B421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403510" y="3297077"/>
            <a:ext cx="2743200" cy="21309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98572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Application>Microsoft Office PowerPoint</Application>
  <PresentationFormat>A4 Paper (210x297 mm)</PresentationFormat>
  <Slides>1</Slides>
  <Notes>0</Notes>
  <HiddenSlides>0</HiddenSlide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/>
  <cp:revision>1</cp:revision>
  <dcterms:created xsi:type="dcterms:W3CDTF">2022-05-16T02:35:23Z</dcterms:created>
  <dcterms:modified xsi:type="dcterms:W3CDTF">2023-09-28T12:01:07Z</dcterms:modified>
</cp:coreProperties>
</file>